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285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FE8F5"/>
    <a:srgbClr val="F0F4F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50825A0-084C-4F47-8C7E-3EA79B6914D9}" v="1" dt="2024-03-19T09:21:20.76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33" autoAdjust="0"/>
    <p:restoredTop sz="96349" autoAdjust="0"/>
  </p:normalViewPr>
  <p:slideViewPr>
    <p:cSldViewPr snapToGrid="0">
      <p:cViewPr varScale="1">
        <p:scale>
          <a:sx n="76" d="100"/>
          <a:sy n="76" d="100"/>
        </p:scale>
        <p:origin x="94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onnor Blair" userId="5dffaaf1-4e99-4a9f-9d58-f6e2d8990ba3" providerId="ADAL" clId="{BC47891A-4B77-47DB-A266-9AB848673391}"/>
    <pc:docChg chg="undo custSel addSld delSld modSld">
      <pc:chgData name="Connor Blair" userId="5dffaaf1-4e99-4a9f-9d58-f6e2d8990ba3" providerId="ADAL" clId="{BC47891A-4B77-47DB-A266-9AB848673391}" dt="2023-12-21T16:40:25.219" v="1277" actId="1035"/>
      <pc:docMkLst>
        <pc:docMk/>
      </pc:docMkLst>
      <pc:sldChg chg="addSp delSp modSp mod">
        <pc:chgData name="Connor Blair" userId="5dffaaf1-4e99-4a9f-9d58-f6e2d8990ba3" providerId="ADAL" clId="{BC47891A-4B77-47DB-A266-9AB848673391}" dt="2023-12-21T16:40:25.219" v="1277" actId="1035"/>
        <pc:sldMkLst>
          <pc:docMk/>
          <pc:sldMk cId="362827076" sldId="285"/>
        </pc:sldMkLst>
        <pc:spChg chg="mod">
          <ac:chgData name="Connor Blair" userId="5dffaaf1-4e99-4a9f-9d58-f6e2d8990ba3" providerId="ADAL" clId="{BC47891A-4B77-47DB-A266-9AB848673391}" dt="2023-12-21T16:35:33.358" v="1211" actId="1076"/>
          <ac:spMkLst>
            <pc:docMk/>
            <pc:sldMk cId="362827076" sldId="285"/>
            <ac:spMk id="2" creationId="{ACA36E39-E06E-F87D-A1D6-2423F6FED5C9}"/>
          </ac:spMkLst>
        </pc:spChg>
        <pc:spChg chg="add 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3" creationId="{7CF362FD-5F22-3B10-F609-D4F84ABC0A0F}"/>
          </ac:spMkLst>
        </pc:spChg>
        <pc:spChg chg="del">
          <ac:chgData name="Connor Blair" userId="5dffaaf1-4e99-4a9f-9d58-f6e2d8990ba3" providerId="ADAL" clId="{BC47891A-4B77-47DB-A266-9AB848673391}" dt="2023-12-21T15:23:39.281" v="1048" actId="478"/>
          <ac:spMkLst>
            <pc:docMk/>
            <pc:sldMk cId="362827076" sldId="285"/>
            <ac:spMk id="4" creationId="{98C3925B-1739-78BB-EBC1-9176D2BF7C70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6" creationId="{4E77848F-168E-217D-2C30-32424BC5D128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7" creationId="{2D254B20-91F1-33CE-0CC1-CF77D7BCEC0C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0" creationId="{4D7FAB6D-5557-1C05-B0AD-23087629DD47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1" creationId="{2D738583-EC7E-72F0-9036-C7E54E669B07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2" creationId="{76055525-E17E-1734-9370-94905375A475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3" creationId="{2E02099E-AA9D-A6C3-531C-A71A01D2C4E3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4" creationId="{6612BD6A-E6CA-67A0-E9D5-8BDA37D17EF8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5" creationId="{AF66BB24-4850-8D38-B5A5-113B203BE311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6" creationId="{BD0B0E09-34FD-BB5B-26B3-F8F286AE2CF8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9" creationId="{FC85046F-D49C-717A-F7FB-FDDBBE66C48B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21" creationId="{531F7090-A44E-24AC-7DBB-62E89FB82D7D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22" creationId="{82900A4A-B2EC-E5F0-4BF9-6E06CD1412A2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23" creationId="{C5BB52DA-33AD-76E7-8E36-455F785D54CF}"/>
          </ac:spMkLst>
        </pc:spChg>
        <pc:spChg chg="add mod">
          <ac:chgData name="Connor Blair" userId="5dffaaf1-4e99-4a9f-9d58-f6e2d8990ba3" providerId="ADAL" clId="{BC47891A-4B77-47DB-A266-9AB848673391}" dt="2023-12-21T15:24:24.653" v="1076" actId="1036"/>
          <ac:spMkLst>
            <pc:docMk/>
            <pc:sldMk cId="362827076" sldId="285"/>
            <ac:spMk id="24" creationId="{5EC1CE03-3789-F400-E1C3-B6773A925E7D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25" creationId="{25D5A164-627B-236E-8266-7E8BB172198D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27" creationId="{DCDEB768-D082-42B2-5DA7-EE7E08B75BDB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28" creationId="{27F2921F-FBE0-2D3A-2F46-09BEAC262B62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29" creationId="{5D7D544B-3451-9734-73D5-7782790A07E6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30" creationId="{B7EF1D5E-93AE-1423-072C-2611BB73A7B1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31" creationId="{AF3B050C-6CDD-9EA3-060D-5020CABDA01C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33" creationId="{13049982-52DB-DC16-0ED4-7D8B8B25685A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34" creationId="{402B75D1-DBD4-82CF-7BFC-16632833E66D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38" creationId="{A90EA1DB-ADD2-2A53-C5B9-34A7B7A36683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39" creationId="{38DC5F0B-DD53-5C07-A2AD-103719BEE5D8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40" creationId="{EBF12CE8-B199-46B7-C476-7B49A73BA1EC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41" creationId="{8F3F9A28-8291-7C50-9C16-73692BE41F54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42" creationId="{AB026556-0875-C06D-8551-DA0AFB5F1C09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43" creationId="{8F4ED1CC-19CA-1E3F-0129-D51AD00AFE53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44" creationId="{BC9F849D-7173-C769-1193-9BCE1BE51004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45" creationId="{1523298C-1B17-290C-1616-58F2D70F31C1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46" creationId="{89A2BB3E-C0FE-8E6A-F057-AEC22108693E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47" creationId="{815EA4A5-974D-F616-3363-229D5AB5B782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48" creationId="{E2A2607D-E14D-241A-DE7D-79D02EE30892}"/>
          </ac:spMkLst>
        </pc:spChg>
        <pc:spChg chg="add mod">
          <ac:chgData name="Connor Blair" userId="5dffaaf1-4e99-4a9f-9d58-f6e2d8990ba3" providerId="ADAL" clId="{BC47891A-4B77-47DB-A266-9AB848673391}" dt="2023-12-21T15:24:24.653" v="1076" actId="1036"/>
          <ac:spMkLst>
            <pc:docMk/>
            <pc:sldMk cId="362827076" sldId="285"/>
            <ac:spMk id="49" creationId="{A3398022-46CE-A695-A3CE-8D2D00CBF03B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51" creationId="{642D7966-847E-DC70-EEE8-4CE9859F230B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52" creationId="{0CD3F66F-2E9B-7088-ED35-DFB8AE9081AF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55" creationId="{94E718DF-D030-B8F9-7973-043AC9991592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56" creationId="{CF378D53-4277-6068-5AD6-620E54FB1A0B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58" creationId="{B3A784E6-A831-B5D8-0DBC-F8BF66BF7CC6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59" creationId="{7CF8A65A-4C46-F489-F2CE-C6052B64BDA9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60" creationId="{936D4AF1-C59D-4DB2-9FEA-7C3CED55C4DF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61" creationId="{D4A32365-3911-E152-C163-4CECD5DD6E60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62" creationId="{294F969B-E9ED-B5C8-C7FE-A0C2D18E656E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63" creationId="{9AE241C2-F8F4-5851-DF7A-B7F526C6A6BD}"/>
          </ac:spMkLst>
        </pc:spChg>
        <pc:spChg chg="add mod">
          <ac:chgData name="Connor Blair" userId="5dffaaf1-4e99-4a9f-9d58-f6e2d8990ba3" providerId="ADAL" clId="{BC47891A-4B77-47DB-A266-9AB848673391}" dt="2023-12-21T15:24:24.653" v="1076" actId="1036"/>
          <ac:spMkLst>
            <pc:docMk/>
            <pc:sldMk cId="362827076" sldId="285"/>
            <ac:spMk id="65" creationId="{2F7DC8FE-AE8C-E9BF-DF93-F51C4E642BAB}"/>
          </ac:spMkLst>
        </pc:spChg>
        <pc:spChg chg="add mod">
          <ac:chgData name="Connor Blair" userId="5dffaaf1-4e99-4a9f-9d58-f6e2d8990ba3" providerId="ADAL" clId="{BC47891A-4B77-47DB-A266-9AB848673391}" dt="2023-12-21T15:24:24.653" v="1076" actId="1036"/>
          <ac:spMkLst>
            <pc:docMk/>
            <pc:sldMk cId="362827076" sldId="285"/>
            <ac:spMk id="70" creationId="{E5641035-6FAD-7E95-3E70-BAEC8B2471DB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72" creationId="{ADD52AB3-0A0A-DF7A-C91E-476FC4DBFD89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77" creationId="{5B080F33-FEA0-F68A-3E38-0DDBC3E6DF63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78" creationId="{B3888673-2FC7-6E18-4D28-E1955EB07B1F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79" creationId="{78B95401-529E-8872-7C6B-61BE5B7F06B4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80" creationId="{345A793F-4F67-306B-EA30-9B9A06BD27D3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81" creationId="{2304959A-C5EC-D661-572C-675B58B3D802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82" creationId="{AED8DEA9-FBCF-6E7D-EEB7-541A7F4F9AB4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83" creationId="{E1DAC9DD-51EC-985E-5323-9CE4D1293139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84" creationId="{49AA8608-E66D-DCB0-9B73-6DFF9439E241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85" creationId="{718F9119-D38F-0A56-863B-F755C9BCAF35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86" creationId="{7236B376-9F23-4062-A2A1-E4189A63E2BC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87" creationId="{8F977640-76A3-7374-C7CD-81467F0C9FA9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89" creationId="{994B874F-B9DA-3DF3-4E9B-CDDC6F673F19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90" creationId="{ED4A2F09-832B-3D3A-51BA-C9664570D2C9}"/>
          </ac:spMkLst>
        </pc:spChg>
        <pc:spChg chg="add mod">
          <ac:chgData name="Connor Blair" userId="5dffaaf1-4e99-4a9f-9d58-f6e2d8990ba3" providerId="ADAL" clId="{BC47891A-4B77-47DB-A266-9AB848673391}" dt="2023-12-21T15:24:24.653" v="1076" actId="1036"/>
          <ac:spMkLst>
            <pc:docMk/>
            <pc:sldMk cId="362827076" sldId="285"/>
            <ac:spMk id="98" creationId="{D2BBDB1F-3A25-6AE8-C6BE-AEC168616E34}"/>
          </ac:spMkLst>
        </pc:spChg>
        <pc:spChg chg="add mod">
          <ac:chgData name="Connor Blair" userId="5dffaaf1-4e99-4a9f-9d58-f6e2d8990ba3" providerId="ADAL" clId="{BC47891A-4B77-47DB-A266-9AB848673391}" dt="2023-12-21T15:24:24.653" v="1076" actId="1036"/>
          <ac:spMkLst>
            <pc:docMk/>
            <pc:sldMk cId="362827076" sldId="285"/>
            <ac:spMk id="100" creationId="{CC822FF1-25B9-BBA3-6B95-E5FA8766C45E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01" creationId="{D6FCA51F-2DD3-9A78-3912-3F28AFAECACB}"/>
          </ac:spMkLst>
        </pc:spChg>
        <pc:spChg chg="add mod">
          <ac:chgData name="Connor Blair" userId="5dffaaf1-4e99-4a9f-9d58-f6e2d8990ba3" providerId="ADAL" clId="{BC47891A-4B77-47DB-A266-9AB848673391}" dt="2023-12-21T15:24:24.653" v="1076" actId="1036"/>
          <ac:spMkLst>
            <pc:docMk/>
            <pc:sldMk cId="362827076" sldId="285"/>
            <ac:spMk id="102" creationId="{75551E8E-9042-C606-65BC-EE6F896DE12B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03" creationId="{31923B51-7ACB-7046-A118-DCD40FCEDBAD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04" creationId="{1263E356-6892-E89C-AEAE-98182109C0FC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05" creationId="{0C55E764-BCA5-C9B6-06F4-9802B2654D96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07" creationId="{144067BF-185C-53E5-D1E8-81C2A8064CEB}"/>
          </ac:spMkLst>
        </pc:spChg>
        <pc:spChg chg="add mod">
          <ac:chgData name="Connor Blair" userId="5dffaaf1-4e99-4a9f-9d58-f6e2d8990ba3" providerId="ADAL" clId="{BC47891A-4B77-47DB-A266-9AB848673391}" dt="2023-12-21T15:24:24.653" v="1076" actId="1036"/>
          <ac:spMkLst>
            <pc:docMk/>
            <pc:sldMk cId="362827076" sldId="285"/>
            <ac:spMk id="108" creationId="{6D7D91AD-8EC9-BF13-6353-B2B92383C6B0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09" creationId="{78996398-D7DD-26D7-89F0-7AAAA8391FD6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10" creationId="{96A3872E-6A1C-6C21-6772-038CD56EA3FE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11" creationId="{37875684-BF49-18AE-E892-F2DE50862186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13" creationId="{2342ADFC-A93D-D02B-A422-C15F2A0AC612}"/>
          </ac:spMkLst>
        </pc:spChg>
        <pc:spChg chg="add mod">
          <ac:chgData name="Connor Blair" userId="5dffaaf1-4e99-4a9f-9d58-f6e2d8990ba3" providerId="ADAL" clId="{BC47891A-4B77-47DB-A266-9AB848673391}" dt="2023-12-21T15:24:24.653" v="1076" actId="1036"/>
          <ac:spMkLst>
            <pc:docMk/>
            <pc:sldMk cId="362827076" sldId="285"/>
            <ac:spMk id="115" creationId="{C4A19647-E775-DD43-06AD-F839F5EFAC9C}"/>
          </ac:spMkLst>
        </pc:spChg>
        <pc:spChg chg="add mod">
          <ac:chgData name="Connor Blair" userId="5dffaaf1-4e99-4a9f-9d58-f6e2d8990ba3" providerId="ADAL" clId="{BC47891A-4B77-47DB-A266-9AB848673391}" dt="2023-12-21T15:24:24.653" v="1076" actId="1036"/>
          <ac:spMkLst>
            <pc:docMk/>
            <pc:sldMk cId="362827076" sldId="285"/>
            <ac:spMk id="116" creationId="{89621347-4C85-3DF2-8B85-B68648F30B96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18" creationId="{A9E1C42C-97E1-6762-8A75-BA815203CB8C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19" creationId="{9A23718E-BC14-8401-4CBA-47E7BA15701C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21" creationId="{6CBCF270-AE05-2D73-5FF0-BF80EBFC0B64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22" creationId="{7F347CA5-08EC-71B5-654B-47155367FCD1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23" creationId="{59FBFBB4-96E8-A2D0-B7FD-B6DC13B6A05D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24" creationId="{CD01EC37-44B5-286C-3355-75FD97981CB4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25" creationId="{35871861-C6A5-A81F-E8FC-88396CB4A886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26" creationId="{E4CB0DBA-DF78-F3AC-7BC0-E0F120E8AA83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27" creationId="{3EE6FB43-B952-36B1-4389-A3134501A8EC}"/>
          </ac:spMkLst>
        </pc:spChg>
        <pc:spChg chg="add mod">
          <ac:chgData name="Connor Blair" userId="5dffaaf1-4e99-4a9f-9d58-f6e2d8990ba3" providerId="ADAL" clId="{BC47891A-4B77-47DB-A266-9AB848673391}" dt="2023-12-21T16:40:04.607" v="1267" actId="1038"/>
          <ac:spMkLst>
            <pc:docMk/>
            <pc:sldMk cId="362827076" sldId="285"/>
            <ac:spMk id="129" creationId="{5276A2F4-6675-37F5-5F66-08A5E9E6745E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31" creationId="{26B39956-5FB5-2CD1-D76E-0D78E92C3E43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32" creationId="{A76C0B8E-E014-61ED-B61F-59645DF84439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35" creationId="{D0758A3E-FDB1-5F4F-0CF2-B4222B05B5A7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36" creationId="{32961E6F-1B69-692B-DF34-4989B8825B40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37" creationId="{52AEDA82-AE51-DAA7-0836-450369399C43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38" creationId="{DA6BC2AE-9862-EA2F-5EF9-387419061462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39" creationId="{B4E41212-305E-BD0B-BE1A-A40282C89AC7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40" creationId="{19ACDFAE-6604-B1AD-515A-C22A0296EC9C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41" creationId="{65414F76-0615-1493-3C20-658C4C2D1839}"/>
          </ac:spMkLst>
        </pc:spChg>
        <pc:spChg chg="add mod">
          <ac:chgData name="Connor Blair" userId="5dffaaf1-4e99-4a9f-9d58-f6e2d8990ba3" providerId="ADAL" clId="{BC47891A-4B77-47DB-A266-9AB848673391}" dt="2023-12-21T16:35:42.945" v="1223" actId="1035"/>
          <ac:spMkLst>
            <pc:docMk/>
            <pc:sldMk cId="362827076" sldId="285"/>
            <ac:spMk id="143" creationId="{81FCE68F-5FC6-F1A4-21C2-8BF26C8734FE}"/>
          </ac:spMkLst>
        </pc:spChg>
        <pc:spChg chg="add mod">
          <ac:chgData name="Connor Blair" userId="5dffaaf1-4e99-4a9f-9d58-f6e2d8990ba3" providerId="ADAL" clId="{BC47891A-4B77-47DB-A266-9AB848673391}" dt="2023-12-21T16:40:25.219" v="1277" actId="1035"/>
          <ac:spMkLst>
            <pc:docMk/>
            <pc:sldMk cId="362827076" sldId="285"/>
            <ac:spMk id="144" creationId="{9DD01E1C-580F-17E1-2383-436774C74AE7}"/>
          </ac:spMkLst>
        </pc:spChg>
        <pc:spChg chg="add mod">
          <ac:chgData name="Connor Blair" userId="5dffaaf1-4e99-4a9f-9d58-f6e2d8990ba3" providerId="ADAL" clId="{BC47891A-4B77-47DB-A266-9AB848673391}" dt="2023-12-21T16:40:25.219" v="1277" actId="1035"/>
          <ac:spMkLst>
            <pc:docMk/>
            <pc:sldMk cId="362827076" sldId="285"/>
            <ac:spMk id="145" creationId="{6E4FC985-79DF-0F09-7FD2-4433B07C4D33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46" creationId="{3082647E-D42B-F44D-4798-704592C6E821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47" creationId="{69C3851C-BA13-91D4-A50D-0199C96CB0B6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49" creationId="{7E089F34-53E9-BE68-004C-EE62C7D94483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51" creationId="{877879F0-AA83-56BC-F394-A554D7C65F95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52" creationId="{C78DD04B-2120-BEBE-9F5A-5C20C8072F9E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53" creationId="{3ECEF43E-3671-B86E-69C7-4B1733D5253C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54" creationId="{8A12541B-9CD9-324B-C52F-8DF408CB8796}"/>
          </ac:spMkLst>
        </pc:spChg>
        <pc:spChg chg="add mod">
          <ac:chgData name="Connor Blair" userId="5dffaaf1-4e99-4a9f-9d58-f6e2d8990ba3" providerId="ADAL" clId="{BC47891A-4B77-47DB-A266-9AB848673391}" dt="2023-12-21T16:40:25.219" v="1277" actId="1035"/>
          <ac:spMkLst>
            <pc:docMk/>
            <pc:sldMk cId="362827076" sldId="285"/>
            <ac:spMk id="155" creationId="{CBCC465B-E1B2-F431-B0D9-7B8E2CE3546D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56" creationId="{DC254E0F-4801-98C1-56AD-4F651B10C8E4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57" creationId="{0371AB2F-78D5-FF50-D4E2-FEAA2A76DC49}"/>
          </ac:spMkLst>
        </pc:spChg>
        <pc:spChg chg="add mod">
          <ac:chgData name="Connor Blair" userId="5dffaaf1-4e99-4a9f-9d58-f6e2d8990ba3" providerId="ADAL" clId="{BC47891A-4B77-47DB-A266-9AB848673391}" dt="2023-12-21T16:40:25.219" v="1277" actId="1035"/>
          <ac:spMkLst>
            <pc:docMk/>
            <pc:sldMk cId="362827076" sldId="285"/>
            <ac:spMk id="159" creationId="{82594C08-0025-36FC-3E25-DF82BBAF64C1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63" creationId="{CCF8CB03-2398-D03F-90A2-F2992037B6B1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64" creationId="{592C5588-A064-4B9D-B30C-2741CA605341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65" creationId="{F261C5F1-1531-273E-B54F-151CD0CDF800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66" creationId="{6A4A682B-B13F-3B6D-A417-C173E6C17D41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67" creationId="{B75DE22E-8333-4098-735B-478927B7F375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68" creationId="{7B67D776-BE27-84F5-CECA-D563EDE45369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72" creationId="{34403509-8ED0-10E1-2382-11316E9C6688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73" creationId="{D0055CBC-965F-841A-DF70-2878FF246A34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74" creationId="{12BB31F6-3998-6C07-A038-CA9D9450B3AA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75" creationId="{C117AC8D-00EF-C953-5355-F47564F98BE1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76" creationId="{4D59AC88-1253-C17D-F708-6292472DF242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77" creationId="{C2BB3111-F4B6-377B-7CD7-0E5E099A1006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78" creationId="{D5C6F07A-DD39-603D-7A09-CEA0E81B62FD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79" creationId="{3C936277-0F88-97AD-724A-9CA91C5E7130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80" creationId="{859EAD91-2A07-A3C8-B246-E47237A4D2CA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81" creationId="{86D4F711-480E-479B-CC17-9DCB8541374B}"/>
          </ac:spMkLst>
        </pc:spChg>
        <pc:spChg chg="mod">
          <ac:chgData name="Connor Blair" userId="5dffaaf1-4e99-4a9f-9d58-f6e2d8990ba3" providerId="ADAL" clId="{BC47891A-4B77-47DB-A266-9AB848673391}" dt="2023-12-21T15:23:47.088" v="1068" actId="1035"/>
          <ac:spMkLst>
            <pc:docMk/>
            <pc:sldMk cId="362827076" sldId="285"/>
            <ac:spMk id="182" creationId="{DAAFE155-AE47-6F26-5017-447036749BF8}"/>
          </ac:spMkLst>
        </pc:spChg>
        <pc:spChg chg="add mod">
          <ac:chgData name="Connor Blair" userId="5dffaaf1-4e99-4a9f-9d58-f6e2d8990ba3" providerId="ADAL" clId="{BC47891A-4B77-47DB-A266-9AB848673391}" dt="2023-12-21T16:40:25.219" v="1277" actId="1035"/>
          <ac:spMkLst>
            <pc:docMk/>
            <pc:sldMk cId="362827076" sldId="285"/>
            <ac:spMk id="184" creationId="{92A7700E-9EC0-74DC-42DF-DEA511344611}"/>
          </ac:spMkLst>
        </pc:spChg>
        <pc:spChg chg="add mod">
          <ac:chgData name="Connor Blair" userId="5dffaaf1-4e99-4a9f-9d58-f6e2d8990ba3" providerId="ADAL" clId="{BC47891A-4B77-47DB-A266-9AB848673391}" dt="2023-12-21T16:35:42.945" v="1223" actId="1035"/>
          <ac:spMkLst>
            <pc:docMk/>
            <pc:sldMk cId="362827076" sldId="285"/>
            <ac:spMk id="186" creationId="{CD5E290F-449B-CF15-4EA4-ED960F70EE48}"/>
          </ac:spMkLst>
        </pc:spChg>
        <pc:spChg chg="add mod">
          <ac:chgData name="Connor Blair" userId="5dffaaf1-4e99-4a9f-9d58-f6e2d8990ba3" providerId="ADAL" clId="{BC47891A-4B77-47DB-A266-9AB848673391}" dt="2023-12-21T16:35:42.945" v="1223" actId="1035"/>
          <ac:spMkLst>
            <pc:docMk/>
            <pc:sldMk cId="362827076" sldId="285"/>
            <ac:spMk id="188" creationId="{2182A216-6FC4-7769-0403-8D0BC361EC96}"/>
          </ac:spMkLst>
        </pc:spChg>
        <pc:spChg chg="add mod">
          <ac:chgData name="Connor Blair" userId="5dffaaf1-4e99-4a9f-9d58-f6e2d8990ba3" providerId="ADAL" clId="{BC47891A-4B77-47DB-A266-9AB848673391}" dt="2023-12-21T16:35:42.945" v="1223" actId="1035"/>
          <ac:spMkLst>
            <pc:docMk/>
            <pc:sldMk cId="362827076" sldId="285"/>
            <ac:spMk id="190" creationId="{BF38EF23-B101-BC76-9FBF-3CDB9766C6A2}"/>
          </ac:spMkLst>
        </pc:spChg>
        <pc:spChg chg="add mod">
          <ac:chgData name="Connor Blair" userId="5dffaaf1-4e99-4a9f-9d58-f6e2d8990ba3" providerId="ADAL" clId="{BC47891A-4B77-47DB-A266-9AB848673391}" dt="2023-12-21T16:35:58.697" v="1236" actId="1037"/>
          <ac:spMkLst>
            <pc:docMk/>
            <pc:sldMk cId="362827076" sldId="285"/>
            <ac:spMk id="198" creationId="{E04D5E35-AA3D-A76B-5BBD-3679F62D8980}"/>
          </ac:spMkLst>
        </pc:spChg>
        <pc:grpChg chg="mod">
          <ac:chgData name="Connor Blair" userId="5dffaaf1-4e99-4a9f-9d58-f6e2d8990ba3" providerId="ADAL" clId="{BC47891A-4B77-47DB-A266-9AB848673391}" dt="2023-12-21T15:23:47.088" v="1068" actId="1035"/>
          <ac:grpSpMkLst>
            <pc:docMk/>
            <pc:sldMk cId="362827076" sldId="285"/>
            <ac:grpSpMk id="73" creationId="{88E76AD8-F91E-BDB9-F37B-EAF91D88BE71}"/>
          </ac:grpSpMkLst>
        </pc:grp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5" creationId="{8A0A0909-2C52-AA85-2B59-8C6BA07A572A}"/>
          </ac:picMkLst>
        </pc:picChg>
        <pc:picChg chg="add del mod">
          <ac:chgData name="Connor Blair" userId="5dffaaf1-4e99-4a9f-9d58-f6e2d8990ba3" providerId="ADAL" clId="{BC47891A-4B77-47DB-A266-9AB848673391}" dt="2023-12-20T18:18:04.862" v="833" actId="21"/>
          <ac:picMkLst>
            <pc:docMk/>
            <pc:sldMk cId="362827076" sldId="285"/>
            <ac:picMk id="9" creationId="{5AF1E9DA-BECA-962E-472B-20C482283BDA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8" creationId="{345BBF85-F225-2BA2-400E-9618E5765D90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53" creationId="{02F6CDC9-B606-E735-F5A7-72704B72D24D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54" creationId="{6602E107-F38E-CD52-031B-8E354093A867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57" creationId="{CE4D3829-5858-9971-DD2B-34AC5375F2E3}"/>
          </ac:picMkLst>
        </pc:picChg>
        <pc:picChg chg="add del mod">
          <ac:chgData name="Connor Blair" userId="5dffaaf1-4e99-4a9f-9d58-f6e2d8990ba3" providerId="ADAL" clId="{BC47891A-4B77-47DB-A266-9AB848673391}" dt="2023-12-21T15:31:58.495" v="1090" actId="478"/>
          <ac:picMkLst>
            <pc:docMk/>
            <pc:sldMk cId="362827076" sldId="285"/>
            <ac:picMk id="64" creationId="{0EEA69EA-0DF8-7724-5AD9-21D1967F2B98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66" creationId="{6E2F66AD-80F5-8E1D-A20A-71FE96661597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67" creationId="{7217FC52-8580-C194-6699-11CD477FD70F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68" creationId="{46EDDE88-6174-AD6E-04EE-84777E2D5D30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69" creationId="{5A12C923-1398-BA34-D943-63C7B1A602C1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71" creationId="{78BF9E9C-912D-6B72-27CE-89E782486BE7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99" creationId="{B34E47E9-EF0F-346E-E5BB-DF83BF4E2049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14" creationId="{BE6A9055-C25B-80A2-D333-69894C2EC933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17" creationId="{392384CF-8EBE-3AE4-865A-37FA77FC5F3B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30" creationId="{97543FD7-58A4-23CE-9852-2CF743CFCD85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42" creationId="{73D695B1-796B-725C-4FB2-D3DB8C4D6C89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58" creationId="{C96FD066-5099-A77B-D94B-6F1D54C3FB38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60" creationId="{6CB2B61F-663B-D471-E587-FFCF887C257C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61" creationId="{F0D42CBA-5399-16AE-1678-D14802CF8D3E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62" creationId="{C53E0CA8-9EFA-A1EC-2181-CF90216A821D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83" creationId="{92B6C4EF-C913-703F-9EC4-46BC7B7EC1EE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85" creationId="{760F6622-2B5E-CC17-F7CF-DF4AA6A3CA5C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87" creationId="{EBBE178A-4453-8D2D-B156-775D7B593721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89" creationId="{117EE4F7-A2C1-02FB-7F0C-91F092B26EC8}"/>
          </ac:picMkLst>
        </pc:picChg>
        <pc:picChg chg="mod">
          <ac:chgData name="Connor Blair" userId="5dffaaf1-4e99-4a9f-9d58-f6e2d8990ba3" providerId="ADAL" clId="{BC47891A-4B77-47DB-A266-9AB848673391}" dt="2023-12-21T15:23:47.088" v="1068" actId="1035"/>
          <ac:picMkLst>
            <pc:docMk/>
            <pc:sldMk cId="362827076" sldId="285"/>
            <ac:picMk id="191" creationId="{62E801D6-EAAB-0D4F-9A71-0EFBA2E43845}"/>
          </ac:picMkLst>
        </pc:picChg>
        <pc:picChg chg="add mod">
          <ac:chgData name="Connor Blair" userId="5dffaaf1-4e99-4a9f-9d58-f6e2d8990ba3" providerId="ADAL" clId="{BC47891A-4B77-47DB-A266-9AB848673391}" dt="2023-12-21T15:32:10.886" v="1142" actId="1035"/>
          <ac:picMkLst>
            <pc:docMk/>
            <pc:sldMk cId="362827076" sldId="285"/>
            <ac:picMk id="193" creationId="{7CE181C1-6097-660F-35BD-B99EB8163DCB}"/>
          </ac:picMkLst>
        </pc:picChg>
        <pc:picChg chg="add del mod">
          <ac:chgData name="Connor Blair" userId="5dffaaf1-4e99-4a9f-9d58-f6e2d8990ba3" providerId="ADAL" clId="{BC47891A-4B77-47DB-A266-9AB848673391}" dt="2023-12-21T16:35:07.165" v="1148" actId="478"/>
          <ac:picMkLst>
            <pc:docMk/>
            <pc:sldMk cId="362827076" sldId="285"/>
            <ac:picMk id="195" creationId="{818B1D45-E4D3-64B3-F304-A73BB96A2862}"/>
          </ac:picMkLst>
        </pc:picChg>
        <pc:picChg chg="add mod">
          <ac:chgData name="Connor Blair" userId="5dffaaf1-4e99-4a9f-9d58-f6e2d8990ba3" providerId="ADAL" clId="{BC47891A-4B77-47DB-A266-9AB848673391}" dt="2023-12-21T16:35:54.164" v="1235" actId="1036"/>
          <ac:picMkLst>
            <pc:docMk/>
            <pc:sldMk cId="362827076" sldId="285"/>
            <ac:picMk id="197" creationId="{64286815-CFA2-1942-6F0E-61572CB98B34}"/>
          </ac:picMkLst>
        </pc:picChg>
        <pc:picChg chg="add mod">
          <ac:chgData name="Connor Blair" userId="5dffaaf1-4e99-4a9f-9d58-f6e2d8990ba3" providerId="ADAL" clId="{BC47891A-4B77-47DB-A266-9AB848673391}" dt="2023-12-21T16:40:00.577" v="1259" actId="1076"/>
          <ac:picMkLst>
            <pc:docMk/>
            <pc:sldMk cId="362827076" sldId="285"/>
            <ac:picMk id="201" creationId="{47F72ED3-8FBC-AB54-CDE5-975B3498930A}"/>
          </ac:picMkLst>
        </pc:pic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8" creationId="{F3B21FE8-4FF3-9F99-4396-07B196432A31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17" creationId="{54387A1C-543D-128E-1C55-375039F0B2E3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20" creationId="{FFB25728-CB01-FC16-482D-7C5FF248B1B5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26" creationId="{0AD45470-2092-03E8-2427-BC529B302B11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32" creationId="{6DCC090E-B25B-FDC5-1146-24B25BA417DD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35" creationId="{100BD001-6D3B-64B1-D0B6-AEC92DE94D52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36" creationId="{32214D44-5A71-AB5E-3C5A-B3D374E27305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37" creationId="{0F8EB760-08D3-95DB-9B2B-E75D2FF1170D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50" creationId="{44FCCA06-B0CD-4167-E000-EEED6265EFB9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74" creationId="{ED5A0FB0-5658-7327-FBEF-5A3D8F1937F1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75" creationId="{E9A9816A-C97E-E26C-2EC9-037AF6740877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76" creationId="{1FAD06EE-E4E5-92DB-D0CE-10A41BC3F767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88" creationId="{192E6926-BEF3-17AA-AAE4-FC61ECCF71F4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106" creationId="{1940F76E-4921-47C1-7FD4-BB9598B48FCD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112" creationId="{9D107513-63BC-7DA0-7D0D-D94210CFD7DF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120" creationId="{3F52AAF8-4BEE-C024-BEF7-BDD718CA16BB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128" creationId="{C3D8C064-F95B-E98C-0838-AF7B1F86185A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133" creationId="{2CB8490D-233E-765A-4C8C-22E3A50FF9CD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134" creationId="{21F80101-E4BB-7028-7A52-4DA2D2EA3BFB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148" creationId="{D2E11A1A-A1A2-C8F1-5CB5-B9B137850E2D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150" creationId="{3F91DBD0-8F87-B869-7D22-E3DD7F9C1964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169" creationId="{B055256F-D14D-D26B-B164-0B845FB52B63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170" creationId="{12FB7F58-BC48-31C3-A948-1B78543EFCC0}"/>
          </ac:cxnSpMkLst>
        </pc:cxnChg>
        <pc:cxnChg chg="mod">
          <ac:chgData name="Connor Blair" userId="5dffaaf1-4e99-4a9f-9d58-f6e2d8990ba3" providerId="ADAL" clId="{BC47891A-4B77-47DB-A266-9AB848673391}" dt="2023-12-21T15:23:47.088" v="1068" actId="1035"/>
          <ac:cxnSpMkLst>
            <pc:docMk/>
            <pc:sldMk cId="362827076" sldId="285"/>
            <ac:cxnSpMk id="171" creationId="{958D9A2C-A7FD-AF11-C330-0E825DC75899}"/>
          </ac:cxnSpMkLst>
        </pc:cxnChg>
        <pc:cxnChg chg="add mod">
          <ac:chgData name="Connor Blair" userId="5dffaaf1-4e99-4a9f-9d58-f6e2d8990ba3" providerId="ADAL" clId="{BC47891A-4B77-47DB-A266-9AB848673391}" dt="2023-12-21T16:35:50.225" v="1232" actId="1035"/>
          <ac:cxnSpMkLst>
            <pc:docMk/>
            <pc:sldMk cId="362827076" sldId="285"/>
            <ac:cxnSpMk id="199" creationId="{35B10935-6E17-E4EB-A853-E05A7B031C9E}"/>
          </ac:cxnSpMkLst>
        </pc:cxnChg>
      </pc:sldChg>
      <pc:sldChg chg="addSp delSp modSp add del mod">
        <pc:chgData name="Connor Blair" userId="5dffaaf1-4e99-4a9f-9d58-f6e2d8990ba3" providerId="ADAL" clId="{BC47891A-4B77-47DB-A266-9AB848673391}" dt="2023-12-21T15:24:38.171" v="1082" actId="47"/>
        <pc:sldMkLst>
          <pc:docMk/>
          <pc:sldMk cId="3032837757" sldId="286"/>
        </pc:sldMkLst>
        <pc:spChg chg="mod">
          <ac:chgData name="Connor Blair" userId="5dffaaf1-4e99-4a9f-9d58-f6e2d8990ba3" providerId="ADAL" clId="{BC47891A-4B77-47DB-A266-9AB848673391}" dt="2023-12-20T17:17:16.987" v="763" actId="113"/>
          <ac:spMkLst>
            <pc:docMk/>
            <pc:sldMk cId="3032837757" sldId="286"/>
            <ac:spMk id="2" creationId="{ACA36E39-E06E-F87D-A1D6-2423F6FED5C9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3" creationId="{7CF362FD-5F22-3B10-F609-D4F84ABC0A0F}"/>
          </ac:spMkLst>
        </pc:spChg>
        <pc:spChg chg="mod">
          <ac:chgData name="Connor Blair" userId="5dffaaf1-4e99-4a9f-9d58-f6e2d8990ba3" providerId="ADAL" clId="{BC47891A-4B77-47DB-A266-9AB848673391}" dt="2023-12-20T18:18:26.079" v="840" actId="1076"/>
          <ac:spMkLst>
            <pc:docMk/>
            <pc:sldMk cId="3032837757" sldId="286"/>
            <ac:spMk id="6" creationId="{4E77848F-168E-217D-2C30-32424BC5D128}"/>
          </ac:spMkLst>
        </pc:spChg>
        <pc:spChg chg="mod">
          <ac:chgData name="Connor Blair" userId="5dffaaf1-4e99-4a9f-9d58-f6e2d8990ba3" providerId="ADAL" clId="{BC47891A-4B77-47DB-A266-9AB848673391}" dt="2023-12-20T18:18:26.079" v="840" actId="1076"/>
          <ac:spMkLst>
            <pc:docMk/>
            <pc:sldMk cId="3032837757" sldId="286"/>
            <ac:spMk id="7" creationId="{2D254B20-91F1-33CE-0CC1-CF77D7BCEC0C}"/>
          </ac:spMkLst>
        </pc:spChg>
        <pc:spChg chg="add del mod">
          <ac:chgData name="Connor Blair" userId="5dffaaf1-4e99-4a9f-9d58-f6e2d8990ba3" providerId="ADAL" clId="{BC47891A-4B77-47DB-A266-9AB848673391}" dt="2023-12-21T15:21:01.571" v="957" actId="478"/>
          <ac:spMkLst>
            <pc:docMk/>
            <pc:sldMk cId="3032837757" sldId="286"/>
            <ac:spMk id="9" creationId="{3EBAF718-1903-4762-65F5-4C634ED8BDE1}"/>
          </ac:spMkLst>
        </pc:spChg>
        <pc:spChg chg="del mod">
          <ac:chgData name="Connor Blair" userId="5dffaaf1-4e99-4a9f-9d58-f6e2d8990ba3" providerId="ADAL" clId="{BC47891A-4B77-47DB-A266-9AB848673391}" dt="2023-12-21T15:21:18.327" v="961" actId="21"/>
          <ac:spMkLst>
            <pc:docMk/>
            <pc:sldMk cId="3032837757" sldId="286"/>
            <ac:spMk id="10" creationId="{4D7FAB6D-5557-1C05-B0AD-23087629DD47}"/>
          </ac:spMkLst>
        </pc:spChg>
        <pc:spChg chg="mod">
          <ac:chgData name="Connor Blair" userId="5dffaaf1-4e99-4a9f-9d58-f6e2d8990ba3" providerId="ADAL" clId="{BC47891A-4B77-47DB-A266-9AB848673391}" dt="2023-12-20T18:18:26.079" v="840" actId="1076"/>
          <ac:spMkLst>
            <pc:docMk/>
            <pc:sldMk cId="3032837757" sldId="286"/>
            <ac:spMk id="11" creationId="{2D738583-EC7E-72F0-9036-C7E54E669B07}"/>
          </ac:spMkLst>
        </pc:spChg>
        <pc:spChg chg="del">
          <ac:chgData name="Connor Blair" userId="5dffaaf1-4e99-4a9f-9d58-f6e2d8990ba3" providerId="ADAL" clId="{BC47891A-4B77-47DB-A266-9AB848673391}" dt="2023-12-20T17:15:08.225" v="336" actId="478"/>
          <ac:spMkLst>
            <pc:docMk/>
            <pc:sldMk cId="3032837757" sldId="286"/>
            <ac:spMk id="12" creationId="{76055525-E17E-1734-9370-94905375A475}"/>
          </ac:spMkLst>
        </pc:spChg>
        <pc:spChg chg="del">
          <ac:chgData name="Connor Blair" userId="5dffaaf1-4e99-4a9f-9d58-f6e2d8990ba3" providerId="ADAL" clId="{BC47891A-4B77-47DB-A266-9AB848673391}" dt="2023-12-20T17:18:24.707" v="817" actId="478"/>
          <ac:spMkLst>
            <pc:docMk/>
            <pc:sldMk cId="3032837757" sldId="286"/>
            <ac:spMk id="13" creationId="{2E02099E-AA9D-A6C3-531C-A71A01D2C4E3}"/>
          </ac:spMkLst>
        </pc:spChg>
        <pc:spChg chg="del">
          <ac:chgData name="Connor Blair" userId="5dffaaf1-4e99-4a9f-9d58-f6e2d8990ba3" providerId="ADAL" clId="{BC47891A-4B77-47DB-A266-9AB848673391}" dt="2023-12-20T17:18:25.398" v="818" actId="478"/>
          <ac:spMkLst>
            <pc:docMk/>
            <pc:sldMk cId="3032837757" sldId="286"/>
            <ac:spMk id="14" creationId="{6612BD6A-E6CA-67A0-E9D5-8BDA37D17EF8}"/>
          </ac:spMkLst>
        </pc:spChg>
        <pc:spChg chg="del">
          <ac:chgData name="Connor Blair" userId="5dffaaf1-4e99-4a9f-9d58-f6e2d8990ba3" providerId="ADAL" clId="{BC47891A-4B77-47DB-A266-9AB848673391}" dt="2023-12-20T17:18:23.912" v="816" actId="478"/>
          <ac:spMkLst>
            <pc:docMk/>
            <pc:sldMk cId="3032837757" sldId="286"/>
            <ac:spMk id="15" creationId="{AF66BB24-4850-8D38-B5A5-113B203BE311}"/>
          </ac:spMkLst>
        </pc:spChg>
        <pc:spChg chg="del">
          <ac:chgData name="Connor Blair" userId="5dffaaf1-4e99-4a9f-9d58-f6e2d8990ba3" providerId="ADAL" clId="{BC47891A-4B77-47DB-A266-9AB848673391}" dt="2023-12-20T17:18:23.247" v="815" actId="478"/>
          <ac:spMkLst>
            <pc:docMk/>
            <pc:sldMk cId="3032837757" sldId="286"/>
            <ac:spMk id="16" creationId="{BD0B0E09-34FD-BB5B-26B3-F8F286AE2CF8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9" creationId="{FC85046F-D49C-717A-F7FB-FDDBBE66C48B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21" creationId="{531F7090-A44E-24AC-7DBB-62E89FB82D7D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22" creationId="{82900A4A-B2EC-E5F0-4BF9-6E06CD1412A2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23" creationId="{C5BB52DA-33AD-76E7-8E36-455F785D54CF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25" creationId="{25D5A164-627B-236E-8266-7E8BB172198D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27" creationId="{DCDEB768-D082-42B2-5DA7-EE7E08B75BDB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28" creationId="{27F2921F-FBE0-2D3A-2F46-09BEAC262B62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29" creationId="{5D7D544B-3451-9734-73D5-7782790A07E6}"/>
          </ac:spMkLst>
        </pc:spChg>
        <pc:spChg chg="del">
          <ac:chgData name="Connor Blair" userId="5dffaaf1-4e99-4a9f-9d58-f6e2d8990ba3" providerId="ADAL" clId="{BC47891A-4B77-47DB-A266-9AB848673391}" dt="2023-12-20T17:14:35.192" v="282" actId="478"/>
          <ac:spMkLst>
            <pc:docMk/>
            <pc:sldMk cId="3032837757" sldId="286"/>
            <ac:spMk id="30" creationId="{B7EF1D5E-93AE-1423-072C-2611BB73A7B1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31" creationId="{AF3B050C-6CDD-9EA3-060D-5020CABDA01C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33" creationId="{13049982-52DB-DC16-0ED4-7D8B8B25685A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34" creationId="{402B75D1-DBD4-82CF-7BFC-16632833E66D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38" creationId="{A90EA1DB-ADD2-2A53-C5B9-34A7B7A36683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39" creationId="{38DC5F0B-DD53-5C07-A2AD-103719BEE5D8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40" creationId="{EBF12CE8-B199-46B7-C476-7B49A73BA1EC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41" creationId="{8F3F9A28-8291-7C50-9C16-73692BE41F54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42" creationId="{AB026556-0875-C06D-8551-DA0AFB5F1C09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43" creationId="{8F4ED1CC-19CA-1E3F-0129-D51AD00AFE53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44" creationId="{BC9F849D-7173-C769-1193-9BCE1BE51004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45" creationId="{1523298C-1B17-290C-1616-58F2D70F31C1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46" creationId="{89A2BB3E-C0FE-8E6A-F057-AEC22108693E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47" creationId="{815EA4A5-974D-F616-3363-229D5AB5B782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48" creationId="{E2A2607D-E14D-241A-DE7D-79D02EE30892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51" creationId="{642D7966-847E-DC70-EEE8-4CE9859F230B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52" creationId="{0CD3F66F-2E9B-7088-ED35-DFB8AE9081AF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55" creationId="{94E718DF-D030-B8F9-7973-043AC9991592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56" creationId="{CF378D53-4277-6068-5AD6-620E54FB1A0B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58" creationId="{B3A784E6-A831-B5D8-0DBC-F8BF66BF7CC6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59" creationId="{7CF8A65A-4C46-F489-F2CE-C6052B64BDA9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60" creationId="{936D4AF1-C59D-4DB2-9FEA-7C3CED55C4DF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61" creationId="{D4A32365-3911-E152-C163-4CECD5DD6E60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62" creationId="{294F969B-E9ED-B5C8-C7FE-A0C2D18E656E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63" creationId="{9AE241C2-F8F4-5851-DF7A-B7F526C6A6BD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72" creationId="{ADD52AB3-0A0A-DF7A-C91E-476FC4DBFD89}"/>
          </ac:spMkLst>
        </pc:spChg>
        <pc:spChg chg="del mod">
          <ac:chgData name="Connor Blair" userId="5dffaaf1-4e99-4a9f-9d58-f6e2d8990ba3" providerId="ADAL" clId="{BC47891A-4B77-47DB-A266-9AB848673391}" dt="2023-12-21T15:21:04.503" v="958" actId="478"/>
          <ac:spMkLst>
            <pc:docMk/>
            <pc:sldMk cId="3032837757" sldId="286"/>
            <ac:spMk id="77" creationId="{5B080F33-FEA0-F68A-3E38-0DDBC3E6DF63}"/>
          </ac:spMkLst>
        </pc:spChg>
        <pc:spChg chg="del mod">
          <ac:chgData name="Connor Blair" userId="5dffaaf1-4e99-4a9f-9d58-f6e2d8990ba3" providerId="ADAL" clId="{BC47891A-4B77-47DB-A266-9AB848673391}" dt="2023-12-20T18:20:39.377" v="954" actId="478"/>
          <ac:spMkLst>
            <pc:docMk/>
            <pc:sldMk cId="3032837757" sldId="286"/>
            <ac:spMk id="78" creationId="{B3888673-2FC7-6E18-4D28-E1955EB07B1F}"/>
          </ac:spMkLst>
        </pc:spChg>
        <pc:spChg chg="del mod">
          <ac:chgData name="Connor Blair" userId="5dffaaf1-4e99-4a9f-9d58-f6e2d8990ba3" providerId="ADAL" clId="{BC47891A-4B77-47DB-A266-9AB848673391}" dt="2023-12-20T18:20:39.977" v="955" actId="478"/>
          <ac:spMkLst>
            <pc:docMk/>
            <pc:sldMk cId="3032837757" sldId="286"/>
            <ac:spMk id="79" creationId="{78B95401-529E-8872-7C6B-61BE5B7F06B4}"/>
          </ac:spMkLst>
        </pc:spChg>
        <pc:spChg chg="del mod">
          <ac:chgData name="Connor Blair" userId="5dffaaf1-4e99-4a9f-9d58-f6e2d8990ba3" providerId="ADAL" clId="{BC47891A-4B77-47DB-A266-9AB848673391}" dt="2023-12-20T18:20:39.377" v="954" actId="478"/>
          <ac:spMkLst>
            <pc:docMk/>
            <pc:sldMk cId="3032837757" sldId="286"/>
            <ac:spMk id="80" creationId="{345A793F-4F67-306B-EA30-9B9A06BD27D3}"/>
          </ac:spMkLst>
        </pc:spChg>
        <pc:spChg chg="del">
          <ac:chgData name="Connor Blair" userId="5dffaaf1-4e99-4a9f-9d58-f6e2d8990ba3" providerId="ADAL" clId="{BC47891A-4B77-47DB-A266-9AB848673391}" dt="2023-12-20T17:18:21.455" v="814" actId="478"/>
          <ac:spMkLst>
            <pc:docMk/>
            <pc:sldMk cId="3032837757" sldId="286"/>
            <ac:spMk id="81" creationId="{2304959A-C5EC-D661-572C-675B58B3D802}"/>
          </ac:spMkLst>
        </pc:spChg>
        <pc:spChg chg="del">
          <ac:chgData name="Connor Blair" userId="5dffaaf1-4e99-4a9f-9d58-f6e2d8990ba3" providerId="ADAL" clId="{BC47891A-4B77-47DB-A266-9AB848673391}" dt="2023-12-20T17:18:21.455" v="814" actId="478"/>
          <ac:spMkLst>
            <pc:docMk/>
            <pc:sldMk cId="3032837757" sldId="286"/>
            <ac:spMk id="82" creationId="{AED8DEA9-FBCF-6E7D-EEB7-541A7F4F9AB4}"/>
          </ac:spMkLst>
        </pc:spChg>
        <pc:spChg chg="del mod">
          <ac:chgData name="Connor Blair" userId="5dffaaf1-4e99-4a9f-9d58-f6e2d8990ba3" providerId="ADAL" clId="{BC47891A-4B77-47DB-A266-9AB848673391}" dt="2023-12-20T18:20:39.377" v="954" actId="478"/>
          <ac:spMkLst>
            <pc:docMk/>
            <pc:sldMk cId="3032837757" sldId="286"/>
            <ac:spMk id="83" creationId="{E1DAC9DD-51EC-985E-5323-9CE4D1293139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84" creationId="{49AA8608-E66D-DCB0-9B73-6DFF9439E241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85" creationId="{718F9119-D38F-0A56-863B-F755C9BCAF35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86" creationId="{7236B376-9F23-4062-A2A1-E4189A63E2BC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87" creationId="{8F977640-76A3-7374-C7CD-81467F0C9FA9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89" creationId="{994B874F-B9DA-3DF3-4E9B-CDDC6F673F19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90" creationId="{ED4A2F09-832B-3D3A-51BA-C9664570D2C9}"/>
          </ac:spMkLst>
        </pc:spChg>
        <pc:spChg chg="mod">
          <ac:chgData name="Connor Blair" userId="5dffaaf1-4e99-4a9f-9d58-f6e2d8990ba3" providerId="ADAL" clId="{BC47891A-4B77-47DB-A266-9AB848673391}" dt="2023-12-20T17:14:45.291" v="298" actId="20577"/>
          <ac:spMkLst>
            <pc:docMk/>
            <pc:sldMk cId="3032837757" sldId="286"/>
            <ac:spMk id="91" creationId="{EE6F7C15-5A20-BBDC-1FE3-9170C97FBEA6}"/>
          </ac:spMkLst>
        </pc:spChg>
        <pc:spChg chg="del mod">
          <ac:chgData name="Connor Blair" userId="5dffaaf1-4e99-4a9f-9d58-f6e2d8990ba3" providerId="ADAL" clId="{BC47891A-4B77-47DB-A266-9AB848673391}" dt="2023-12-20T17:16:43.958" v="711" actId="478"/>
          <ac:spMkLst>
            <pc:docMk/>
            <pc:sldMk cId="3032837757" sldId="286"/>
            <ac:spMk id="92" creationId="{4A5D08EC-4D2A-81B6-22C5-7D076CE49D6E}"/>
          </ac:spMkLst>
        </pc:spChg>
        <pc:spChg chg="del">
          <ac:chgData name="Connor Blair" userId="5dffaaf1-4e99-4a9f-9d58-f6e2d8990ba3" providerId="ADAL" clId="{BC47891A-4B77-47DB-A266-9AB848673391}" dt="2023-12-20T17:14:29.280" v="279" actId="478"/>
          <ac:spMkLst>
            <pc:docMk/>
            <pc:sldMk cId="3032837757" sldId="286"/>
            <ac:spMk id="93" creationId="{E079BB6B-1234-52D6-C0A5-D183775C0152}"/>
          </ac:spMkLst>
        </pc:spChg>
        <pc:spChg chg="del">
          <ac:chgData name="Connor Blair" userId="5dffaaf1-4e99-4a9f-9d58-f6e2d8990ba3" providerId="ADAL" clId="{BC47891A-4B77-47DB-A266-9AB848673391}" dt="2023-12-20T17:14:26.535" v="277" actId="478"/>
          <ac:spMkLst>
            <pc:docMk/>
            <pc:sldMk cId="3032837757" sldId="286"/>
            <ac:spMk id="94" creationId="{1923C7E1-13F6-F371-95A1-CE84BF1AB5EC}"/>
          </ac:spMkLst>
        </pc:spChg>
        <pc:spChg chg="del">
          <ac:chgData name="Connor Blair" userId="5dffaaf1-4e99-4a9f-9d58-f6e2d8990ba3" providerId="ADAL" clId="{BC47891A-4B77-47DB-A266-9AB848673391}" dt="2023-12-20T17:14:27.998" v="278" actId="478"/>
          <ac:spMkLst>
            <pc:docMk/>
            <pc:sldMk cId="3032837757" sldId="286"/>
            <ac:spMk id="96" creationId="{412393D2-75B9-455F-174B-D05851B7F409}"/>
          </ac:spMkLst>
        </pc:spChg>
        <pc:spChg chg="del">
          <ac:chgData name="Connor Blair" userId="5dffaaf1-4e99-4a9f-9d58-f6e2d8990ba3" providerId="ADAL" clId="{BC47891A-4B77-47DB-A266-9AB848673391}" dt="2023-12-20T17:15:09.912" v="337" actId="478"/>
          <ac:spMkLst>
            <pc:docMk/>
            <pc:sldMk cId="3032837757" sldId="286"/>
            <ac:spMk id="97" creationId="{578E4E55-5D11-A767-108C-902FB98AFBB9}"/>
          </ac:spMkLst>
        </pc:spChg>
        <pc:spChg chg="add del mod">
          <ac:chgData name="Connor Blair" userId="5dffaaf1-4e99-4a9f-9d58-f6e2d8990ba3" providerId="ADAL" clId="{BC47891A-4B77-47DB-A266-9AB848673391}" dt="2023-12-21T15:21:18.327" v="961" actId="21"/>
          <ac:spMkLst>
            <pc:docMk/>
            <pc:sldMk cId="3032837757" sldId="286"/>
            <ac:spMk id="98" creationId="{1638AC6A-6866-5DD6-5F70-59112F3C71D6}"/>
          </ac:spMkLst>
        </pc:spChg>
        <pc:spChg chg="add del mod">
          <ac:chgData name="Connor Blair" userId="5dffaaf1-4e99-4a9f-9d58-f6e2d8990ba3" providerId="ADAL" clId="{BC47891A-4B77-47DB-A266-9AB848673391}" dt="2023-12-21T15:21:18.327" v="961" actId="21"/>
          <ac:spMkLst>
            <pc:docMk/>
            <pc:sldMk cId="3032837757" sldId="286"/>
            <ac:spMk id="100" creationId="{D73866BF-C82D-A8BD-612F-02FC669887BB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01" creationId="{D6FCA51F-2DD3-9A78-3912-3F28AFAECACB}"/>
          </ac:spMkLst>
        </pc:spChg>
        <pc:spChg chg="add del mod">
          <ac:chgData name="Connor Blair" userId="5dffaaf1-4e99-4a9f-9d58-f6e2d8990ba3" providerId="ADAL" clId="{BC47891A-4B77-47DB-A266-9AB848673391}" dt="2023-12-21T15:21:18.327" v="961" actId="21"/>
          <ac:spMkLst>
            <pc:docMk/>
            <pc:sldMk cId="3032837757" sldId="286"/>
            <ac:spMk id="102" creationId="{8BCD1F87-5571-25A7-91C8-BC192091C0DA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03" creationId="{31923B51-7ACB-7046-A118-DCD40FCEDBAD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04" creationId="{1263E356-6892-E89C-AEAE-98182109C0FC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05" creationId="{0C55E764-BCA5-C9B6-06F4-9802B2654D96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07" creationId="{144067BF-185C-53E5-D1E8-81C2A8064CEB}"/>
          </ac:spMkLst>
        </pc:spChg>
        <pc:spChg chg="add del mod">
          <ac:chgData name="Connor Blair" userId="5dffaaf1-4e99-4a9f-9d58-f6e2d8990ba3" providerId="ADAL" clId="{BC47891A-4B77-47DB-A266-9AB848673391}" dt="2023-12-21T15:21:18.327" v="961" actId="21"/>
          <ac:spMkLst>
            <pc:docMk/>
            <pc:sldMk cId="3032837757" sldId="286"/>
            <ac:spMk id="108" creationId="{722D154B-609C-4965-5346-032675C5AC4E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09" creationId="{78996398-D7DD-26D7-89F0-7AAAA8391FD6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10" creationId="{96A3872E-6A1C-6C21-6772-038CD56EA3FE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11" creationId="{37875684-BF49-18AE-E892-F2DE50862186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13" creationId="{2342ADFC-A93D-D02B-A422-C15F2A0AC612}"/>
          </ac:spMkLst>
        </pc:spChg>
        <pc:spChg chg="add del mod">
          <ac:chgData name="Connor Blair" userId="5dffaaf1-4e99-4a9f-9d58-f6e2d8990ba3" providerId="ADAL" clId="{BC47891A-4B77-47DB-A266-9AB848673391}" dt="2023-12-21T15:21:18.327" v="961" actId="21"/>
          <ac:spMkLst>
            <pc:docMk/>
            <pc:sldMk cId="3032837757" sldId="286"/>
            <ac:spMk id="115" creationId="{2EB2C37F-4DB9-DCCA-7F59-6B08B0783ADB}"/>
          </ac:spMkLst>
        </pc:spChg>
        <pc:spChg chg="add del mod">
          <ac:chgData name="Connor Blair" userId="5dffaaf1-4e99-4a9f-9d58-f6e2d8990ba3" providerId="ADAL" clId="{BC47891A-4B77-47DB-A266-9AB848673391}" dt="2023-12-21T15:21:18.327" v="961" actId="21"/>
          <ac:spMkLst>
            <pc:docMk/>
            <pc:sldMk cId="3032837757" sldId="286"/>
            <ac:spMk id="116" creationId="{572EFD25-F750-6108-C615-A174FDCA2A1C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18" creationId="{A9E1C42C-97E1-6762-8A75-BA815203CB8C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19" creationId="{9A23718E-BC14-8401-4CBA-47E7BA15701C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21" creationId="{6CBCF270-AE05-2D73-5FF0-BF80EBFC0B64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22" creationId="{7F347CA5-08EC-71B5-654B-47155367FCD1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23" creationId="{59FBFBB4-96E8-A2D0-B7FD-B6DC13B6A05D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24" creationId="{CD01EC37-44B5-286C-3355-75FD97981CB4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25" creationId="{35871861-C6A5-A81F-E8FC-88396CB4A886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26" creationId="{E4CB0DBA-DF78-F3AC-7BC0-E0F120E8AA83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27" creationId="{3EE6FB43-B952-36B1-4389-A3134501A8EC}"/>
          </ac:spMkLst>
        </pc:spChg>
        <pc:spChg chg="add del mod">
          <ac:chgData name="Connor Blair" userId="5dffaaf1-4e99-4a9f-9d58-f6e2d8990ba3" providerId="ADAL" clId="{BC47891A-4B77-47DB-A266-9AB848673391}" dt="2023-12-21T15:21:18.327" v="961" actId="21"/>
          <ac:spMkLst>
            <pc:docMk/>
            <pc:sldMk cId="3032837757" sldId="286"/>
            <ac:spMk id="129" creationId="{88115FFD-DB22-6520-36FA-694AEDCACFCB}"/>
          </ac:spMkLst>
        </pc:spChg>
        <pc:spChg chg="del">
          <ac:chgData name="Connor Blair" userId="5dffaaf1-4e99-4a9f-9d58-f6e2d8990ba3" providerId="ADAL" clId="{BC47891A-4B77-47DB-A266-9AB848673391}" dt="2023-12-20T17:14:39.625" v="289" actId="478"/>
          <ac:spMkLst>
            <pc:docMk/>
            <pc:sldMk cId="3032837757" sldId="286"/>
            <ac:spMk id="131" creationId="{26B39956-5FB5-2CD1-D76E-0D78E92C3E43}"/>
          </ac:spMkLst>
        </pc:spChg>
        <pc:spChg chg="del">
          <ac:chgData name="Connor Blair" userId="5dffaaf1-4e99-4a9f-9d58-f6e2d8990ba3" providerId="ADAL" clId="{BC47891A-4B77-47DB-A266-9AB848673391}" dt="2023-12-20T17:14:39.625" v="289" actId="478"/>
          <ac:spMkLst>
            <pc:docMk/>
            <pc:sldMk cId="3032837757" sldId="286"/>
            <ac:spMk id="132" creationId="{A76C0B8E-E014-61ED-B61F-59645DF84439}"/>
          </ac:spMkLst>
        </pc:spChg>
        <pc:spChg chg="del">
          <ac:chgData name="Connor Blair" userId="5dffaaf1-4e99-4a9f-9d58-f6e2d8990ba3" providerId="ADAL" clId="{BC47891A-4B77-47DB-A266-9AB848673391}" dt="2023-12-20T17:14:38.483" v="288" actId="478"/>
          <ac:spMkLst>
            <pc:docMk/>
            <pc:sldMk cId="3032837757" sldId="286"/>
            <ac:spMk id="135" creationId="{D0758A3E-FDB1-5F4F-0CF2-B4222B05B5A7}"/>
          </ac:spMkLst>
        </pc:spChg>
        <pc:spChg chg="del">
          <ac:chgData name="Connor Blair" userId="5dffaaf1-4e99-4a9f-9d58-f6e2d8990ba3" providerId="ADAL" clId="{BC47891A-4B77-47DB-A266-9AB848673391}" dt="2023-12-20T17:14:39.625" v="289" actId="478"/>
          <ac:spMkLst>
            <pc:docMk/>
            <pc:sldMk cId="3032837757" sldId="286"/>
            <ac:spMk id="136" creationId="{32961E6F-1B69-692B-DF34-4989B8825B40}"/>
          </ac:spMkLst>
        </pc:spChg>
        <pc:spChg chg="del">
          <ac:chgData name="Connor Blair" userId="5dffaaf1-4e99-4a9f-9d58-f6e2d8990ba3" providerId="ADAL" clId="{BC47891A-4B77-47DB-A266-9AB848673391}" dt="2023-12-20T17:14:39.625" v="289" actId="478"/>
          <ac:spMkLst>
            <pc:docMk/>
            <pc:sldMk cId="3032837757" sldId="286"/>
            <ac:spMk id="137" creationId="{52AEDA82-AE51-DAA7-0836-450369399C43}"/>
          </ac:spMkLst>
        </pc:spChg>
        <pc:spChg chg="del mod">
          <ac:chgData name="Connor Blair" userId="5dffaaf1-4e99-4a9f-9d58-f6e2d8990ba3" providerId="ADAL" clId="{BC47891A-4B77-47DB-A266-9AB848673391}" dt="2023-12-20T18:20:41.293" v="956" actId="478"/>
          <ac:spMkLst>
            <pc:docMk/>
            <pc:sldMk cId="3032837757" sldId="286"/>
            <ac:spMk id="138" creationId="{DA6BC2AE-9862-EA2F-5EF9-387419061462}"/>
          </ac:spMkLst>
        </pc:spChg>
        <pc:spChg chg="del mod">
          <ac:chgData name="Connor Blair" userId="5dffaaf1-4e99-4a9f-9d58-f6e2d8990ba3" providerId="ADAL" clId="{BC47891A-4B77-47DB-A266-9AB848673391}" dt="2023-12-20T18:20:41.293" v="956" actId="478"/>
          <ac:spMkLst>
            <pc:docMk/>
            <pc:sldMk cId="3032837757" sldId="286"/>
            <ac:spMk id="139" creationId="{B4E41212-305E-BD0B-BE1A-A40282C89AC7}"/>
          </ac:spMkLst>
        </pc:spChg>
        <pc:spChg chg="del mod">
          <ac:chgData name="Connor Blair" userId="5dffaaf1-4e99-4a9f-9d58-f6e2d8990ba3" providerId="ADAL" clId="{BC47891A-4B77-47DB-A266-9AB848673391}" dt="2023-12-20T18:20:41.293" v="956" actId="478"/>
          <ac:spMkLst>
            <pc:docMk/>
            <pc:sldMk cId="3032837757" sldId="286"/>
            <ac:spMk id="140" creationId="{19ACDFAE-6604-B1AD-515A-C22A0296EC9C}"/>
          </ac:spMkLst>
        </pc:spChg>
        <pc:spChg chg="del mod">
          <ac:chgData name="Connor Blair" userId="5dffaaf1-4e99-4a9f-9d58-f6e2d8990ba3" providerId="ADAL" clId="{BC47891A-4B77-47DB-A266-9AB848673391}" dt="2023-12-20T18:20:41.293" v="956" actId="478"/>
          <ac:spMkLst>
            <pc:docMk/>
            <pc:sldMk cId="3032837757" sldId="286"/>
            <ac:spMk id="141" creationId="{65414F76-0615-1493-3C20-658C4C2D1839}"/>
          </ac:spMkLst>
        </pc:spChg>
        <pc:spChg chg="add del mod">
          <ac:chgData name="Connor Blair" userId="5dffaaf1-4e99-4a9f-9d58-f6e2d8990ba3" providerId="ADAL" clId="{BC47891A-4B77-47DB-A266-9AB848673391}" dt="2023-12-21T15:21:18.327" v="961" actId="21"/>
          <ac:spMkLst>
            <pc:docMk/>
            <pc:sldMk cId="3032837757" sldId="286"/>
            <ac:spMk id="143" creationId="{40036324-596A-6526-90D4-EAA86DD049BE}"/>
          </ac:spMkLst>
        </pc:spChg>
        <pc:spChg chg="add del mod">
          <ac:chgData name="Connor Blair" userId="5dffaaf1-4e99-4a9f-9d58-f6e2d8990ba3" providerId="ADAL" clId="{BC47891A-4B77-47DB-A266-9AB848673391}" dt="2023-12-21T15:21:01.571" v="957" actId="478"/>
          <ac:spMkLst>
            <pc:docMk/>
            <pc:sldMk cId="3032837757" sldId="286"/>
            <ac:spMk id="144" creationId="{65054816-B938-8441-1DEF-03F7CE9452CC}"/>
          </ac:spMkLst>
        </pc:spChg>
        <pc:spChg chg="add del mod">
          <ac:chgData name="Connor Blair" userId="5dffaaf1-4e99-4a9f-9d58-f6e2d8990ba3" providerId="ADAL" clId="{BC47891A-4B77-47DB-A266-9AB848673391}" dt="2023-12-21T15:21:01.571" v="957" actId="478"/>
          <ac:spMkLst>
            <pc:docMk/>
            <pc:sldMk cId="3032837757" sldId="286"/>
            <ac:spMk id="145" creationId="{8B9E09C2-FC34-E9A1-8D98-25B5588B4659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46" creationId="{3082647E-D42B-F44D-4798-704592C6E821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47" creationId="{69C3851C-BA13-91D4-A50D-0199C96CB0B6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49" creationId="{7E089F34-53E9-BE68-004C-EE62C7D94483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51" creationId="{877879F0-AA83-56BC-F394-A554D7C65F95}"/>
          </ac:spMkLst>
        </pc:spChg>
        <pc:spChg chg="del">
          <ac:chgData name="Connor Blair" userId="5dffaaf1-4e99-4a9f-9d58-f6e2d8990ba3" providerId="ADAL" clId="{BC47891A-4B77-47DB-A266-9AB848673391}" dt="2023-12-20T17:14:38.033" v="287" actId="478"/>
          <ac:spMkLst>
            <pc:docMk/>
            <pc:sldMk cId="3032837757" sldId="286"/>
            <ac:spMk id="152" creationId="{C78DD04B-2120-BEBE-9F5A-5C20C8072F9E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53" creationId="{3ECEF43E-3671-B86E-69C7-4B1733D5253C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54" creationId="{8A12541B-9CD9-324B-C52F-8DF408CB8796}"/>
          </ac:spMkLst>
        </pc:spChg>
        <pc:spChg chg="add del mod">
          <ac:chgData name="Connor Blair" userId="5dffaaf1-4e99-4a9f-9d58-f6e2d8990ba3" providerId="ADAL" clId="{BC47891A-4B77-47DB-A266-9AB848673391}" dt="2023-12-21T15:21:01.571" v="957" actId="478"/>
          <ac:spMkLst>
            <pc:docMk/>
            <pc:sldMk cId="3032837757" sldId="286"/>
            <ac:spMk id="155" creationId="{21F6D48B-1F1B-D01A-745B-F0741F09EB57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56" creationId="{DC254E0F-4801-98C1-56AD-4F651B10C8E4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57" creationId="{0371AB2F-78D5-FF50-D4E2-FEAA2A76DC49}"/>
          </ac:spMkLst>
        </pc:spChg>
        <pc:spChg chg="add del mod">
          <ac:chgData name="Connor Blair" userId="5dffaaf1-4e99-4a9f-9d58-f6e2d8990ba3" providerId="ADAL" clId="{BC47891A-4B77-47DB-A266-9AB848673391}" dt="2023-12-21T15:21:01.571" v="957" actId="478"/>
          <ac:spMkLst>
            <pc:docMk/>
            <pc:sldMk cId="3032837757" sldId="286"/>
            <ac:spMk id="159" creationId="{1C8D0380-37DB-92A3-2710-66AF974ABC6A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63" creationId="{CCF8CB03-2398-D03F-90A2-F2992037B6B1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64" creationId="{592C5588-A064-4B9D-B30C-2741CA605341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65" creationId="{F261C5F1-1531-273E-B54F-151CD0CDF800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66" creationId="{6A4A682B-B13F-3B6D-A417-C173E6C17D41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67" creationId="{B75DE22E-8333-4098-735B-478927B7F375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68" creationId="{7B67D776-BE27-84F5-CECA-D563EDE45369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72" creationId="{34403509-8ED0-10E1-2382-11316E9C6688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73" creationId="{D0055CBC-965F-841A-DF70-2878FF246A34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74" creationId="{12BB31F6-3998-6C07-A038-CA9D9450B3AA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75" creationId="{C117AC8D-00EF-C953-5355-F47564F98BE1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76" creationId="{4D59AC88-1253-C17D-F708-6292472DF242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77" creationId="{C2BB3111-F4B6-377B-7CD7-0E5E099A1006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78" creationId="{D5C6F07A-DD39-603D-7A09-CEA0E81B62FD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79" creationId="{3C936277-0F88-97AD-724A-9CA91C5E7130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80" creationId="{859EAD91-2A07-A3C8-B246-E47237A4D2CA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81" creationId="{86D4F711-480E-479B-CC17-9DCB8541374B}"/>
          </ac:spMkLst>
        </pc:spChg>
        <pc:spChg chg="del">
          <ac:chgData name="Connor Blair" userId="5dffaaf1-4e99-4a9f-9d58-f6e2d8990ba3" providerId="ADAL" clId="{BC47891A-4B77-47DB-A266-9AB848673391}" dt="2023-12-20T17:14:21.162" v="276" actId="478"/>
          <ac:spMkLst>
            <pc:docMk/>
            <pc:sldMk cId="3032837757" sldId="286"/>
            <ac:spMk id="182" creationId="{DAAFE155-AE47-6F26-5017-447036749BF8}"/>
          </ac:spMkLst>
        </pc:spChg>
        <pc:spChg chg="add del mod">
          <ac:chgData name="Connor Blair" userId="5dffaaf1-4e99-4a9f-9d58-f6e2d8990ba3" providerId="ADAL" clId="{BC47891A-4B77-47DB-A266-9AB848673391}" dt="2023-12-21T15:21:01.571" v="957" actId="478"/>
          <ac:spMkLst>
            <pc:docMk/>
            <pc:sldMk cId="3032837757" sldId="286"/>
            <ac:spMk id="184" creationId="{467F029E-1A10-6843-4FE7-901DA2ECF6B0}"/>
          </ac:spMkLst>
        </pc:spChg>
        <pc:spChg chg="add del mod">
          <ac:chgData name="Connor Blair" userId="5dffaaf1-4e99-4a9f-9d58-f6e2d8990ba3" providerId="ADAL" clId="{BC47891A-4B77-47DB-A266-9AB848673391}" dt="2023-12-21T15:21:01.571" v="957" actId="478"/>
          <ac:spMkLst>
            <pc:docMk/>
            <pc:sldMk cId="3032837757" sldId="286"/>
            <ac:spMk id="186" creationId="{16BC3A92-A0CA-719D-B9D7-EE6F7A9CDF60}"/>
          </ac:spMkLst>
        </pc:spChg>
        <pc:spChg chg="add del mod">
          <ac:chgData name="Connor Blair" userId="5dffaaf1-4e99-4a9f-9d58-f6e2d8990ba3" providerId="ADAL" clId="{BC47891A-4B77-47DB-A266-9AB848673391}" dt="2023-12-21T15:21:01.571" v="957" actId="478"/>
          <ac:spMkLst>
            <pc:docMk/>
            <pc:sldMk cId="3032837757" sldId="286"/>
            <ac:spMk id="188" creationId="{E2A666E2-DAA4-40B9-06DE-7AAEC16EC73A}"/>
          </ac:spMkLst>
        </pc:spChg>
        <pc:spChg chg="add del mod">
          <ac:chgData name="Connor Blair" userId="5dffaaf1-4e99-4a9f-9d58-f6e2d8990ba3" providerId="ADAL" clId="{BC47891A-4B77-47DB-A266-9AB848673391}" dt="2023-12-21T15:21:01.571" v="957" actId="478"/>
          <ac:spMkLst>
            <pc:docMk/>
            <pc:sldMk cId="3032837757" sldId="286"/>
            <ac:spMk id="190" creationId="{C3E448B3-A8F1-2121-6323-971B6517D189}"/>
          </ac:spMkLst>
        </pc:spChg>
        <pc:grpChg chg="mod">
          <ac:chgData name="Connor Blair" userId="5dffaaf1-4e99-4a9f-9d58-f6e2d8990ba3" providerId="ADAL" clId="{BC47891A-4B77-47DB-A266-9AB848673391}" dt="2023-12-20T17:16:54.941" v="744" actId="1038"/>
          <ac:grpSpMkLst>
            <pc:docMk/>
            <pc:sldMk cId="3032837757" sldId="286"/>
            <ac:grpSpMk id="73" creationId="{88E76AD8-F91E-BDB9-F37B-EAF91D88BE71}"/>
          </ac:grpSpMkLst>
        </pc:grpChg>
        <pc:picChg chg="del">
          <ac:chgData name="Connor Blair" userId="5dffaaf1-4e99-4a9f-9d58-f6e2d8990ba3" providerId="ADAL" clId="{BC47891A-4B77-47DB-A266-9AB848673391}" dt="2023-12-20T17:14:33.970" v="280" actId="478"/>
          <ac:picMkLst>
            <pc:docMk/>
            <pc:sldMk cId="3032837757" sldId="286"/>
            <ac:picMk id="5" creationId="{8A0A0909-2C52-AA85-2B59-8C6BA07A572A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18" creationId="{345BBF85-F225-2BA2-400E-9618E5765D90}"/>
          </ac:picMkLst>
        </pc:picChg>
        <pc:picChg chg="add del mod">
          <ac:chgData name="Connor Blair" userId="5dffaaf1-4e99-4a9f-9d58-f6e2d8990ba3" providerId="ADAL" clId="{BC47891A-4B77-47DB-A266-9AB848673391}" dt="2023-12-20T18:17:44.003" v="826" actId="21"/>
          <ac:picMkLst>
            <pc:docMk/>
            <pc:sldMk cId="3032837757" sldId="286"/>
            <ac:picMk id="49" creationId="{2F003D13-3EFA-9E1F-674B-5764EAA44A0B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53" creationId="{02F6CDC9-B606-E735-F5A7-72704B72D24D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54" creationId="{6602E107-F38E-CD52-031B-8E354093A867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57" creationId="{CE4D3829-5858-9971-DD2B-34AC5375F2E3}"/>
          </ac:picMkLst>
        </pc:picChg>
        <pc:picChg chg="add del mod">
          <ac:chgData name="Connor Blair" userId="5dffaaf1-4e99-4a9f-9d58-f6e2d8990ba3" providerId="ADAL" clId="{BC47891A-4B77-47DB-A266-9AB848673391}" dt="2023-12-21T15:21:01.571" v="957" actId="478"/>
          <ac:picMkLst>
            <pc:docMk/>
            <pc:sldMk cId="3032837757" sldId="286"/>
            <ac:picMk id="65" creationId="{48029E3A-6C83-4B6A-74F0-D3DC9D549A72}"/>
          </ac:picMkLst>
        </pc:picChg>
        <pc:picChg chg="del">
          <ac:chgData name="Connor Blair" userId="5dffaaf1-4e99-4a9f-9d58-f6e2d8990ba3" providerId="ADAL" clId="{BC47891A-4B77-47DB-A266-9AB848673391}" dt="2023-12-20T17:14:34.312" v="281" actId="478"/>
          <ac:picMkLst>
            <pc:docMk/>
            <pc:sldMk cId="3032837757" sldId="286"/>
            <ac:picMk id="66" creationId="{6E2F66AD-80F5-8E1D-A20A-71FE96661597}"/>
          </ac:picMkLst>
        </pc:picChg>
        <pc:picChg chg="del">
          <ac:chgData name="Connor Blair" userId="5dffaaf1-4e99-4a9f-9d58-f6e2d8990ba3" providerId="ADAL" clId="{BC47891A-4B77-47DB-A266-9AB848673391}" dt="2023-12-20T17:14:35.762" v="283" actId="478"/>
          <ac:picMkLst>
            <pc:docMk/>
            <pc:sldMk cId="3032837757" sldId="286"/>
            <ac:picMk id="67" creationId="{7217FC52-8580-C194-6699-11CD477FD70F}"/>
          </ac:picMkLst>
        </pc:picChg>
        <pc:picChg chg="del">
          <ac:chgData name="Connor Blair" userId="5dffaaf1-4e99-4a9f-9d58-f6e2d8990ba3" providerId="ADAL" clId="{BC47891A-4B77-47DB-A266-9AB848673391}" dt="2023-12-20T17:14:36.032" v="284" actId="478"/>
          <ac:picMkLst>
            <pc:docMk/>
            <pc:sldMk cId="3032837757" sldId="286"/>
            <ac:picMk id="68" creationId="{46EDDE88-6174-AD6E-04EE-84777E2D5D30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69" creationId="{5A12C923-1398-BA34-D943-63C7B1A602C1}"/>
          </ac:picMkLst>
        </pc:picChg>
        <pc:picChg chg="add del mod">
          <ac:chgData name="Connor Blair" userId="5dffaaf1-4e99-4a9f-9d58-f6e2d8990ba3" providerId="ADAL" clId="{BC47891A-4B77-47DB-A266-9AB848673391}" dt="2023-12-21T15:21:18.327" v="961" actId="21"/>
          <ac:picMkLst>
            <pc:docMk/>
            <pc:sldMk cId="3032837757" sldId="286"/>
            <ac:picMk id="70" creationId="{65582512-A977-FD79-93AF-0DDCBA953906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71" creationId="{78BF9E9C-912D-6B72-27CE-89E782486BE7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99" creationId="{B34E47E9-EF0F-346E-E5BB-DF83BF4E2049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114" creationId="{BE6A9055-C25B-80A2-D333-69894C2EC933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117" creationId="{392384CF-8EBE-3AE4-865A-37FA77FC5F3B}"/>
          </ac:picMkLst>
        </pc:picChg>
        <pc:picChg chg="del">
          <ac:chgData name="Connor Blair" userId="5dffaaf1-4e99-4a9f-9d58-f6e2d8990ba3" providerId="ADAL" clId="{BC47891A-4B77-47DB-A266-9AB848673391}" dt="2023-12-20T17:14:37.129" v="286" actId="478"/>
          <ac:picMkLst>
            <pc:docMk/>
            <pc:sldMk cId="3032837757" sldId="286"/>
            <ac:picMk id="130" creationId="{97543FD7-58A4-23CE-9852-2CF743CFCD85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142" creationId="{73D695B1-796B-725C-4FB2-D3DB8C4D6C89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158" creationId="{C96FD066-5099-A77B-D94B-6F1D54C3FB38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160" creationId="{6CB2B61F-663B-D471-E587-FFCF887C257C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161" creationId="{F0D42CBA-5399-16AE-1678-D14802CF8D3E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162" creationId="{C53E0CA8-9EFA-A1EC-2181-CF90216A821D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183" creationId="{92B6C4EF-C913-703F-9EC4-46BC7B7EC1EE}"/>
          </ac:picMkLst>
        </pc:picChg>
        <pc:picChg chg="del">
          <ac:chgData name="Connor Blair" userId="5dffaaf1-4e99-4a9f-9d58-f6e2d8990ba3" providerId="ADAL" clId="{BC47891A-4B77-47DB-A266-9AB848673391}" dt="2023-12-20T17:14:36.842" v="285" actId="478"/>
          <ac:picMkLst>
            <pc:docMk/>
            <pc:sldMk cId="3032837757" sldId="286"/>
            <ac:picMk id="185" creationId="{760F6622-2B5E-CC17-F7CF-DF4AA6A3CA5C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187" creationId="{EBBE178A-4453-8D2D-B156-775D7B593721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189" creationId="{117EE4F7-A2C1-02FB-7F0C-91F092B26EC8}"/>
          </ac:picMkLst>
        </pc:picChg>
        <pc:picChg chg="del">
          <ac:chgData name="Connor Blair" userId="5dffaaf1-4e99-4a9f-9d58-f6e2d8990ba3" providerId="ADAL" clId="{BC47891A-4B77-47DB-A266-9AB848673391}" dt="2023-12-20T17:14:21.162" v="276" actId="478"/>
          <ac:picMkLst>
            <pc:docMk/>
            <pc:sldMk cId="3032837757" sldId="286"/>
            <ac:picMk id="191" creationId="{62E801D6-EAAB-0D4F-9A71-0EFBA2E43845}"/>
          </ac:picMkLst>
        </pc:picChg>
        <pc:cxnChg chg="mod">
          <ac:chgData name="Connor Blair" userId="5dffaaf1-4e99-4a9f-9d58-f6e2d8990ba3" providerId="ADAL" clId="{BC47891A-4B77-47DB-A266-9AB848673391}" dt="2023-12-20T18:18:26.079" v="840" actId="1076"/>
          <ac:cxnSpMkLst>
            <pc:docMk/>
            <pc:sldMk cId="3032837757" sldId="286"/>
            <ac:cxnSpMk id="8" creationId="{F3B21FE8-4FF3-9F99-4396-07B196432A31}"/>
          </ac:cxnSpMkLst>
        </pc:cxnChg>
        <pc:cxnChg chg="del">
          <ac:chgData name="Connor Blair" userId="5dffaaf1-4e99-4a9f-9d58-f6e2d8990ba3" providerId="ADAL" clId="{BC47891A-4B77-47DB-A266-9AB848673391}" dt="2023-12-20T17:16:46.043" v="712" actId="478"/>
          <ac:cxnSpMkLst>
            <pc:docMk/>
            <pc:sldMk cId="3032837757" sldId="286"/>
            <ac:cxnSpMk id="17" creationId="{54387A1C-543D-128E-1C55-375039F0B2E3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20" creationId="{FFB25728-CB01-FC16-482D-7C5FF248B1B5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26" creationId="{0AD45470-2092-03E8-2427-BC529B302B11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32" creationId="{6DCC090E-B25B-FDC5-1146-24B25BA417DD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35" creationId="{100BD001-6D3B-64B1-D0B6-AEC92DE94D52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36" creationId="{32214D44-5A71-AB5E-3C5A-B3D374E27305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37" creationId="{0F8EB760-08D3-95DB-9B2B-E75D2FF1170D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50" creationId="{44FCCA06-B0CD-4167-E000-EEED6265EFB9}"/>
          </ac:cxnSpMkLst>
        </pc:cxnChg>
        <pc:cxnChg chg="mod">
          <ac:chgData name="Connor Blair" userId="5dffaaf1-4e99-4a9f-9d58-f6e2d8990ba3" providerId="ADAL" clId="{BC47891A-4B77-47DB-A266-9AB848673391}" dt="2023-12-20T17:16:54.941" v="744" actId="1038"/>
          <ac:cxnSpMkLst>
            <pc:docMk/>
            <pc:sldMk cId="3032837757" sldId="286"/>
            <ac:cxnSpMk id="74" creationId="{ED5A0FB0-5658-7327-FBEF-5A3D8F1937F1}"/>
          </ac:cxnSpMkLst>
        </pc:cxnChg>
        <pc:cxnChg chg="del">
          <ac:chgData name="Connor Blair" userId="5dffaaf1-4e99-4a9f-9d58-f6e2d8990ba3" providerId="ADAL" clId="{BC47891A-4B77-47DB-A266-9AB848673391}" dt="2023-12-20T17:16:46.866" v="713" actId="478"/>
          <ac:cxnSpMkLst>
            <pc:docMk/>
            <pc:sldMk cId="3032837757" sldId="286"/>
            <ac:cxnSpMk id="75" creationId="{E9A9816A-C97E-E26C-2EC9-037AF6740877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76" creationId="{1FAD06EE-E4E5-92DB-D0CE-10A41BC3F767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88" creationId="{192E6926-BEF3-17AA-AAE4-FC61ECCF71F4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106" creationId="{1940F76E-4921-47C1-7FD4-BB9598B48FCD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112" creationId="{9D107513-63BC-7DA0-7D0D-D94210CFD7DF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120" creationId="{3F52AAF8-4BEE-C024-BEF7-BDD718CA16BB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128" creationId="{C3D8C064-F95B-E98C-0838-AF7B1F86185A}"/>
          </ac:cxnSpMkLst>
        </pc:cxnChg>
        <pc:cxnChg chg="del">
          <ac:chgData name="Connor Blair" userId="5dffaaf1-4e99-4a9f-9d58-f6e2d8990ba3" providerId="ADAL" clId="{BC47891A-4B77-47DB-A266-9AB848673391}" dt="2023-12-20T17:14:39.625" v="289" actId="478"/>
          <ac:cxnSpMkLst>
            <pc:docMk/>
            <pc:sldMk cId="3032837757" sldId="286"/>
            <ac:cxnSpMk id="133" creationId="{2CB8490D-233E-765A-4C8C-22E3A50FF9CD}"/>
          </ac:cxnSpMkLst>
        </pc:cxnChg>
        <pc:cxnChg chg="del">
          <ac:chgData name="Connor Blair" userId="5dffaaf1-4e99-4a9f-9d58-f6e2d8990ba3" providerId="ADAL" clId="{BC47891A-4B77-47DB-A266-9AB848673391}" dt="2023-12-20T17:14:39.625" v="289" actId="478"/>
          <ac:cxnSpMkLst>
            <pc:docMk/>
            <pc:sldMk cId="3032837757" sldId="286"/>
            <ac:cxnSpMk id="134" creationId="{21F80101-E4BB-7028-7A52-4DA2D2EA3BFB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148" creationId="{D2E11A1A-A1A2-C8F1-5CB5-B9B137850E2D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150" creationId="{3F91DBD0-8F87-B869-7D22-E3DD7F9C1964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169" creationId="{B055256F-D14D-D26B-B164-0B845FB52B63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170" creationId="{12FB7F58-BC48-31C3-A948-1B78543EFCC0}"/>
          </ac:cxnSpMkLst>
        </pc:cxnChg>
        <pc:cxnChg chg="del">
          <ac:chgData name="Connor Blair" userId="5dffaaf1-4e99-4a9f-9d58-f6e2d8990ba3" providerId="ADAL" clId="{BC47891A-4B77-47DB-A266-9AB848673391}" dt="2023-12-20T17:14:21.162" v="276" actId="478"/>
          <ac:cxnSpMkLst>
            <pc:docMk/>
            <pc:sldMk cId="3032837757" sldId="286"/>
            <ac:cxnSpMk id="171" creationId="{958D9A2C-A7FD-AF11-C330-0E825DC75899}"/>
          </ac:cxnSpMkLst>
        </pc:cxnChg>
      </pc:sldChg>
      <pc:sldChg chg="add del">
        <pc:chgData name="Connor Blair" userId="5dffaaf1-4e99-4a9f-9d58-f6e2d8990ba3" providerId="ADAL" clId="{BC47891A-4B77-47DB-A266-9AB848673391}" dt="2023-12-20T17:16:40.821" v="709"/>
        <pc:sldMkLst>
          <pc:docMk/>
          <pc:sldMk cId="4154016669" sldId="287"/>
        </pc:sldMkLst>
      </pc:sldChg>
      <pc:sldChg chg="addSp delSp modSp del mod">
        <pc:chgData name="Connor Blair" userId="5dffaaf1-4e99-4a9f-9d58-f6e2d8990ba3" providerId="ADAL" clId="{BC47891A-4B77-47DB-A266-9AB848673391}" dt="2023-12-19T12:06:31.787" v="274" actId="47"/>
        <pc:sldMkLst>
          <pc:docMk/>
          <pc:sldMk cId="3340225526" sldId="289"/>
        </pc:sldMkLst>
        <pc:spChg chg="mod">
          <ac:chgData name="Connor Blair" userId="5dffaaf1-4e99-4a9f-9d58-f6e2d8990ba3" providerId="ADAL" clId="{BC47891A-4B77-47DB-A266-9AB848673391}" dt="2023-12-13T14:41:04.291" v="64" actId="571"/>
          <ac:spMkLst>
            <pc:docMk/>
            <pc:sldMk cId="3340225526" sldId="289"/>
            <ac:spMk id="5" creationId="{FE737842-6095-B1B1-B8B9-14BDB344B093}"/>
          </ac:spMkLst>
        </pc:spChg>
        <pc:spChg chg="mod">
          <ac:chgData name="Connor Blair" userId="5dffaaf1-4e99-4a9f-9d58-f6e2d8990ba3" providerId="ADAL" clId="{BC47891A-4B77-47DB-A266-9AB848673391}" dt="2023-12-13T14:41:04.291" v="64" actId="571"/>
          <ac:spMkLst>
            <pc:docMk/>
            <pc:sldMk cId="3340225526" sldId="289"/>
            <ac:spMk id="36" creationId="{1F98F764-A348-33E9-3A6B-EDF52F7DF01F}"/>
          </ac:spMkLst>
        </pc:spChg>
        <pc:spChg chg="mod">
          <ac:chgData name="Connor Blair" userId="5dffaaf1-4e99-4a9f-9d58-f6e2d8990ba3" providerId="ADAL" clId="{BC47891A-4B77-47DB-A266-9AB848673391}" dt="2023-12-13T14:41:04.291" v="64" actId="571"/>
          <ac:spMkLst>
            <pc:docMk/>
            <pc:sldMk cId="3340225526" sldId="289"/>
            <ac:spMk id="37" creationId="{59DF5F95-F504-9270-88D5-61B834764E63}"/>
          </ac:spMkLst>
        </pc:spChg>
        <pc:spChg chg="mod">
          <ac:chgData name="Connor Blair" userId="5dffaaf1-4e99-4a9f-9d58-f6e2d8990ba3" providerId="ADAL" clId="{BC47891A-4B77-47DB-A266-9AB848673391}" dt="2023-12-13T14:41:04.291" v="64" actId="571"/>
          <ac:spMkLst>
            <pc:docMk/>
            <pc:sldMk cId="3340225526" sldId="289"/>
            <ac:spMk id="38" creationId="{E5F22F89-95FF-9FF6-34AB-AB79DDFDEAFC}"/>
          </ac:spMkLst>
        </pc:spChg>
        <pc:spChg chg="mod">
          <ac:chgData name="Connor Blair" userId="5dffaaf1-4e99-4a9f-9d58-f6e2d8990ba3" providerId="ADAL" clId="{BC47891A-4B77-47DB-A266-9AB848673391}" dt="2023-12-13T14:41:04.291" v="64" actId="571"/>
          <ac:spMkLst>
            <pc:docMk/>
            <pc:sldMk cId="3340225526" sldId="289"/>
            <ac:spMk id="39" creationId="{FFAFDD43-DE10-1C14-E8A9-45DD9D54FF6F}"/>
          </ac:spMkLst>
        </pc:spChg>
        <pc:spChg chg="mod">
          <ac:chgData name="Connor Blair" userId="5dffaaf1-4e99-4a9f-9d58-f6e2d8990ba3" providerId="ADAL" clId="{BC47891A-4B77-47DB-A266-9AB848673391}" dt="2023-12-13T14:41:04.291" v="64" actId="571"/>
          <ac:spMkLst>
            <pc:docMk/>
            <pc:sldMk cId="3340225526" sldId="289"/>
            <ac:spMk id="40" creationId="{64AC0820-8335-6627-1211-9216AD059A39}"/>
          </ac:spMkLst>
        </pc:spChg>
        <pc:spChg chg="mod">
          <ac:chgData name="Connor Blair" userId="5dffaaf1-4e99-4a9f-9d58-f6e2d8990ba3" providerId="ADAL" clId="{BC47891A-4B77-47DB-A266-9AB848673391}" dt="2023-12-13T14:41:04.291" v="64" actId="571"/>
          <ac:spMkLst>
            <pc:docMk/>
            <pc:sldMk cId="3340225526" sldId="289"/>
            <ac:spMk id="41" creationId="{AA83B43D-AD1D-9771-8B16-8B17824C3727}"/>
          </ac:spMkLst>
        </pc:spChg>
        <pc:spChg chg="del">
          <ac:chgData name="Connor Blair" userId="5dffaaf1-4e99-4a9f-9d58-f6e2d8990ba3" providerId="ADAL" clId="{BC47891A-4B77-47DB-A266-9AB848673391}" dt="2023-12-13T14:40:33.432" v="43" actId="478"/>
          <ac:spMkLst>
            <pc:docMk/>
            <pc:sldMk cId="3340225526" sldId="289"/>
            <ac:spMk id="42" creationId="{AB668642-ED25-E66E-9D04-FD3B568F7E8E}"/>
          </ac:spMkLst>
        </pc:spChg>
        <pc:spChg chg="del">
          <ac:chgData name="Connor Blair" userId="5dffaaf1-4e99-4a9f-9d58-f6e2d8990ba3" providerId="ADAL" clId="{BC47891A-4B77-47DB-A266-9AB848673391}" dt="2023-12-13T14:40:32.109" v="42" actId="478"/>
          <ac:spMkLst>
            <pc:docMk/>
            <pc:sldMk cId="3340225526" sldId="289"/>
            <ac:spMk id="43" creationId="{25749AB8-E0EF-8E0D-5FD1-32721C70E583}"/>
          </ac:spMkLst>
        </pc:spChg>
        <pc:spChg chg="del">
          <ac:chgData name="Connor Blair" userId="5dffaaf1-4e99-4a9f-9d58-f6e2d8990ba3" providerId="ADAL" clId="{BC47891A-4B77-47DB-A266-9AB848673391}" dt="2023-12-13T14:40:32.109" v="42" actId="478"/>
          <ac:spMkLst>
            <pc:docMk/>
            <pc:sldMk cId="3340225526" sldId="289"/>
            <ac:spMk id="44" creationId="{2688AF0B-9433-6F06-7464-1978E1F30889}"/>
          </ac:spMkLst>
        </pc:spChg>
        <pc:spChg chg="del">
          <ac:chgData name="Connor Blair" userId="5dffaaf1-4e99-4a9f-9d58-f6e2d8990ba3" providerId="ADAL" clId="{BC47891A-4B77-47DB-A266-9AB848673391}" dt="2023-12-13T14:40:32.109" v="42" actId="478"/>
          <ac:spMkLst>
            <pc:docMk/>
            <pc:sldMk cId="3340225526" sldId="289"/>
            <ac:spMk id="45" creationId="{F0C5A6CF-DBD2-C221-60EA-C52D5CB3217A}"/>
          </ac:spMkLst>
        </pc:spChg>
        <pc:spChg chg="del">
          <ac:chgData name="Connor Blair" userId="5dffaaf1-4e99-4a9f-9d58-f6e2d8990ba3" providerId="ADAL" clId="{BC47891A-4B77-47DB-A266-9AB848673391}" dt="2023-12-13T14:40:32.109" v="42" actId="478"/>
          <ac:spMkLst>
            <pc:docMk/>
            <pc:sldMk cId="3340225526" sldId="289"/>
            <ac:spMk id="46" creationId="{1D878B7F-1C0D-A8D2-FEED-F6469ACEE742}"/>
          </ac:spMkLst>
        </pc:spChg>
        <pc:spChg chg="mod">
          <ac:chgData name="Connor Blair" userId="5dffaaf1-4e99-4a9f-9d58-f6e2d8990ba3" providerId="ADAL" clId="{BC47891A-4B77-47DB-A266-9AB848673391}" dt="2023-12-13T14:41:23.675" v="67" actId="1076"/>
          <ac:spMkLst>
            <pc:docMk/>
            <pc:sldMk cId="3340225526" sldId="289"/>
            <ac:spMk id="47" creationId="{1DE44399-B5FD-86CE-6859-D8AA3E2E8992}"/>
          </ac:spMkLst>
        </pc:spChg>
        <pc:spChg chg="mod">
          <ac:chgData name="Connor Blair" userId="5dffaaf1-4e99-4a9f-9d58-f6e2d8990ba3" providerId="ADAL" clId="{BC47891A-4B77-47DB-A266-9AB848673391}" dt="2023-12-13T14:41:23.675" v="67" actId="1076"/>
          <ac:spMkLst>
            <pc:docMk/>
            <pc:sldMk cId="3340225526" sldId="289"/>
            <ac:spMk id="48" creationId="{6D616C94-F4F9-6785-F4CE-DFE08D4499A5}"/>
          </ac:spMkLst>
        </pc:spChg>
        <pc:spChg chg="mod">
          <ac:chgData name="Connor Blair" userId="5dffaaf1-4e99-4a9f-9d58-f6e2d8990ba3" providerId="ADAL" clId="{BC47891A-4B77-47DB-A266-9AB848673391}" dt="2023-12-13T14:41:23.675" v="67" actId="1076"/>
          <ac:spMkLst>
            <pc:docMk/>
            <pc:sldMk cId="3340225526" sldId="289"/>
            <ac:spMk id="49" creationId="{F97D2DF0-CE6A-8098-7483-EACA890A4D34}"/>
          </ac:spMkLst>
        </pc:spChg>
        <pc:spChg chg="mod">
          <ac:chgData name="Connor Blair" userId="5dffaaf1-4e99-4a9f-9d58-f6e2d8990ba3" providerId="ADAL" clId="{BC47891A-4B77-47DB-A266-9AB848673391}" dt="2023-12-13T14:41:23.675" v="67" actId="1076"/>
          <ac:spMkLst>
            <pc:docMk/>
            <pc:sldMk cId="3340225526" sldId="289"/>
            <ac:spMk id="50" creationId="{C8B902BC-0E82-C292-5C31-39988261774B}"/>
          </ac:spMkLst>
        </pc:spChg>
        <pc:spChg chg="del mod">
          <ac:chgData name="Connor Blair" userId="5dffaaf1-4e99-4a9f-9d58-f6e2d8990ba3" providerId="ADAL" clId="{BC47891A-4B77-47DB-A266-9AB848673391}" dt="2023-12-13T14:41:08.186" v="65" actId="478"/>
          <ac:spMkLst>
            <pc:docMk/>
            <pc:sldMk cId="3340225526" sldId="289"/>
            <ac:spMk id="51" creationId="{B57F9438-F9F9-AFB7-58FD-E1FBD3284ED7}"/>
          </ac:spMkLst>
        </pc:spChg>
        <pc:spChg chg="del mod">
          <ac:chgData name="Connor Blair" userId="5dffaaf1-4e99-4a9f-9d58-f6e2d8990ba3" providerId="ADAL" clId="{BC47891A-4B77-47DB-A266-9AB848673391}" dt="2023-12-13T14:41:08.186" v="65" actId="478"/>
          <ac:spMkLst>
            <pc:docMk/>
            <pc:sldMk cId="3340225526" sldId="289"/>
            <ac:spMk id="52" creationId="{0D71F29E-9A49-F7DE-C3BE-112BF196A596}"/>
          </ac:spMkLst>
        </pc:spChg>
        <pc:spChg chg="del mod">
          <ac:chgData name="Connor Blair" userId="5dffaaf1-4e99-4a9f-9d58-f6e2d8990ba3" providerId="ADAL" clId="{BC47891A-4B77-47DB-A266-9AB848673391}" dt="2023-12-13T14:41:08.186" v="65" actId="478"/>
          <ac:spMkLst>
            <pc:docMk/>
            <pc:sldMk cId="3340225526" sldId="289"/>
            <ac:spMk id="53" creationId="{55BD472E-C763-890F-85B7-B6E20737ED8B}"/>
          </ac:spMkLst>
        </pc:spChg>
        <pc:spChg chg="del mod">
          <ac:chgData name="Connor Blair" userId="5dffaaf1-4e99-4a9f-9d58-f6e2d8990ba3" providerId="ADAL" clId="{BC47891A-4B77-47DB-A266-9AB848673391}" dt="2023-12-13T14:41:08.186" v="65" actId="478"/>
          <ac:spMkLst>
            <pc:docMk/>
            <pc:sldMk cId="3340225526" sldId="289"/>
            <ac:spMk id="54" creationId="{07CF46BB-1CAA-8942-5AB7-63DFEC0C59F7}"/>
          </ac:spMkLst>
        </pc:spChg>
        <pc:spChg chg="del mod">
          <ac:chgData name="Connor Blair" userId="5dffaaf1-4e99-4a9f-9d58-f6e2d8990ba3" providerId="ADAL" clId="{BC47891A-4B77-47DB-A266-9AB848673391}" dt="2023-12-13T14:41:08.186" v="65" actId="478"/>
          <ac:spMkLst>
            <pc:docMk/>
            <pc:sldMk cId="3340225526" sldId="289"/>
            <ac:spMk id="55" creationId="{A7E3DD9C-8AAA-A4D6-239B-75EF8013885C}"/>
          </ac:spMkLst>
        </pc:spChg>
        <pc:spChg chg="mod">
          <ac:chgData name="Connor Blair" userId="5dffaaf1-4e99-4a9f-9d58-f6e2d8990ba3" providerId="ADAL" clId="{BC47891A-4B77-47DB-A266-9AB848673391}" dt="2023-12-13T14:41:04.291" v="64" actId="571"/>
          <ac:spMkLst>
            <pc:docMk/>
            <pc:sldMk cId="3340225526" sldId="289"/>
            <ac:spMk id="76" creationId="{8FD35275-FB68-D605-D04B-9D9544FB5FDE}"/>
          </ac:spMkLst>
        </pc:spChg>
        <pc:spChg chg="add mod">
          <ac:chgData name="Connor Blair" userId="5dffaaf1-4e99-4a9f-9d58-f6e2d8990ba3" providerId="ADAL" clId="{BC47891A-4B77-47DB-A266-9AB848673391}" dt="2023-12-13T14:41:04.291" v="64" actId="571"/>
          <ac:spMkLst>
            <pc:docMk/>
            <pc:sldMk cId="3340225526" sldId="289"/>
            <ac:spMk id="268" creationId="{2E0A6528-CAF7-7D60-9253-28123F16560D}"/>
          </ac:spMkLst>
        </pc:spChg>
        <pc:spChg chg="add mod">
          <ac:chgData name="Connor Blair" userId="5dffaaf1-4e99-4a9f-9d58-f6e2d8990ba3" providerId="ADAL" clId="{BC47891A-4B77-47DB-A266-9AB848673391}" dt="2023-12-13T14:45:56.737" v="262" actId="14100"/>
          <ac:spMkLst>
            <pc:docMk/>
            <pc:sldMk cId="3340225526" sldId="289"/>
            <ac:spMk id="271" creationId="{F3AAEF7B-D707-69F5-FA91-FAD7CCE63F7C}"/>
          </ac:spMkLst>
        </pc:spChg>
        <pc:spChg chg="mod">
          <ac:chgData name="Connor Blair" userId="5dffaaf1-4e99-4a9f-9d58-f6e2d8990ba3" providerId="ADAL" clId="{BC47891A-4B77-47DB-A266-9AB848673391}" dt="2023-12-13T14:45:43.472" v="254" actId="14100"/>
          <ac:spMkLst>
            <pc:docMk/>
            <pc:sldMk cId="3340225526" sldId="289"/>
            <ac:spMk id="277" creationId="{7112E497-64D9-344B-7B71-E1E08424ABFE}"/>
          </ac:spMkLst>
        </pc:spChg>
        <pc:spChg chg="mod">
          <ac:chgData name="Connor Blair" userId="5dffaaf1-4e99-4a9f-9d58-f6e2d8990ba3" providerId="ADAL" clId="{BC47891A-4B77-47DB-A266-9AB848673391}" dt="2023-12-13T14:45:53.258" v="260" actId="14100"/>
          <ac:spMkLst>
            <pc:docMk/>
            <pc:sldMk cId="3340225526" sldId="289"/>
            <ac:spMk id="281" creationId="{A3C39B05-A116-14F3-B104-DC7DB4AFA776}"/>
          </ac:spMkLst>
        </pc:spChg>
        <pc:spChg chg="mod">
          <ac:chgData name="Connor Blair" userId="5dffaaf1-4e99-4a9f-9d58-f6e2d8990ba3" providerId="ADAL" clId="{BC47891A-4B77-47DB-A266-9AB848673391}" dt="2023-12-13T14:45:49.181" v="258" actId="14100"/>
          <ac:spMkLst>
            <pc:docMk/>
            <pc:sldMk cId="3340225526" sldId="289"/>
            <ac:spMk id="285" creationId="{C94C6FFA-D907-A594-62EE-0070CD84BBF4}"/>
          </ac:spMkLst>
        </pc:spChg>
        <pc:grpChg chg="mod">
          <ac:chgData name="Connor Blair" userId="5dffaaf1-4e99-4a9f-9d58-f6e2d8990ba3" providerId="ADAL" clId="{BC47891A-4B77-47DB-A266-9AB848673391}" dt="2023-12-13T14:41:13.387" v="66" actId="164"/>
          <ac:grpSpMkLst>
            <pc:docMk/>
            <pc:sldMk cId="3340225526" sldId="289"/>
            <ac:grpSpMk id="7" creationId="{711728F3-02CB-A58F-FC74-7D3F6679EBE5}"/>
          </ac:grpSpMkLst>
        </pc:grpChg>
        <pc:grpChg chg="mod">
          <ac:chgData name="Connor Blair" userId="5dffaaf1-4e99-4a9f-9d58-f6e2d8990ba3" providerId="ADAL" clId="{BC47891A-4B77-47DB-A266-9AB848673391}" dt="2023-12-19T12:06:06.825" v="273" actId="1076"/>
          <ac:grpSpMkLst>
            <pc:docMk/>
            <pc:sldMk cId="3340225526" sldId="289"/>
            <ac:grpSpMk id="19" creationId="{656EF410-663A-B341-FE3F-5333BAD5B569}"/>
          </ac:grpSpMkLst>
        </pc:grpChg>
        <pc:grpChg chg="add mod">
          <ac:chgData name="Connor Blair" userId="5dffaaf1-4e99-4a9f-9d58-f6e2d8990ba3" providerId="ADAL" clId="{BC47891A-4B77-47DB-A266-9AB848673391}" dt="2023-12-13T14:42:03.560" v="74" actId="164"/>
          <ac:grpSpMkLst>
            <pc:docMk/>
            <pc:sldMk cId="3340225526" sldId="289"/>
            <ac:grpSpMk id="269" creationId="{4C829CAD-36E6-EB3E-35C6-EF981FEC8C2C}"/>
          </ac:grpSpMkLst>
        </pc:grpChg>
        <pc:grpChg chg="add mod">
          <ac:chgData name="Connor Blair" userId="5dffaaf1-4e99-4a9f-9d58-f6e2d8990ba3" providerId="ADAL" clId="{BC47891A-4B77-47DB-A266-9AB848673391}" dt="2023-12-13T14:46:02.235" v="266" actId="1035"/>
          <ac:grpSpMkLst>
            <pc:docMk/>
            <pc:sldMk cId="3340225526" sldId="289"/>
            <ac:grpSpMk id="270" creationId="{5E787222-94D5-FC84-C106-9BD9DF36EC91}"/>
          </ac:grpSpMkLst>
        </pc:grpChg>
        <pc:grpChg chg="add mod">
          <ac:chgData name="Connor Blair" userId="5dffaaf1-4e99-4a9f-9d58-f6e2d8990ba3" providerId="ADAL" clId="{BC47891A-4B77-47DB-A266-9AB848673391}" dt="2023-12-13T14:44:42.456" v="196" actId="1038"/>
          <ac:grpSpMkLst>
            <pc:docMk/>
            <pc:sldMk cId="3340225526" sldId="289"/>
            <ac:grpSpMk id="275" creationId="{F3F042A9-D9D9-9BD5-2563-1C4E6B8EBC1D}"/>
          </ac:grpSpMkLst>
        </pc:grpChg>
        <pc:grpChg chg="add mod">
          <ac:chgData name="Connor Blair" userId="5dffaaf1-4e99-4a9f-9d58-f6e2d8990ba3" providerId="ADAL" clId="{BC47891A-4B77-47DB-A266-9AB848673391}" dt="2023-12-13T14:44:54.428" v="224" actId="1036"/>
          <ac:grpSpMkLst>
            <pc:docMk/>
            <pc:sldMk cId="3340225526" sldId="289"/>
            <ac:grpSpMk id="276" creationId="{36621BB5-7F04-49AB-74D7-D1289985F943}"/>
          </ac:grpSpMkLst>
        </pc:grpChg>
        <pc:grpChg chg="add mod">
          <ac:chgData name="Connor Blair" userId="5dffaaf1-4e99-4a9f-9d58-f6e2d8990ba3" providerId="ADAL" clId="{BC47891A-4B77-47DB-A266-9AB848673391}" dt="2023-12-13T14:45:22.809" v="252" actId="1038"/>
          <ac:grpSpMkLst>
            <pc:docMk/>
            <pc:sldMk cId="3340225526" sldId="289"/>
            <ac:grpSpMk id="280" creationId="{7E54C54B-1D07-AE21-CDAE-5C8D28F898C6}"/>
          </ac:grpSpMkLst>
        </pc:grpChg>
        <pc:grpChg chg="add mod">
          <ac:chgData name="Connor Blair" userId="5dffaaf1-4e99-4a9f-9d58-f6e2d8990ba3" providerId="ADAL" clId="{BC47891A-4B77-47DB-A266-9AB848673391}" dt="2023-12-13T14:45:46.005" v="256" actId="14100"/>
          <ac:grpSpMkLst>
            <pc:docMk/>
            <pc:sldMk cId="3340225526" sldId="289"/>
            <ac:grpSpMk id="284" creationId="{6FC9606F-E811-79CB-625F-F5A2DBB8F5AB}"/>
          </ac:grpSpMkLst>
        </pc:grpChg>
        <pc:picChg chg="del mod">
          <ac:chgData name="Connor Blair" userId="5dffaaf1-4e99-4a9f-9d58-f6e2d8990ba3" providerId="ADAL" clId="{BC47891A-4B77-47DB-A266-9AB848673391}" dt="2023-12-13T14:39:57.384" v="26" actId="478"/>
          <ac:picMkLst>
            <pc:docMk/>
            <pc:sldMk cId="3340225526" sldId="289"/>
            <ac:picMk id="8" creationId="{88AACFA1-7B8D-0A9C-6AA1-3A2EAFDC81D1}"/>
          </ac:picMkLst>
        </pc:picChg>
        <pc:picChg chg="mod">
          <ac:chgData name="Connor Blair" userId="5dffaaf1-4e99-4a9f-9d58-f6e2d8990ba3" providerId="ADAL" clId="{BC47891A-4B77-47DB-A266-9AB848673391}" dt="2023-12-13T14:34:51.572" v="3" actId="2085"/>
          <ac:picMkLst>
            <pc:docMk/>
            <pc:sldMk cId="3340225526" sldId="289"/>
            <ac:picMk id="9" creationId="{68F0EE35-AD37-CB86-8D34-9C2F9BE5D488}"/>
          </ac:picMkLst>
        </pc:picChg>
        <pc:picChg chg="del mod">
          <ac:chgData name="Connor Blair" userId="5dffaaf1-4e99-4a9f-9d58-f6e2d8990ba3" providerId="ADAL" clId="{BC47891A-4B77-47DB-A266-9AB848673391}" dt="2023-12-13T14:40:47.016" v="52" actId="478"/>
          <ac:picMkLst>
            <pc:docMk/>
            <pc:sldMk cId="3340225526" sldId="289"/>
            <ac:picMk id="11" creationId="{40070352-538F-FCDF-9C23-94FFA03BAF96}"/>
          </ac:picMkLst>
        </pc:picChg>
        <pc:picChg chg="mod">
          <ac:chgData name="Connor Blair" userId="5dffaaf1-4e99-4a9f-9d58-f6e2d8990ba3" providerId="ADAL" clId="{BC47891A-4B77-47DB-A266-9AB848673391}" dt="2023-12-13T14:34:51.572" v="3" actId="2085"/>
          <ac:picMkLst>
            <pc:docMk/>
            <pc:sldMk cId="3340225526" sldId="289"/>
            <ac:picMk id="12" creationId="{D2844AAA-088B-2CAB-FB90-7F855A0558A6}"/>
          </ac:picMkLst>
        </pc:picChg>
        <pc:picChg chg="mod">
          <ac:chgData name="Connor Blair" userId="5dffaaf1-4e99-4a9f-9d58-f6e2d8990ba3" providerId="ADAL" clId="{BC47891A-4B77-47DB-A266-9AB848673391}" dt="2023-12-13T14:35:06.896" v="7" actId="2085"/>
          <ac:picMkLst>
            <pc:docMk/>
            <pc:sldMk cId="3340225526" sldId="289"/>
            <ac:picMk id="80" creationId="{1980BCC8-A2C4-4682-FB32-417418AC2C52}"/>
          </ac:picMkLst>
        </pc:picChg>
        <pc:picChg chg="mod">
          <ac:chgData name="Connor Blair" userId="5dffaaf1-4e99-4a9f-9d58-f6e2d8990ba3" providerId="ADAL" clId="{BC47891A-4B77-47DB-A266-9AB848673391}" dt="2023-12-13T14:35:04.112" v="6" actId="2085"/>
          <ac:picMkLst>
            <pc:docMk/>
            <pc:sldMk cId="3340225526" sldId="289"/>
            <ac:picMk id="81" creationId="{FB2049CA-E3D4-2DCC-3BC2-6250A334E3C1}"/>
          </ac:picMkLst>
        </pc:picChg>
        <pc:picChg chg="mod">
          <ac:chgData name="Connor Blair" userId="5dffaaf1-4e99-4a9f-9d58-f6e2d8990ba3" providerId="ADAL" clId="{BC47891A-4B77-47DB-A266-9AB848673391}" dt="2023-12-13T14:35:01.348" v="5" actId="2085"/>
          <ac:picMkLst>
            <pc:docMk/>
            <pc:sldMk cId="3340225526" sldId="289"/>
            <ac:picMk id="82" creationId="{6E12D268-8707-EC4B-7CF4-A254E9068F8E}"/>
          </ac:picMkLst>
        </pc:picChg>
        <pc:picChg chg="mod">
          <ac:chgData name="Connor Blair" userId="5dffaaf1-4e99-4a9f-9d58-f6e2d8990ba3" providerId="ADAL" clId="{BC47891A-4B77-47DB-A266-9AB848673391}" dt="2023-12-13T14:35:06.896" v="7" actId="2085"/>
          <ac:picMkLst>
            <pc:docMk/>
            <pc:sldMk cId="3340225526" sldId="289"/>
            <ac:picMk id="83" creationId="{E08173D8-7A1F-62FB-D3E8-44A7806E5649}"/>
          </ac:picMkLst>
        </pc:picChg>
        <pc:picChg chg="mod">
          <ac:chgData name="Connor Blair" userId="5dffaaf1-4e99-4a9f-9d58-f6e2d8990ba3" providerId="ADAL" clId="{BC47891A-4B77-47DB-A266-9AB848673391}" dt="2023-12-13T14:35:04.112" v="6" actId="2085"/>
          <ac:picMkLst>
            <pc:docMk/>
            <pc:sldMk cId="3340225526" sldId="289"/>
            <ac:picMk id="84" creationId="{7B80BB56-D248-1330-1CE0-F7ABE2E6DD92}"/>
          </ac:picMkLst>
        </pc:picChg>
        <pc:picChg chg="mod">
          <ac:chgData name="Connor Blair" userId="5dffaaf1-4e99-4a9f-9d58-f6e2d8990ba3" providerId="ADAL" clId="{BC47891A-4B77-47DB-A266-9AB848673391}" dt="2023-12-13T14:35:01.348" v="5" actId="2085"/>
          <ac:picMkLst>
            <pc:docMk/>
            <pc:sldMk cId="3340225526" sldId="289"/>
            <ac:picMk id="85" creationId="{44B68937-F2CF-1868-1E03-E41D3A9044F2}"/>
          </ac:picMkLst>
        </pc:picChg>
        <pc:picChg chg="add del mod">
          <ac:chgData name="Connor Blair" userId="5dffaaf1-4e99-4a9f-9d58-f6e2d8990ba3" providerId="ADAL" clId="{BC47891A-4B77-47DB-A266-9AB848673391}" dt="2023-12-13T14:38:41.766" v="15" actId="478"/>
          <ac:picMkLst>
            <pc:docMk/>
            <pc:sldMk cId="3340225526" sldId="289"/>
            <ac:picMk id="165" creationId="{E57F3BD7-2632-C8AB-46AA-DF610E8816A8}"/>
          </ac:picMkLst>
        </pc:picChg>
        <pc:picChg chg="add del mod">
          <ac:chgData name="Connor Blair" userId="5dffaaf1-4e99-4a9f-9d58-f6e2d8990ba3" providerId="ADAL" clId="{BC47891A-4B77-47DB-A266-9AB848673391}" dt="2023-12-13T14:38:41.766" v="15" actId="478"/>
          <ac:picMkLst>
            <pc:docMk/>
            <pc:sldMk cId="3340225526" sldId="289"/>
            <ac:picMk id="185" creationId="{921861D6-7012-9A29-BE62-7D3AA5483EE4}"/>
          </ac:picMkLst>
        </pc:picChg>
        <pc:picChg chg="mod">
          <ac:chgData name="Connor Blair" userId="5dffaaf1-4e99-4a9f-9d58-f6e2d8990ba3" providerId="ADAL" clId="{BC47891A-4B77-47DB-A266-9AB848673391}" dt="2023-12-13T14:34:54.385" v="4" actId="2085"/>
          <ac:picMkLst>
            <pc:docMk/>
            <pc:sldMk cId="3340225526" sldId="289"/>
            <ac:picMk id="189" creationId="{4CAF047A-2003-6483-CDF0-3C13960186F4}"/>
          </ac:picMkLst>
        </pc:picChg>
        <pc:picChg chg="mod">
          <ac:chgData name="Connor Blair" userId="5dffaaf1-4e99-4a9f-9d58-f6e2d8990ba3" providerId="ADAL" clId="{BC47891A-4B77-47DB-A266-9AB848673391}" dt="2023-12-13T14:34:54.385" v="4" actId="2085"/>
          <ac:picMkLst>
            <pc:docMk/>
            <pc:sldMk cId="3340225526" sldId="289"/>
            <ac:picMk id="193" creationId="{FA2618FD-2AFB-9C2C-0832-735880D51F98}"/>
          </ac:picMkLst>
        </pc:picChg>
        <pc:picChg chg="mod">
          <ac:chgData name="Connor Blair" userId="5dffaaf1-4e99-4a9f-9d58-f6e2d8990ba3" providerId="ADAL" clId="{BC47891A-4B77-47DB-A266-9AB848673391}" dt="2023-12-13T14:34:54.385" v="4" actId="2085"/>
          <ac:picMkLst>
            <pc:docMk/>
            <pc:sldMk cId="3340225526" sldId="289"/>
            <ac:picMk id="195" creationId="{8A21DAD4-519A-90B4-AA5B-49E586FBC2F4}"/>
          </ac:picMkLst>
        </pc:picChg>
        <pc:picChg chg="add mod">
          <ac:chgData name="Connor Blair" userId="5dffaaf1-4e99-4a9f-9d58-f6e2d8990ba3" providerId="ADAL" clId="{BC47891A-4B77-47DB-A266-9AB848673391}" dt="2023-12-13T14:42:09.994" v="76" actId="692"/>
          <ac:picMkLst>
            <pc:docMk/>
            <pc:sldMk cId="3340225526" sldId="289"/>
            <ac:picMk id="212" creationId="{CBE4E2FA-5C1F-E0EA-2161-EFCAA37CF711}"/>
          </ac:picMkLst>
        </pc:picChg>
        <pc:picChg chg="add mod">
          <ac:chgData name="Connor Blair" userId="5dffaaf1-4e99-4a9f-9d58-f6e2d8990ba3" providerId="ADAL" clId="{BC47891A-4B77-47DB-A266-9AB848673391}" dt="2023-12-13T14:42:09.994" v="76" actId="692"/>
          <ac:picMkLst>
            <pc:docMk/>
            <pc:sldMk cId="3340225526" sldId="289"/>
            <ac:picMk id="247" creationId="{A74B2368-CB85-A0E7-E451-E75FA5E8BB96}"/>
          </ac:picMkLst>
        </pc:picChg>
        <pc:picChg chg="add mod">
          <ac:chgData name="Connor Blair" userId="5dffaaf1-4e99-4a9f-9d58-f6e2d8990ba3" providerId="ADAL" clId="{BC47891A-4B77-47DB-A266-9AB848673391}" dt="2023-12-13T14:42:09.994" v="76" actId="692"/>
          <ac:picMkLst>
            <pc:docMk/>
            <pc:sldMk cId="3340225526" sldId="289"/>
            <ac:picMk id="250" creationId="{26BDBF5C-5964-D334-7617-7753E57CE404}"/>
          </ac:picMkLst>
        </pc:picChg>
        <pc:picChg chg="add mod">
          <ac:chgData name="Connor Blair" userId="5dffaaf1-4e99-4a9f-9d58-f6e2d8990ba3" providerId="ADAL" clId="{BC47891A-4B77-47DB-A266-9AB848673391}" dt="2023-12-13T14:46:23.635" v="271" actId="1035"/>
          <ac:picMkLst>
            <pc:docMk/>
            <pc:sldMk cId="3340225526" sldId="289"/>
            <ac:picMk id="267" creationId="{3690C33A-6E69-5697-D512-C81227FAC056}"/>
          </ac:picMkLst>
        </pc:picChg>
        <pc:cxnChg chg="mod">
          <ac:chgData name="Connor Blair" userId="5dffaaf1-4e99-4a9f-9d58-f6e2d8990ba3" providerId="ADAL" clId="{BC47891A-4B77-47DB-A266-9AB848673391}" dt="2023-12-13T14:41:04.291" v="64" actId="571"/>
          <ac:cxnSpMkLst>
            <pc:docMk/>
            <pc:sldMk cId="3340225526" sldId="289"/>
            <ac:cxnSpMk id="77" creationId="{6CE9937A-BABA-50EE-4556-F7789B67A096}"/>
          </ac:cxnSpMkLst>
        </pc:cxnChg>
        <pc:cxnChg chg="add mod">
          <ac:chgData name="Connor Blair" userId="5dffaaf1-4e99-4a9f-9d58-f6e2d8990ba3" providerId="ADAL" clId="{BC47891A-4B77-47DB-A266-9AB848673391}" dt="2023-12-13T14:43:32.665" v="157" actId="164"/>
          <ac:cxnSpMkLst>
            <pc:docMk/>
            <pc:sldMk cId="3340225526" sldId="289"/>
            <ac:cxnSpMk id="273" creationId="{6DD1A977-F7CC-8505-FE91-5C8347B0CD7B}"/>
          </ac:cxnSpMkLst>
        </pc:cxnChg>
        <pc:cxnChg chg="add mod">
          <ac:chgData name="Connor Blair" userId="5dffaaf1-4e99-4a9f-9d58-f6e2d8990ba3" providerId="ADAL" clId="{BC47891A-4B77-47DB-A266-9AB848673391}" dt="2023-12-13T14:44:26.897" v="186" actId="1036"/>
          <ac:cxnSpMkLst>
            <pc:docMk/>
            <pc:sldMk cId="3340225526" sldId="289"/>
            <ac:cxnSpMk id="274" creationId="{27DFA906-A960-7E61-4226-0FAA28230137}"/>
          </ac:cxnSpMkLst>
        </pc:cxnChg>
        <pc:cxnChg chg="mod">
          <ac:chgData name="Connor Blair" userId="5dffaaf1-4e99-4a9f-9d58-f6e2d8990ba3" providerId="ADAL" clId="{BC47891A-4B77-47DB-A266-9AB848673391}" dt="2023-12-13T14:44:45.789" v="197"/>
          <ac:cxnSpMkLst>
            <pc:docMk/>
            <pc:sldMk cId="3340225526" sldId="289"/>
            <ac:cxnSpMk id="278" creationId="{4B37CE82-1860-5437-212E-2604587B14FE}"/>
          </ac:cxnSpMkLst>
        </pc:cxnChg>
        <pc:cxnChg chg="mod">
          <ac:chgData name="Connor Blair" userId="5dffaaf1-4e99-4a9f-9d58-f6e2d8990ba3" providerId="ADAL" clId="{BC47891A-4B77-47DB-A266-9AB848673391}" dt="2023-12-13T14:44:45.789" v="197"/>
          <ac:cxnSpMkLst>
            <pc:docMk/>
            <pc:sldMk cId="3340225526" sldId="289"/>
            <ac:cxnSpMk id="279" creationId="{8A299E5E-732F-7328-2D49-0BBA44D3E26E}"/>
          </ac:cxnSpMkLst>
        </pc:cxnChg>
        <pc:cxnChg chg="mod">
          <ac:chgData name="Connor Blair" userId="5dffaaf1-4e99-4a9f-9d58-f6e2d8990ba3" providerId="ADAL" clId="{BC47891A-4B77-47DB-A266-9AB848673391}" dt="2023-12-13T14:44:58.280" v="225"/>
          <ac:cxnSpMkLst>
            <pc:docMk/>
            <pc:sldMk cId="3340225526" sldId="289"/>
            <ac:cxnSpMk id="282" creationId="{15F5A2D2-EA7F-E1CC-8040-CB7EA6291A49}"/>
          </ac:cxnSpMkLst>
        </pc:cxnChg>
        <pc:cxnChg chg="mod">
          <ac:chgData name="Connor Blair" userId="5dffaaf1-4e99-4a9f-9d58-f6e2d8990ba3" providerId="ADAL" clId="{BC47891A-4B77-47DB-A266-9AB848673391}" dt="2023-12-13T14:44:58.280" v="225"/>
          <ac:cxnSpMkLst>
            <pc:docMk/>
            <pc:sldMk cId="3340225526" sldId="289"/>
            <ac:cxnSpMk id="283" creationId="{8CDBF767-EC07-F6A8-BF15-AB9695E621DA}"/>
          </ac:cxnSpMkLst>
        </pc:cxnChg>
        <pc:cxnChg chg="mod">
          <ac:chgData name="Connor Blair" userId="5dffaaf1-4e99-4a9f-9d58-f6e2d8990ba3" providerId="ADAL" clId="{BC47891A-4B77-47DB-A266-9AB848673391}" dt="2023-12-13T14:46:01.072" v="264" actId="1038"/>
          <ac:cxnSpMkLst>
            <pc:docMk/>
            <pc:sldMk cId="3340225526" sldId="289"/>
            <ac:cxnSpMk id="286" creationId="{8FD09769-4C93-FAD5-22F6-A57604B57234}"/>
          </ac:cxnSpMkLst>
        </pc:cxnChg>
        <pc:cxnChg chg="mod">
          <ac:chgData name="Connor Blair" userId="5dffaaf1-4e99-4a9f-9d58-f6e2d8990ba3" providerId="ADAL" clId="{BC47891A-4B77-47DB-A266-9AB848673391}" dt="2023-12-13T14:44:58.280" v="225"/>
          <ac:cxnSpMkLst>
            <pc:docMk/>
            <pc:sldMk cId="3340225526" sldId="289"/>
            <ac:cxnSpMk id="287" creationId="{BF74C1BC-1570-EF3E-3EC6-D81F22EBACA8}"/>
          </ac:cxnSpMkLst>
        </pc:cxnChg>
      </pc:sldChg>
    </pc:docChg>
  </pc:docChgLst>
  <pc:docChgLst>
    <pc:chgData name="Connor Blair" userId="5dffaaf1-4e99-4a9f-9d58-f6e2d8990ba3" providerId="ADAL" clId="{250825A0-084C-4F47-8C7E-3EA79B6914D9}"/>
    <pc:docChg chg="custSel modSld">
      <pc:chgData name="Connor Blair" userId="5dffaaf1-4e99-4a9f-9d58-f6e2d8990ba3" providerId="ADAL" clId="{250825A0-084C-4F47-8C7E-3EA79B6914D9}" dt="2024-03-19T09:22:03.026" v="33" actId="20577"/>
      <pc:docMkLst>
        <pc:docMk/>
      </pc:docMkLst>
      <pc:sldChg chg="addSp modSp mod">
        <pc:chgData name="Connor Blair" userId="5dffaaf1-4e99-4a9f-9d58-f6e2d8990ba3" providerId="ADAL" clId="{250825A0-084C-4F47-8C7E-3EA79B6914D9}" dt="2024-03-19T09:22:03.026" v="33" actId="20577"/>
        <pc:sldMkLst>
          <pc:docMk/>
          <pc:sldMk cId="362827076" sldId="285"/>
        </pc:sldMkLst>
        <pc:spChg chg="mod">
          <ac:chgData name="Connor Blair" userId="5dffaaf1-4e99-4a9f-9d58-f6e2d8990ba3" providerId="ADAL" clId="{250825A0-084C-4F47-8C7E-3EA79B6914D9}" dt="2024-03-19T09:22:03.026" v="33" actId="20577"/>
          <ac:spMkLst>
            <pc:docMk/>
            <pc:sldMk cId="362827076" sldId="285"/>
            <ac:spMk id="2" creationId="{ACA36E39-E06E-F87D-A1D6-2423F6FED5C9}"/>
          </ac:spMkLst>
        </pc:spChg>
        <pc:spChg chg="add mod">
          <ac:chgData name="Connor Blair" userId="5dffaaf1-4e99-4a9f-9d58-f6e2d8990ba3" providerId="ADAL" clId="{250825A0-084C-4F47-8C7E-3EA79B6914D9}" dt="2024-03-19T09:21:42.918" v="29" actId="1038"/>
          <ac:spMkLst>
            <pc:docMk/>
            <pc:sldMk cId="362827076" sldId="285"/>
            <ac:spMk id="4" creationId="{8A82EFF6-46AA-7719-792E-988B36CE1C5F}"/>
          </ac:spMkLst>
        </pc:spChg>
        <pc:spChg chg="mod">
          <ac:chgData name="Connor Blair" userId="5dffaaf1-4e99-4a9f-9d58-f6e2d8990ba3" providerId="ADAL" clId="{250825A0-084C-4F47-8C7E-3EA79B6914D9}" dt="2024-03-19T09:21:33.462" v="21" actId="20577"/>
          <ac:spMkLst>
            <pc:docMk/>
            <pc:sldMk cId="362827076" sldId="285"/>
            <ac:spMk id="105" creationId="{0C55E764-BCA5-C9B6-06F4-9802B2654D96}"/>
          </ac:spMkLst>
        </pc:spChg>
        <pc:spChg chg="mod">
          <ac:chgData name="Connor Blair" userId="5dffaaf1-4e99-4a9f-9d58-f6e2d8990ba3" providerId="ADAL" clId="{250825A0-084C-4F47-8C7E-3EA79B6914D9}" dt="2024-03-19T09:21:17.752" v="2" actId="1038"/>
          <ac:spMkLst>
            <pc:docMk/>
            <pc:sldMk cId="362827076" sldId="285"/>
            <ac:spMk id="186" creationId="{CD5E290F-449B-CF15-4EA4-ED960F70EE48}"/>
          </ac:spMkLst>
        </pc:spChg>
        <pc:spChg chg="mod">
          <ac:chgData name="Connor Blair" userId="5dffaaf1-4e99-4a9f-9d58-f6e2d8990ba3" providerId="ADAL" clId="{250825A0-084C-4F47-8C7E-3EA79B6914D9}" dt="2024-03-19T09:21:17.752" v="2" actId="1038"/>
          <ac:spMkLst>
            <pc:docMk/>
            <pc:sldMk cId="362827076" sldId="285"/>
            <ac:spMk id="188" creationId="{2182A216-6FC4-7769-0403-8D0BC361EC96}"/>
          </ac:spMkLst>
        </pc:spChg>
        <pc:spChg chg="mod">
          <ac:chgData name="Connor Blair" userId="5dffaaf1-4e99-4a9f-9d58-f6e2d8990ba3" providerId="ADAL" clId="{250825A0-084C-4F47-8C7E-3EA79B6914D9}" dt="2024-03-19T09:21:17.752" v="2" actId="1038"/>
          <ac:spMkLst>
            <pc:docMk/>
            <pc:sldMk cId="362827076" sldId="285"/>
            <ac:spMk id="190" creationId="{BF38EF23-B101-BC76-9FBF-3CDB9766C6A2}"/>
          </ac:spMkLst>
        </pc:spChg>
        <pc:spChg chg="mod">
          <ac:chgData name="Connor Blair" userId="5dffaaf1-4e99-4a9f-9d58-f6e2d8990ba3" providerId="ADAL" clId="{250825A0-084C-4F47-8C7E-3EA79B6914D9}" dt="2024-03-19T09:21:17.752" v="2" actId="1038"/>
          <ac:spMkLst>
            <pc:docMk/>
            <pc:sldMk cId="362827076" sldId="285"/>
            <ac:spMk id="198" creationId="{E04D5E35-AA3D-A76B-5BBD-3679F62D8980}"/>
          </ac:spMkLst>
        </pc:spChg>
        <pc:picChg chg="mod">
          <ac:chgData name="Connor Blair" userId="5dffaaf1-4e99-4a9f-9d58-f6e2d8990ba3" providerId="ADAL" clId="{250825A0-084C-4F47-8C7E-3EA79B6914D9}" dt="2024-03-19T09:21:17.752" v="2" actId="1038"/>
          <ac:picMkLst>
            <pc:docMk/>
            <pc:sldMk cId="362827076" sldId="285"/>
            <ac:picMk id="197" creationId="{64286815-CFA2-1942-6F0E-61572CB98B34}"/>
          </ac:picMkLst>
        </pc:picChg>
        <pc:cxnChg chg="add mod">
          <ac:chgData name="Connor Blair" userId="5dffaaf1-4e99-4a9f-9d58-f6e2d8990ba3" providerId="ADAL" clId="{250825A0-084C-4F47-8C7E-3EA79B6914D9}" dt="2024-03-19T09:21:42.918" v="29" actId="1038"/>
          <ac:cxnSpMkLst>
            <pc:docMk/>
            <pc:sldMk cId="362827076" sldId="285"/>
            <ac:cxnSpMk id="9" creationId="{A17732C6-AE99-2E89-B456-D57C2C79739F}"/>
          </ac:cxnSpMkLst>
        </pc:cxnChg>
        <pc:cxnChg chg="mod">
          <ac:chgData name="Connor Blair" userId="5dffaaf1-4e99-4a9f-9d58-f6e2d8990ba3" providerId="ADAL" clId="{250825A0-084C-4F47-8C7E-3EA79B6914D9}" dt="2024-03-19T09:21:17.752" v="2" actId="1038"/>
          <ac:cxnSpMkLst>
            <pc:docMk/>
            <pc:sldMk cId="362827076" sldId="285"/>
            <ac:cxnSpMk id="199" creationId="{35B10935-6E17-E4EB-A853-E05A7B031C9E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E723AD-2E02-4C2F-9A1C-07616C41FFC0}" type="datetimeFigureOut">
              <a:rPr lang="en-GB" smtClean="0"/>
              <a:t>19/03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E2DD3F-F90B-42FD-BF2D-F2FB96A7A6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0496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E2DD3F-F90B-42FD-BF2D-F2FB96A7A6C6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27848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9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5610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9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5098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9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836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9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445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9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6280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9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141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9/03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2705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9/03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233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9/03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8471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9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501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904DB-C9B3-40FA-8187-72FD223B53BD}" type="datetimeFigureOut">
              <a:rPr lang="en-GB" smtClean="0"/>
              <a:t>19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5109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5904DB-C9B3-40FA-8187-72FD223B53BD}" type="datetimeFigureOut">
              <a:rPr lang="en-GB" smtClean="0"/>
              <a:t>19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560EDA-1F22-4BB7-B5B0-5C66481CFE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3705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1" name="Picture 190">
            <a:extLst>
              <a:ext uri="{FF2B5EF4-FFF2-40B4-BE49-F238E27FC236}">
                <a16:creationId xmlns:a16="http://schemas.microsoft.com/office/drawing/2014/main" id="{62E801D6-EAAB-0D4F-9A71-0EFBA2E438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9783" y="6210647"/>
            <a:ext cx="1716944" cy="77766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89" name="Picture 188">
            <a:extLst>
              <a:ext uri="{FF2B5EF4-FFF2-40B4-BE49-F238E27FC236}">
                <a16:creationId xmlns:a16="http://schemas.microsoft.com/office/drawing/2014/main" id="{117EE4F7-A2C1-02FB-7F0C-91F092B26E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53836" y="2762062"/>
            <a:ext cx="1652143" cy="66897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87" name="Picture 186">
            <a:extLst>
              <a:ext uri="{FF2B5EF4-FFF2-40B4-BE49-F238E27FC236}">
                <a16:creationId xmlns:a16="http://schemas.microsoft.com/office/drawing/2014/main" id="{EBBE178A-4453-8D2D-B156-775D7B59372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66179" y="2025170"/>
            <a:ext cx="1652143" cy="67177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85" name="Picture 184">
            <a:extLst>
              <a:ext uri="{FF2B5EF4-FFF2-40B4-BE49-F238E27FC236}">
                <a16:creationId xmlns:a16="http://schemas.microsoft.com/office/drawing/2014/main" id="{760F6622-2B5E-CC17-F7CF-DF4AA6A3CA5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66638" y="1017009"/>
            <a:ext cx="1652143" cy="67370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83" name="Picture 182">
            <a:extLst>
              <a:ext uri="{FF2B5EF4-FFF2-40B4-BE49-F238E27FC236}">
                <a16:creationId xmlns:a16="http://schemas.microsoft.com/office/drawing/2014/main" id="{92B6C4EF-C913-703F-9EC4-46BC7B7EC1E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73192" y="6213728"/>
            <a:ext cx="1506609" cy="78045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8" name="Picture 157">
            <a:extLst>
              <a:ext uri="{FF2B5EF4-FFF2-40B4-BE49-F238E27FC236}">
                <a16:creationId xmlns:a16="http://schemas.microsoft.com/office/drawing/2014/main" id="{C96FD066-5099-A77B-D94B-6F1D54C3FB3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73578" y="5460844"/>
            <a:ext cx="1500440" cy="66652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42" name="Picture 141">
            <a:extLst>
              <a:ext uri="{FF2B5EF4-FFF2-40B4-BE49-F238E27FC236}">
                <a16:creationId xmlns:a16="http://schemas.microsoft.com/office/drawing/2014/main" id="{73D695B1-796B-725C-4FB2-D3DB8C4D6C8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89873" y="4494456"/>
            <a:ext cx="1484519" cy="66951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14" name="Picture 113">
            <a:extLst>
              <a:ext uri="{FF2B5EF4-FFF2-40B4-BE49-F238E27FC236}">
                <a16:creationId xmlns:a16="http://schemas.microsoft.com/office/drawing/2014/main" id="{BE6A9055-C25B-80A2-D333-69894C2EC93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589873" y="2790557"/>
            <a:ext cx="1523067" cy="67495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B34E47E9-EF0F-346E-E5BB-DF83BF4E204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58863" y="6174906"/>
            <a:ext cx="1533808" cy="72917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78BF9E9C-912D-6B72-27CE-89E782486BE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71320" y="2719339"/>
            <a:ext cx="1525231" cy="72096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6E2F66AD-80F5-8E1D-A20A-71FE9666159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70072" y="1018836"/>
            <a:ext cx="1514027" cy="64460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A0A0909-2C52-AA85-2B59-8C6BA07A572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70526" y="287258"/>
            <a:ext cx="1526837" cy="650308"/>
          </a:xfrm>
          <a:prstGeom prst="rect">
            <a:avLst/>
          </a:prstGeom>
          <a:ln w="12700">
            <a:solidFill>
              <a:schemeClr val="tx1"/>
            </a:solidFill>
          </a:ln>
          <a:effectLst/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E77848F-168E-217D-2C30-32424BC5D128}"/>
              </a:ext>
            </a:extLst>
          </p:cNvPr>
          <p:cNvSpPr txBox="1"/>
          <p:nvPr/>
        </p:nvSpPr>
        <p:spPr>
          <a:xfrm>
            <a:off x="1864246" y="397479"/>
            <a:ext cx="457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Total</a:t>
            </a:r>
          </a:p>
          <a:p>
            <a:r>
              <a:rPr lang="en-GB" sz="900" b="1" dirty="0"/>
              <a:t>c-RAF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D254B20-91F1-33CE-0CC1-CF77D7BCEC0C}"/>
              </a:ext>
            </a:extLst>
          </p:cNvPr>
          <p:cNvSpPr txBox="1"/>
          <p:nvPr/>
        </p:nvSpPr>
        <p:spPr>
          <a:xfrm>
            <a:off x="1706121" y="228022"/>
            <a:ext cx="19093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F3B21FE8-4FF3-9F99-4396-07B196432A31}"/>
              </a:ext>
            </a:extLst>
          </p:cNvPr>
          <p:cNvCxnSpPr>
            <a:cxnSpLocks/>
          </p:cNvCxnSpPr>
          <p:nvPr/>
        </p:nvCxnSpPr>
        <p:spPr>
          <a:xfrm flipH="1" flipV="1">
            <a:off x="1924431" y="777017"/>
            <a:ext cx="136746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4D7FAB6D-5557-1C05-B0AD-23087629DD47}"/>
              </a:ext>
            </a:extLst>
          </p:cNvPr>
          <p:cNvSpPr txBox="1"/>
          <p:nvPr/>
        </p:nvSpPr>
        <p:spPr>
          <a:xfrm>
            <a:off x="1860131" y="1202920"/>
            <a:ext cx="4876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HSP9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D738583-EC7E-72F0-9036-C7E54E669B07}"/>
              </a:ext>
            </a:extLst>
          </p:cNvPr>
          <p:cNvSpPr txBox="1"/>
          <p:nvPr/>
        </p:nvSpPr>
        <p:spPr>
          <a:xfrm>
            <a:off x="751398" y="-50547"/>
            <a:ext cx="769885" cy="3376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1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6055525-E17E-1734-9370-94905375A475}"/>
              </a:ext>
            </a:extLst>
          </p:cNvPr>
          <p:cNvSpPr txBox="1"/>
          <p:nvPr/>
        </p:nvSpPr>
        <p:spPr>
          <a:xfrm>
            <a:off x="1698822" y="952231"/>
            <a:ext cx="206054" cy="2085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E02099E-AA9D-A6C3-531C-A71A01D2C4E3}"/>
              </a:ext>
            </a:extLst>
          </p:cNvPr>
          <p:cNvSpPr txBox="1"/>
          <p:nvPr/>
        </p:nvSpPr>
        <p:spPr>
          <a:xfrm>
            <a:off x="-17215" y="636921"/>
            <a:ext cx="402934" cy="196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612BD6A-E6CA-67A0-E9D5-8BDA37D17EF8}"/>
              </a:ext>
            </a:extLst>
          </p:cNvPr>
          <p:cNvSpPr txBox="1"/>
          <p:nvPr/>
        </p:nvSpPr>
        <p:spPr>
          <a:xfrm>
            <a:off x="-60325" y="507136"/>
            <a:ext cx="448623" cy="196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F66BB24-4850-8D38-B5A5-113B203BE311}"/>
              </a:ext>
            </a:extLst>
          </p:cNvPr>
          <p:cNvSpPr txBox="1"/>
          <p:nvPr/>
        </p:nvSpPr>
        <p:spPr>
          <a:xfrm>
            <a:off x="-14634" y="1384500"/>
            <a:ext cx="402934" cy="196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D0B0E09-34FD-BB5B-26B3-F8F286AE2CF8}"/>
              </a:ext>
            </a:extLst>
          </p:cNvPr>
          <p:cNvSpPr txBox="1"/>
          <p:nvPr/>
        </p:nvSpPr>
        <p:spPr>
          <a:xfrm>
            <a:off x="-57744" y="1254715"/>
            <a:ext cx="448623" cy="196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54387A1C-543D-128E-1C55-375039F0B2E3}"/>
              </a:ext>
            </a:extLst>
          </p:cNvPr>
          <p:cNvCxnSpPr>
            <a:cxnSpLocks/>
          </p:cNvCxnSpPr>
          <p:nvPr/>
        </p:nvCxnSpPr>
        <p:spPr>
          <a:xfrm flipH="1" flipV="1">
            <a:off x="1930291" y="1447835"/>
            <a:ext cx="136746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Picture 17">
            <a:extLst>
              <a:ext uri="{FF2B5EF4-FFF2-40B4-BE49-F238E27FC236}">
                <a16:creationId xmlns:a16="http://schemas.microsoft.com/office/drawing/2014/main" id="{345BBF85-F225-2BA2-400E-9618E5765D9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75487" y="1939220"/>
            <a:ext cx="1521064" cy="72596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FC85046F-D49C-717A-F7FB-FDDBBE66C48B}"/>
              </a:ext>
            </a:extLst>
          </p:cNvPr>
          <p:cNvSpPr txBox="1"/>
          <p:nvPr/>
        </p:nvSpPr>
        <p:spPr>
          <a:xfrm>
            <a:off x="1875881" y="2061632"/>
            <a:ext cx="4571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pS43</a:t>
            </a:r>
          </a:p>
          <a:p>
            <a:r>
              <a:rPr lang="en-GB" sz="900" b="1" dirty="0"/>
              <a:t>c-RAF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FFB25728-CB01-FC16-482D-7C5FF248B1B5}"/>
              </a:ext>
            </a:extLst>
          </p:cNvPr>
          <p:cNvCxnSpPr>
            <a:cxnSpLocks/>
          </p:cNvCxnSpPr>
          <p:nvPr/>
        </p:nvCxnSpPr>
        <p:spPr>
          <a:xfrm flipH="1" flipV="1">
            <a:off x="1923935" y="2435247"/>
            <a:ext cx="148797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531F7090-A44E-24AC-7DBB-62E89FB82D7D}"/>
              </a:ext>
            </a:extLst>
          </p:cNvPr>
          <p:cNvSpPr txBox="1"/>
          <p:nvPr/>
        </p:nvSpPr>
        <p:spPr>
          <a:xfrm>
            <a:off x="1690487" y="1884035"/>
            <a:ext cx="1796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2900A4A-B2EC-E5F0-4BF9-6E06CD1412A2}"/>
              </a:ext>
            </a:extLst>
          </p:cNvPr>
          <p:cNvSpPr txBox="1"/>
          <p:nvPr/>
        </p:nvSpPr>
        <p:spPr>
          <a:xfrm>
            <a:off x="-25149" y="2307196"/>
            <a:ext cx="438442" cy="19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5BB52DA-33AD-76E7-8E36-455F785D54CF}"/>
              </a:ext>
            </a:extLst>
          </p:cNvPr>
          <p:cNvSpPr txBox="1"/>
          <p:nvPr/>
        </p:nvSpPr>
        <p:spPr>
          <a:xfrm>
            <a:off x="-72058" y="2177574"/>
            <a:ext cx="488159" cy="19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5D5A164-627B-236E-8266-7E8BB172198D}"/>
              </a:ext>
            </a:extLst>
          </p:cNvPr>
          <p:cNvSpPr txBox="1"/>
          <p:nvPr/>
        </p:nvSpPr>
        <p:spPr>
          <a:xfrm>
            <a:off x="1834316" y="2931992"/>
            <a:ext cx="4876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HSP90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0AD45470-2092-03E8-2427-BC529B302B11}"/>
              </a:ext>
            </a:extLst>
          </p:cNvPr>
          <p:cNvCxnSpPr>
            <a:cxnSpLocks/>
          </p:cNvCxnSpPr>
          <p:nvPr/>
        </p:nvCxnSpPr>
        <p:spPr>
          <a:xfrm flipH="1" flipV="1">
            <a:off x="1921741" y="3165637"/>
            <a:ext cx="148797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DCDEB768-D082-42B2-5DA7-EE7E08B75BDB}"/>
              </a:ext>
            </a:extLst>
          </p:cNvPr>
          <p:cNvSpPr txBox="1"/>
          <p:nvPr/>
        </p:nvSpPr>
        <p:spPr>
          <a:xfrm>
            <a:off x="-17677" y="3190084"/>
            <a:ext cx="438442" cy="19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7F2921F-FBE0-2D3A-2F46-09BEAC262B62}"/>
              </a:ext>
            </a:extLst>
          </p:cNvPr>
          <p:cNvSpPr txBox="1"/>
          <p:nvPr/>
        </p:nvSpPr>
        <p:spPr>
          <a:xfrm>
            <a:off x="-64586" y="2974737"/>
            <a:ext cx="488159" cy="19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D7D544B-3451-9734-73D5-7782790A07E6}"/>
              </a:ext>
            </a:extLst>
          </p:cNvPr>
          <p:cNvSpPr txBox="1"/>
          <p:nvPr/>
        </p:nvSpPr>
        <p:spPr>
          <a:xfrm>
            <a:off x="1655459" y="2661989"/>
            <a:ext cx="17967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7EF1D5E-93AE-1423-072C-2611BB73A7B1}"/>
              </a:ext>
            </a:extLst>
          </p:cNvPr>
          <p:cNvSpPr txBox="1"/>
          <p:nvPr/>
        </p:nvSpPr>
        <p:spPr>
          <a:xfrm>
            <a:off x="703435" y="1618101"/>
            <a:ext cx="856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1B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02F6CDC9-B606-E735-F5A7-72704B72D24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70526" y="4405042"/>
            <a:ext cx="1522144" cy="84102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6602E107-F38E-CD52-031B-8E354093A86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70526" y="3730074"/>
            <a:ext cx="1522144" cy="63530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94E718DF-D030-B8F9-7973-043AC9991592}"/>
              </a:ext>
            </a:extLst>
          </p:cNvPr>
          <p:cNvSpPr txBox="1"/>
          <p:nvPr/>
        </p:nvSpPr>
        <p:spPr>
          <a:xfrm>
            <a:off x="1857162" y="3870725"/>
            <a:ext cx="4521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pS259 </a:t>
            </a:r>
          </a:p>
          <a:p>
            <a:r>
              <a:rPr lang="en-GB" sz="900" b="1" dirty="0"/>
              <a:t>c-RAF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F378D53-4277-6068-5AD6-620E54FB1A0B}"/>
              </a:ext>
            </a:extLst>
          </p:cNvPr>
          <p:cNvSpPr txBox="1"/>
          <p:nvPr/>
        </p:nvSpPr>
        <p:spPr>
          <a:xfrm>
            <a:off x="1868479" y="4586314"/>
            <a:ext cx="4130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Total </a:t>
            </a:r>
          </a:p>
          <a:p>
            <a:r>
              <a:rPr lang="en-GB" sz="900" b="1" dirty="0"/>
              <a:t>ERK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CE4D3829-5858-9971-DD2B-34AC5375F2E3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71320" y="5282585"/>
            <a:ext cx="1522144" cy="84102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B3A784E6-A831-B5D8-0DBC-F8BF66BF7CC6}"/>
              </a:ext>
            </a:extLst>
          </p:cNvPr>
          <p:cNvSpPr txBox="1"/>
          <p:nvPr/>
        </p:nvSpPr>
        <p:spPr>
          <a:xfrm>
            <a:off x="1845817" y="5431585"/>
            <a:ext cx="478016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pT202</a:t>
            </a:r>
          </a:p>
          <a:p>
            <a:r>
              <a:rPr lang="en-GB" sz="900" b="1" dirty="0"/>
              <a:t>pY204</a:t>
            </a:r>
          </a:p>
          <a:p>
            <a:r>
              <a:rPr lang="en-GB" sz="900" b="1" dirty="0"/>
              <a:t>ERK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CF8A65A-4C46-F489-F2CE-C6052B64BDA9}"/>
              </a:ext>
            </a:extLst>
          </p:cNvPr>
          <p:cNvSpPr txBox="1"/>
          <p:nvPr/>
        </p:nvSpPr>
        <p:spPr>
          <a:xfrm>
            <a:off x="1889094" y="6358305"/>
            <a:ext cx="4405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HSP9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36D4AF1-C59D-4DB2-9FEA-7C3CED55C4DF}"/>
              </a:ext>
            </a:extLst>
          </p:cNvPr>
          <p:cNvSpPr txBox="1"/>
          <p:nvPr/>
        </p:nvSpPr>
        <p:spPr>
          <a:xfrm>
            <a:off x="1695367" y="3662599"/>
            <a:ext cx="173979" cy="2037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4A32365-3911-E152-C163-4CECD5DD6E60}"/>
              </a:ext>
            </a:extLst>
          </p:cNvPr>
          <p:cNvSpPr txBox="1"/>
          <p:nvPr/>
        </p:nvSpPr>
        <p:spPr>
          <a:xfrm>
            <a:off x="1674889" y="5906034"/>
            <a:ext cx="173979" cy="2037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94F969B-E9ED-B5C8-C7FE-A0C2D18E656E}"/>
              </a:ext>
            </a:extLst>
          </p:cNvPr>
          <p:cNvSpPr txBox="1"/>
          <p:nvPr/>
        </p:nvSpPr>
        <p:spPr>
          <a:xfrm>
            <a:off x="1653104" y="5009550"/>
            <a:ext cx="201867" cy="2037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/>
              <a:t>M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100BD001-6D3B-64B1-D0B6-AEC92DE94D52}"/>
              </a:ext>
            </a:extLst>
          </p:cNvPr>
          <p:cNvCxnSpPr>
            <a:cxnSpLocks/>
          </p:cNvCxnSpPr>
          <p:nvPr/>
        </p:nvCxnSpPr>
        <p:spPr>
          <a:xfrm flipH="1" flipV="1">
            <a:off x="1926503" y="4273909"/>
            <a:ext cx="117405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32214D44-5A71-AB5E-3C5A-B3D374E27305}"/>
              </a:ext>
            </a:extLst>
          </p:cNvPr>
          <p:cNvCxnSpPr>
            <a:cxnSpLocks/>
          </p:cNvCxnSpPr>
          <p:nvPr/>
        </p:nvCxnSpPr>
        <p:spPr>
          <a:xfrm flipH="1" flipV="1">
            <a:off x="1918514" y="4599593"/>
            <a:ext cx="117405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0F8EB760-08D3-95DB-9B2B-E75D2FF1170D}"/>
              </a:ext>
            </a:extLst>
          </p:cNvPr>
          <p:cNvCxnSpPr>
            <a:cxnSpLocks/>
          </p:cNvCxnSpPr>
          <p:nvPr/>
        </p:nvCxnSpPr>
        <p:spPr>
          <a:xfrm flipH="1" flipV="1">
            <a:off x="1918514" y="5423595"/>
            <a:ext cx="117405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A90EA1DB-ADD2-2A53-C5B9-34A7B7A36683}"/>
              </a:ext>
            </a:extLst>
          </p:cNvPr>
          <p:cNvSpPr txBox="1"/>
          <p:nvPr/>
        </p:nvSpPr>
        <p:spPr>
          <a:xfrm>
            <a:off x="726269" y="3405961"/>
            <a:ext cx="979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lot 1C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8DC5F0B-DD53-5C07-A2AD-103719BEE5D8}"/>
              </a:ext>
            </a:extLst>
          </p:cNvPr>
          <p:cNvSpPr txBox="1"/>
          <p:nvPr/>
        </p:nvSpPr>
        <p:spPr>
          <a:xfrm>
            <a:off x="-24178" y="4103493"/>
            <a:ext cx="3459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BF12CE8-B199-46B7-C476-7B49A73BA1EC}"/>
              </a:ext>
            </a:extLst>
          </p:cNvPr>
          <p:cNvSpPr txBox="1"/>
          <p:nvPr/>
        </p:nvSpPr>
        <p:spPr>
          <a:xfrm>
            <a:off x="-61191" y="3975833"/>
            <a:ext cx="385171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F3F9A28-8291-7C50-9C16-73692BE41F54}"/>
              </a:ext>
            </a:extLst>
          </p:cNvPr>
          <p:cNvSpPr txBox="1"/>
          <p:nvPr/>
        </p:nvSpPr>
        <p:spPr>
          <a:xfrm>
            <a:off x="-42110" y="4571745"/>
            <a:ext cx="3459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37kD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B026556-0875-C06D-8551-DA0AFB5F1C09}"/>
              </a:ext>
            </a:extLst>
          </p:cNvPr>
          <p:cNvSpPr txBox="1"/>
          <p:nvPr/>
        </p:nvSpPr>
        <p:spPr>
          <a:xfrm>
            <a:off x="-41282" y="4917656"/>
            <a:ext cx="3459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5kD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F4ED1CC-19CA-1E3F-0129-D51AD00AFE53}"/>
              </a:ext>
            </a:extLst>
          </p:cNvPr>
          <p:cNvSpPr txBox="1"/>
          <p:nvPr/>
        </p:nvSpPr>
        <p:spPr>
          <a:xfrm>
            <a:off x="-42110" y="5028933"/>
            <a:ext cx="3459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0kD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C9F849D-7173-C769-1193-9BCE1BE51004}"/>
              </a:ext>
            </a:extLst>
          </p:cNvPr>
          <p:cNvSpPr txBox="1"/>
          <p:nvPr/>
        </p:nvSpPr>
        <p:spPr>
          <a:xfrm>
            <a:off x="-43135" y="4335171"/>
            <a:ext cx="3459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50kD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523298C-1B17-290C-1616-58F2D70F31C1}"/>
              </a:ext>
            </a:extLst>
          </p:cNvPr>
          <p:cNvSpPr txBox="1"/>
          <p:nvPr/>
        </p:nvSpPr>
        <p:spPr>
          <a:xfrm>
            <a:off x="-37391" y="5455529"/>
            <a:ext cx="3459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37kD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9A2BB3E-C0FE-8E6A-F057-AEC22108693E}"/>
              </a:ext>
            </a:extLst>
          </p:cNvPr>
          <p:cNvSpPr txBox="1"/>
          <p:nvPr/>
        </p:nvSpPr>
        <p:spPr>
          <a:xfrm>
            <a:off x="-36564" y="5801440"/>
            <a:ext cx="3459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5kD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15EA4A5-974D-F616-3363-229D5AB5B782}"/>
              </a:ext>
            </a:extLst>
          </p:cNvPr>
          <p:cNvSpPr txBox="1"/>
          <p:nvPr/>
        </p:nvSpPr>
        <p:spPr>
          <a:xfrm>
            <a:off x="-37391" y="5912717"/>
            <a:ext cx="3459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0kD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2A2607D-E14D-241A-DE7D-79D02EE30892}"/>
              </a:ext>
            </a:extLst>
          </p:cNvPr>
          <p:cNvSpPr txBox="1"/>
          <p:nvPr/>
        </p:nvSpPr>
        <p:spPr>
          <a:xfrm>
            <a:off x="-38417" y="5218955"/>
            <a:ext cx="3459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50kDa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44FCCA06-B0CD-4167-E000-EEED6265EFB9}"/>
              </a:ext>
            </a:extLst>
          </p:cNvPr>
          <p:cNvCxnSpPr>
            <a:cxnSpLocks/>
          </p:cNvCxnSpPr>
          <p:nvPr/>
        </p:nvCxnSpPr>
        <p:spPr>
          <a:xfrm flipH="1" flipV="1">
            <a:off x="1930519" y="6606874"/>
            <a:ext cx="117405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642D7966-847E-DC70-EEE8-4CE9859F230B}"/>
              </a:ext>
            </a:extLst>
          </p:cNvPr>
          <p:cNvSpPr txBox="1"/>
          <p:nvPr/>
        </p:nvSpPr>
        <p:spPr>
          <a:xfrm>
            <a:off x="-37091" y="6673144"/>
            <a:ext cx="3459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CD3F66F-2E9B-7088-ED35-DFB8AE9081AF}"/>
              </a:ext>
            </a:extLst>
          </p:cNvPr>
          <p:cNvSpPr txBox="1"/>
          <p:nvPr/>
        </p:nvSpPr>
        <p:spPr>
          <a:xfrm>
            <a:off x="-74110" y="6478809"/>
            <a:ext cx="385171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3049982-52DB-DC16-0ED4-7D8B8B25685A}"/>
              </a:ext>
            </a:extLst>
          </p:cNvPr>
          <p:cNvSpPr txBox="1"/>
          <p:nvPr/>
        </p:nvSpPr>
        <p:spPr>
          <a:xfrm>
            <a:off x="1689310" y="6110054"/>
            <a:ext cx="171162" cy="1828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7217FC52-8580-C194-6699-11CD477FD70F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592431" y="982666"/>
            <a:ext cx="1514026" cy="84729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46EDDE88-6174-AD6E-04EE-84777E2D5D30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592459" y="297197"/>
            <a:ext cx="1513999" cy="64226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5A12C923-1398-BA34-D943-63C7B1A602C1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591876" y="1880910"/>
            <a:ext cx="1521064" cy="84729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73" name="Group 72">
            <a:extLst>
              <a:ext uri="{FF2B5EF4-FFF2-40B4-BE49-F238E27FC236}">
                <a16:creationId xmlns:a16="http://schemas.microsoft.com/office/drawing/2014/main" id="{88E76AD8-F91E-BDB9-F37B-EAF91D88BE71}"/>
              </a:ext>
            </a:extLst>
          </p:cNvPr>
          <p:cNvGrpSpPr/>
          <p:nvPr/>
        </p:nvGrpSpPr>
        <p:grpSpPr>
          <a:xfrm>
            <a:off x="3868583" y="256535"/>
            <a:ext cx="680008" cy="2933467"/>
            <a:chOff x="10854308" y="1080373"/>
            <a:chExt cx="1024551" cy="3656045"/>
          </a:xfrm>
          <a:effectLst/>
        </p:grpSpPr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EE6F7C15-5A20-BBDC-1FE3-9170C97FBEA6}"/>
                </a:ext>
              </a:extLst>
            </p:cNvPr>
            <p:cNvSpPr txBox="1"/>
            <p:nvPr/>
          </p:nvSpPr>
          <p:spPr>
            <a:xfrm>
              <a:off x="11139318" y="1289048"/>
              <a:ext cx="617337" cy="460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/>
                <a:t>Total </a:t>
              </a:r>
            </a:p>
            <a:p>
              <a:r>
                <a:rPr lang="en-GB" sz="900" b="1" dirty="0"/>
                <a:t>c-RAF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4A5D08EC-4D2A-81B6-22C5-7D076CE49D6E}"/>
                </a:ext>
              </a:extLst>
            </p:cNvPr>
            <p:cNvSpPr txBox="1"/>
            <p:nvPr/>
          </p:nvSpPr>
          <p:spPr>
            <a:xfrm>
              <a:off x="11156231" y="2273936"/>
              <a:ext cx="617337" cy="460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/>
                <a:t>Total </a:t>
              </a:r>
            </a:p>
            <a:p>
              <a:r>
                <a:rPr lang="en-GB" sz="900" b="1" dirty="0"/>
                <a:t>ERK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E079BB6B-1234-52D6-C0A5-D183775C0152}"/>
                </a:ext>
              </a:extLst>
            </p:cNvPr>
            <p:cNvSpPr txBox="1"/>
            <p:nvPr/>
          </p:nvSpPr>
          <p:spPr>
            <a:xfrm>
              <a:off x="11156231" y="3285073"/>
              <a:ext cx="722628" cy="6329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/>
                <a:t>pT202</a:t>
              </a:r>
            </a:p>
            <a:p>
              <a:r>
                <a:rPr lang="en-GB" sz="900" b="1" dirty="0"/>
                <a:t>pY204</a:t>
              </a:r>
            </a:p>
            <a:p>
              <a:r>
                <a:rPr lang="en-GB" sz="900" b="1" dirty="0"/>
                <a:t>ERK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1923C7E1-13F6-F371-95A1-CE84BF1AB5EC}"/>
                </a:ext>
              </a:extLst>
            </p:cNvPr>
            <p:cNvSpPr txBox="1"/>
            <p:nvPr/>
          </p:nvSpPr>
          <p:spPr>
            <a:xfrm>
              <a:off x="11187039" y="4448727"/>
              <a:ext cx="658465" cy="2876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/>
                <a:t>HSP90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635C8B59-FDDD-D5CA-4A7B-9B53B4B48C71}"/>
                </a:ext>
              </a:extLst>
            </p:cNvPr>
            <p:cNvSpPr txBox="1"/>
            <p:nvPr/>
          </p:nvSpPr>
          <p:spPr>
            <a:xfrm>
              <a:off x="10940222" y="1080373"/>
              <a:ext cx="2600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b="1" dirty="0"/>
                <a:t>R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412393D2-75B9-455F-174B-D05851B7F409}"/>
                </a:ext>
              </a:extLst>
            </p:cNvPr>
            <p:cNvSpPr txBox="1"/>
            <p:nvPr/>
          </p:nvSpPr>
          <p:spPr>
            <a:xfrm>
              <a:off x="10910231" y="3939674"/>
              <a:ext cx="2600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b="1" dirty="0"/>
                <a:t>R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578E4E55-5D11-A767-108C-902FB98AFBB9}"/>
                </a:ext>
              </a:extLst>
            </p:cNvPr>
            <p:cNvSpPr txBox="1"/>
            <p:nvPr/>
          </p:nvSpPr>
          <p:spPr>
            <a:xfrm>
              <a:off x="10854308" y="2769911"/>
              <a:ext cx="30168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b="1" dirty="0"/>
                <a:t>M</a:t>
              </a:r>
            </a:p>
          </p:txBody>
        </p:sp>
      </p:grp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ED5A0FB0-5658-7327-FBEF-5A3D8F1937F1}"/>
              </a:ext>
            </a:extLst>
          </p:cNvPr>
          <p:cNvCxnSpPr>
            <a:cxnSpLocks/>
          </p:cNvCxnSpPr>
          <p:nvPr/>
        </p:nvCxnSpPr>
        <p:spPr>
          <a:xfrm flipH="1" flipV="1">
            <a:off x="4136045" y="789051"/>
            <a:ext cx="116454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E9A9816A-C97E-E26C-2EC9-037AF6740877}"/>
              </a:ext>
            </a:extLst>
          </p:cNvPr>
          <p:cNvCxnSpPr>
            <a:cxnSpLocks/>
          </p:cNvCxnSpPr>
          <p:nvPr/>
        </p:nvCxnSpPr>
        <p:spPr>
          <a:xfrm flipH="1" flipV="1">
            <a:off x="4166220" y="1189383"/>
            <a:ext cx="116454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1FAD06EE-E4E5-92DB-D0CE-10A41BC3F767}"/>
              </a:ext>
            </a:extLst>
          </p:cNvPr>
          <p:cNvCxnSpPr>
            <a:cxnSpLocks/>
          </p:cNvCxnSpPr>
          <p:nvPr/>
        </p:nvCxnSpPr>
        <p:spPr>
          <a:xfrm flipH="1" flipV="1">
            <a:off x="4147170" y="2013384"/>
            <a:ext cx="116454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5B080F33-FEA0-F68A-3E38-0DDBC3E6DF63}"/>
              </a:ext>
            </a:extLst>
          </p:cNvPr>
          <p:cNvSpPr txBox="1"/>
          <p:nvPr/>
        </p:nvSpPr>
        <p:spPr>
          <a:xfrm>
            <a:off x="2965041" y="-24718"/>
            <a:ext cx="774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2A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3888673-2FC7-6E18-4D28-E1955EB07B1F}"/>
              </a:ext>
            </a:extLst>
          </p:cNvPr>
          <p:cNvSpPr txBox="1"/>
          <p:nvPr/>
        </p:nvSpPr>
        <p:spPr>
          <a:xfrm>
            <a:off x="2230810" y="637685"/>
            <a:ext cx="3431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78B95401-529E-8872-7C6B-61BE5B7F06B4}"/>
              </a:ext>
            </a:extLst>
          </p:cNvPr>
          <p:cNvSpPr txBox="1"/>
          <p:nvPr/>
        </p:nvSpPr>
        <p:spPr>
          <a:xfrm>
            <a:off x="2194098" y="510025"/>
            <a:ext cx="382053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345A793F-4F67-306B-EA30-9B9A06BD27D3}"/>
              </a:ext>
            </a:extLst>
          </p:cNvPr>
          <p:cNvSpPr txBox="1"/>
          <p:nvPr/>
        </p:nvSpPr>
        <p:spPr>
          <a:xfrm>
            <a:off x="2213024" y="1161535"/>
            <a:ext cx="3431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37kDa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2304959A-C5EC-D661-572C-675B58B3D802}"/>
              </a:ext>
            </a:extLst>
          </p:cNvPr>
          <p:cNvSpPr txBox="1"/>
          <p:nvPr/>
        </p:nvSpPr>
        <p:spPr>
          <a:xfrm>
            <a:off x="2213845" y="1507445"/>
            <a:ext cx="3431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5kDa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AED8DEA9-FBCF-6E7D-EEB7-541A7F4F9AB4}"/>
              </a:ext>
            </a:extLst>
          </p:cNvPr>
          <p:cNvSpPr txBox="1"/>
          <p:nvPr/>
        </p:nvSpPr>
        <p:spPr>
          <a:xfrm>
            <a:off x="2213024" y="1618723"/>
            <a:ext cx="3431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0kDa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E1DAC9DD-51EC-985E-5323-9CE4D1293139}"/>
              </a:ext>
            </a:extLst>
          </p:cNvPr>
          <p:cNvSpPr txBox="1"/>
          <p:nvPr/>
        </p:nvSpPr>
        <p:spPr>
          <a:xfrm>
            <a:off x="2212007" y="924961"/>
            <a:ext cx="3431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50kDa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9AA8608-E66D-DCB0-9B73-6DFF9439E241}"/>
              </a:ext>
            </a:extLst>
          </p:cNvPr>
          <p:cNvSpPr txBox="1"/>
          <p:nvPr/>
        </p:nvSpPr>
        <p:spPr>
          <a:xfrm>
            <a:off x="2217704" y="2045318"/>
            <a:ext cx="3431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37kDa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18F9119-D38F-0A56-863B-F755C9BCAF35}"/>
              </a:ext>
            </a:extLst>
          </p:cNvPr>
          <p:cNvSpPr txBox="1"/>
          <p:nvPr/>
        </p:nvSpPr>
        <p:spPr>
          <a:xfrm>
            <a:off x="2218525" y="2391229"/>
            <a:ext cx="3431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5kDa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7236B376-9F23-4062-A2A1-E4189A63E2BC}"/>
              </a:ext>
            </a:extLst>
          </p:cNvPr>
          <p:cNvSpPr txBox="1"/>
          <p:nvPr/>
        </p:nvSpPr>
        <p:spPr>
          <a:xfrm>
            <a:off x="2217704" y="2502506"/>
            <a:ext cx="3431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0kDa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F977640-76A3-7374-C7CD-81467F0C9FA9}"/>
              </a:ext>
            </a:extLst>
          </p:cNvPr>
          <p:cNvSpPr txBox="1"/>
          <p:nvPr/>
        </p:nvSpPr>
        <p:spPr>
          <a:xfrm>
            <a:off x="2216687" y="1808745"/>
            <a:ext cx="3431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50kDa</a:t>
            </a:r>
          </a:p>
        </p:txBody>
      </p: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192E6926-BEF3-17AA-AAE4-FC61ECCF71F4}"/>
              </a:ext>
            </a:extLst>
          </p:cNvPr>
          <p:cNvCxnSpPr>
            <a:cxnSpLocks/>
          </p:cNvCxnSpPr>
          <p:nvPr/>
        </p:nvCxnSpPr>
        <p:spPr>
          <a:xfrm flipH="1" flipV="1">
            <a:off x="4159078" y="3179166"/>
            <a:ext cx="116454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994B874F-B9DA-3DF3-4E9B-CDDC6F673F19}"/>
              </a:ext>
            </a:extLst>
          </p:cNvPr>
          <p:cNvSpPr txBox="1"/>
          <p:nvPr/>
        </p:nvSpPr>
        <p:spPr>
          <a:xfrm>
            <a:off x="2208555" y="3159713"/>
            <a:ext cx="343142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ED4A2F09-832B-3D3A-51BA-C9664570D2C9}"/>
              </a:ext>
            </a:extLst>
          </p:cNvPr>
          <p:cNvSpPr txBox="1"/>
          <p:nvPr/>
        </p:nvSpPr>
        <p:spPr>
          <a:xfrm>
            <a:off x="2171835" y="3032051"/>
            <a:ext cx="382053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DD52AB3-0A0A-DF7A-C91E-476FC4DBFD89}"/>
              </a:ext>
            </a:extLst>
          </p:cNvPr>
          <p:cNvSpPr txBox="1"/>
          <p:nvPr/>
        </p:nvSpPr>
        <p:spPr>
          <a:xfrm>
            <a:off x="3907099" y="2718895"/>
            <a:ext cx="169776" cy="1828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D6FCA51F-2DD3-9A78-3912-3F28AFAECACB}"/>
              </a:ext>
            </a:extLst>
          </p:cNvPr>
          <p:cNvSpPr txBox="1"/>
          <p:nvPr/>
        </p:nvSpPr>
        <p:spPr>
          <a:xfrm>
            <a:off x="2939957" y="5143364"/>
            <a:ext cx="982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lot 2D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31923B51-7ACB-7046-A118-DCD40FCEDBAD}"/>
              </a:ext>
            </a:extLst>
          </p:cNvPr>
          <p:cNvSpPr txBox="1"/>
          <p:nvPr/>
        </p:nvSpPr>
        <p:spPr>
          <a:xfrm>
            <a:off x="2187457" y="5786274"/>
            <a:ext cx="5036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1263E356-6892-E89C-AEAE-98182109C0FC}"/>
              </a:ext>
            </a:extLst>
          </p:cNvPr>
          <p:cNvSpPr txBox="1"/>
          <p:nvPr/>
        </p:nvSpPr>
        <p:spPr>
          <a:xfrm>
            <a:off x="2128736" y="5664092"/>
            <a:ext cx="5446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0C55E764-BCA5-C9B6-06F4-9802B2654D96}"/>
              </a:ext>
            </a:extLst>
          </p:cNvPr>
          <p:cNvSpPr txBox="1"/>
          <p:nvPr/>
        </p:nvSpPr>
        <p:spPr>
          <a:xfrm>
            <a:off x="4039846" y="5588048"/>
            <a:ext cx="818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/>
              <a:t>pS43 </a:t>
            </a:r>
          </a:p>
          <a:p>
            <a:r>
              <a:rPr lang="en-GB" sz="900" b="1" dirty="0"/>
              <a:t>c-RAF</a:t>
            </a:r>
          </a:p>
        </p:txBody>
      </p: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1940F76E-4921-47C1-7FD4-BB9598B48FCD}"/>
              </a:ext>
            </a:extLst>
          </p:cNvPr>
          <p:cNvCxnSpPr>
            <a:cxnSpLocks/>
          </p:cNvCxnSpPr>
          <p:nvPr/>
        </p:nvCxnSpPr>
        <p:spPr>
          <a:xfrm flipH="1" flipV="1">
            <a:off x="4119480" y="5927602"/>
            <a:ext cx="129938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>
            <a:extLst>
              <a:ext uri="{FF2B5EF4-FFF2-40B4-BE49-F238E27FC236}">
                <a16:creationId xmlns:a16="http://schemas.microsoft.com/office/drawing/2014/main" id="{144067BF-185C-53E5-D1E8-81C2A8064CEB}"/>
              </a:ext>
            </a:extLst>
          </p:cNvPr>
          <p:cNvSpPr txBox="1"/>
          <p:nvPr/>
        </p:nvSpPr>
        <p:spPr>
          <a:xfrm>
            <a:off x="3866498" y="5414633"/>
            <a:ext cx="1736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78996398-D7DD-26D7-89F0-7AAAA8391FD6}"/>
              </a:ext>
            </a:extLst>
          </p:cNvPr>
          <p:cNvSpPr txBox="1"/>
          <p:nvPr/>
        </p:nvSpPr>
        <p:spPr>
          <a:xfrm>
            <a:off x="2172233" y="6638660"/>
            <a:ext cx="4673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96A3872E-6A1C-6C21-6772-038CD56EA3FE}"/>
              </a:ext>
            </a:extLst>
          </p:cNvPr>
          <p:cNvSpPr txBox="1"/>
          <p:nvPr/>
        </p:nvSpPr>
        <p:spPr>
          <a:xfrm>
            <a:off x="2135907" y="6489461"/>
            <a:ext cx="5036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37875684-BF49-18AE-E892-F2DE50862186}"/>
              </a:ext>
            </a:extLst>
          </p:cNvPr>
          <p:cNvSpPr txBox="1"/>
          <p:nvPr/>
        </p:nvSpPr>
        <p:spPr>
          <a:xfrm>
            <a:off x="4013856" y="6479666"/>
            <a:ext cx="6188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/>
              <a:t>HSP90</a:t>
            </a:r>
          </a:p>
        </p:txBody>
      </p: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9D107513-63BC-7DA0-7D0D-D94210CFD7DF}"/>
              </a:ext>
            </a:extLst>
          </p:cNvPr>
          <p:cNvCxnSpPr>
            <a:cxnSpLocks/>
          </p:cNvCxnSpPr>
          <p:nvPr/>
        </p:nvCxnSpPr>
        <p:spPr>
          <a:xfrm flipH="1" flipV="1">
            <a:off x="4103965" y="6674888"/>
            <a:ext cx="129938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id="{2342ADFC-A93D-D02B-A422-C15F2A0AC612}"/>
              </a:ext>
            </a:extLst>
          </p:cNvPr>
          <p:cNvSpPr txBox="1"/>
          <p:nvPr/>
        </p:nvSpPr>
        <p:spPr>
          <a:xfrm>
            <a:off x="3890134" y="6183538"/>
            <a:ext cx="1736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pic>
        <p:nvPicPr>
          <p:cNvPr id="117" name="Picture 116">
            <a:extLst>
              <a:ext uri="{FF2B5EF4-FFF2-40B4-BE49-F238E27FC236}">
                <a16:creationId xmlns:a16="http://schemas.microsoft.com/office/drawing/2014/main" id="{392384CF-8EBE-3AE4-865A-37FA77FC5F3B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2593919" y="3771217"/>
            <a:ext cx="1488775" cy="67495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</p:pic>
      <p:sp>
        <p:nvSpPr>
          <p:cNvPr id="118" name="TextBox 117">
            <a:extLst>
              <a:ext uri="{FF2B5EF4-FFF2-40B4-BE49-F238E27FC236}">
                <a16:creationId xmlns:a16="http://schemas.microsoft.com/office/drawing/2014/main" id="{A9E1C42C-97E1-6762-8A75-BA815203CB8C}"/>
              </a:ext>
            </a:extLst>
          </p:cNvPr>
          <p:cNvSpPr txBox="1"/>
          <p:nvPr/>
        </p:nvSpPr>
        <p:spPr>
          <a:xfrm>
            <a:off x="4042105" y="3964238"/>
            <a:ext cx="474809" cy="3693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pS259</a:t>
            </a:r>
          </a:p>
          <a:p>
            <a:r>
              <a:rPr lang="en-GB" sz="900" b="1" dirty="0"/>
              <a:t>c-RAF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9A23718E-BC14-8401-4CBA-47E7BA15701C}"/>
              </a:ext>
            </a:extLst>
          </p:cNvPr>
          <p:cNvSpPr txBox="1"/>
          <p:nvPr/>
        </p:nvSpPr>
        <p:spPr>
          <a:xfrm>
            <a:off x="3859947" y="3718884"/>
            <a:ext cx="206054" cy="2085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id="{3F52AAF8-4BEE-C024-BEF7-BDD718CA16BB}"/>
              </a:ext>
            </a:extLst>
          </p:cNvPr>
          <p:cNvCxnSpPr>
            <a:cxnSpLocks/>
          </p:cNvCxnSpPr>
          <p:nvPr/>
        </p:nvCxnSpPr>
        <p:spPr>
          <a:xfrm flipH="1" flipV="1">
            <a:off x="4126245" y="4283143"/>
            <a:ext cx="136746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6CBCF270-AE05-2D73-5FF0-BF80EBFC0B64}"/>
              </a:ext>
            </a:extLst>
          </p:cNvPr>
          <p:cNvSpPr txBox="1"/>
          <p:nvPr/>
        </p:nvSpPr>
        <p:spPr>
          <a:xfrm>
            <a:off x="4048125" y="4681824"/>
            <a:ext cx="4876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HSP9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7F347CA5-08EC-71B5-654B-47155367FCD1}"/>
              </a:ext>
            </a:extLst>
          </p:cNvPr>
          <p:cNvSpPr txBox="1"/>
          <p:nvPr/>
        </p:nvSpPr>
        <p:spPr>
          <a:xfrm>
            <a:off x="2953648" y="3429109"/>
            <a:ext cx="8547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2C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59FBFBB4-96E8-A2D0-B7FD-B6DC13B6A05D}"/>
              </a:ext>
            </a:extLst>
          </p:cNvPr>
          <p:cNvSpPr txBox="1"/>
          <p:nvPr/>
        </p:nvSpPr>
        <p:spPr>
          <a:xfrm>
            <a:off x="3860851" y="4421289"/>
            <a:ext cx="206054" cy="2085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CD01EC37-44B5-286C-3355-75FD97981CB4}"/>
              </a:ext>
            </a:extLst>
          </p:cNvPr>
          <p:cNvSpPr txBox="1"/>
          <p:nvPr/>
        </p:nvSpPr>
        <p:spPr>
          <a:xfrm>
            <a:off x="2190985" y="4088619"/>
            <a:ext cx="402934" cy="196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35871861-C6A5-A81F-E8FC-88396CB4A886}"/>
              </a:ext>
            </a:extLst>
          </p:cNvPr>
          <p:cNvSpPr txBox="1"/>
          <p:nvPr/>
        </p:nvSpPr>
        <p:spPr>
          <a:xfrm>
            <a:off x="2147875" y="3958835"/>
            <a:ext cx="448623" cy="196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E4CB0DBA-DF78-F3AC-7BC0-E0F120E8AA83}"/>
              </a:ext>
            </a:extLst>
          </p:cNvPr>
          <p:cNvSpPr txBox="1"/>
          <p:nvPr/>
        </p:nvSpPr>
        <p:spPr>
          <a:xfrm>
            <a:off x="2199587" y="4835486"/>
            <a:ext cx="402934" cy="196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3EE6FB43-B952-36B1-4389-A3134501A8EC}"/>
              </a:ext>
            </a:extLst>
          </p:cNvPr>
          <p:cNvSpPr txBox="1"/>
          <p:nvPr/>
        </p:nvSpPr>
        <p:spPr>
          <a:xfrm>
            <a:off x="2138549" y="4696266"/>
            <a:ext cx="448623" cy="196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cxnSp>
        <p:nvCxnSpPr>
          <p:cNvPr id="128" name="Straight Arrow Connector 127">
            <a:extLst>
              <a:ext uri="{FF2B5EF4-FFF2-40B4-BE49-F238E27FC236}">
                <a16:creationId xmlns:a16="http://schemas.microsoft.com/office/drawing/2014/main" id="{C3D8C064-F95B-E98C-0838-AF7B1F86185A}"/>
              </a:ext>
            </a:extLst>
          </p:cNvPr>
          <p:cNvCxnSpPr>
            <a:cxnSpLocks/>
          </p:cNvCxnSpPr>
          <p:nvPr/>
        </p:nvCxnSpPr>
        <p:spPr>
          <a:xfrm flipH="1" flipV="1">
            <a:off x="4126552" y="4932610"/>
            <a:ext cx="136746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0" name="Picture 129">
            <a:extLst>
              <a:ext uri="{FF2B5EF4-FFF2-40B4-BE49-F238E27FC236}">
                <a16:creationId xmlns:a16="http://schemas.microsoft.com/office/drawing/2014/main" id="{97543FD7-58A4-23CE-9852-2CF743CFCD85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866638" y="297197"/>
            <a:ext cx="1650757" cy="66940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31" name="TextBox 130">
            <a:extLst>
              <a:ext uri="{FF2B5EF4-FFF2-40B4-BE49-F238E27FC236}">
                <a16:creationId xmlns:a16="http://schemas.microsoft.com/office/drawing/2014/main" id="{26B39956-5FB5-2CD1-D76E-0D78E92C3E43}"/>
              </a:ext>
            </a:extLst>
          </p:cNvPr>
          <p:cNvSpPr txBox="1"/>
          <p:nvPr/>
        </p:nvSpPr>
        <p:spPr>
          <a:xfrm>
            <a:off x="6466154" y="460521"/>
            <a:ext cx="4571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/>
              <a:t>Total</a:t>
            </a:r>
          </a:p>
          <a:p>
            <a:r>
              <a:rPr lang="en-GB" sz="900" b="1" dirty="0"/>
              <a:t>c-RAF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A76C0B8E-E014-61ED-B61F-59645DF84439}"/>
              </a:ext>
            </a:extLst>
          </p:cNvPr>
          <p:cNvSpPr txBox="1"/>
          <p:nvPr/>
        </p:nvSpPr>
        <p:spPr>
          <a:xfrm>
            <a:off x="6270242" y="260896"/>
            <a:ext cx="2060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2CB8490D-233E-765A-4C8C-22E3A50FF9CD}"/>
              </a:ext>
            </a:extLst>
          </p:cNvPr>
          <p:cNvCxnSpPr>
            <a:cxnSpLocks/>
          </p:cNvCxnSpPr>
          <p:nvPr/>
        </p:nvCxnSpPr>
        <p:spPr>
          <a:xfrm flipH="1" flipV="1">
            <a:off x="6561027" y="853365"/>
            <a:ext cx="136746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21F80101-E4BB-7028-7A52-4DA2D2EA3BFB}"/>
              </a:ext>
            </a:extLst>
          </p:cNvPr>
          <p:cNvCxnSpPr>
            <a:cxnSpLocks/>
          </p:cNvCxnSpPr>
          <p:nvPr/>
        </p:nvCxnSpPr>
        <p:spPr>
          <a:xfrm flipH="1" flipV="1">
            <a:off x="6536251" y="1402617"/>
            <a:ext cx="136746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D0758A3E-FDB1-5F4F-0CF2-B4222B05B5A7}"/>
              </a:ext>
            </a:extLst>
          </p:cNvPr>
          <p:cNvSpPr txBox="1"/>
          <p:nvPr/>
        </p:nvSpPr>
        <p:spPr>
          <a:xfrm>
            <a:off x="6451905" y="1182225"/>
            <a:ext cx="4876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/>
              <a:t>HSP90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32961E6F-1B69-692B-DF34-4989B8825B40}"/>
              </a:ext>
            </a:extLst>
          </p:cNvPr>
          <p:cNvSpPr txBox="1"/>
          <p:nvPr/>
        </p:nvSpPr>
        <p:spPr>
          <a:xfrm>
            <a:off x="5266232" y="-4839"/>
            <a:ext cx="8643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lot 3A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52AEDA82-AE51-DAA7-0836-450369399C43}"/>
              </a:ext>
            </a:extLst>
          </p:cNvPr>
          <p:cNvSpPr txBox="1"/>
          <p:nvPr/>
        </p:nvSpPr>
        <p:spPr>
          <a:xfrm>
            <a:off x="6305647" y="976755"/>
            <a:ext cx="2060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DA6BC2AE-9862-EA2F-5EF9-387419061462}"/>
              </a:ext>
            </a:extLst>
          </p:cNvPr>
          <p:cNvSpPr txBox="1"/>
          <p:nvPr/>
        </p:nvSpPr>
        <p:spPr>
          <a:xfrm>
            <a:off x="4458547" y="637922"/>
            <a:ext cx="5223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B4E41212-305E-BD0B-BE1A-A40282C89AC7}"/>
              </a:ext>
            </a:extLst>
          </p:cNvPr>
          <p:cNvSpPr txBox="1"/>
          <p:nvPr/>
        </p:nvSpPr>
        <p:spPr>
          <a:xfrm>
            <a:off x="4415437" y="508138"/>
            <a:ext cx="5308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19ACDFAE-6604-B1AD-515A-C22A0296EC9C}"/>
              </a:ext>
            </a:extLst>
          </p:cNvPr>
          <p:cNvSpPr txBox="1"/>
          <p:nvPr/>
        </p:nvSpPr>
        <p:spPr>
          <a:xfrm>
            <a:off x="4452657" y="1349425"/>
            <a:ext cx="485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65414F76-0615-1493-3C20-658C4C2D1839}"/>
              </a:ext>
            </a:extLst>
          </p:cNvPr>
          <p:cNvSpPr txBox="1"/>
          <p:nvPr/>
        </p:nvSpPr>
        <p:spPr>
          <a:xfrm>
            <a:off x="4409548" y="1219644"/>
            <a:ext cx="5160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3082647E-D42B-F44D-4798-704592C6E821}"/>
              </a:ext>
            </a:extLst>
          </p:cNvPr>
          <p:cNvSpPr txBox="1"/>
          <p:nvPr/>
        </p:nvSpPr>
        <p:spPr>
          <a:xfrm>
            <a:off x="6462900" y="2175129"/>
            <a:ext cx="457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pS43</a:t>
            </a:r>
          </a:p>
          <a:p>
            <a:r>
              <a:rPr lang="en-GB" sz="900" b="1" dirty="0"/>
              <a:t>c-RAF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69C3851C-BA13-91D4-A50D-0199C96CB0B6}"/>
              </a:ext>
            </a:extLst>
          </p:cNvPr>
          <p:cNvSpPr txBox="1"/>
          <p:nvPr/>
        </p:nvSpPr>
        <p:spPr>
          <a:xfrm>
            <a:off x="6325770" y="1961752"/>
            <a:ext cx="17119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cxnSp>
        <p:nvCxnSpPr>
          <p:cNvPr id="148" name="Straight Arrow Connector 147">
            <a:extLst>
              <a:ext uri="{FF2B5EF4-FFF2-40B4-BE49-F238E27FC236}">
                <a16:creationId xmlns:a16="http://schemas.microsoft.com/office/drawing/2014/main" id="{D2E11A1A-A1A2-C8F1-5CB5-B9B137850E2D}"/>
              </a:ext>
            </a:extLst>
          </p:cNvPr>
          <p:cNvCxnSpPr>
            <a:cxnSpLocks/>
          </p:cNvCxnSpPr>
          <p:nvPr/>
        </p:nvCxnSpPr>
        <p:spPr>
          <a:xfrm flipH="1" flipV="1">
            <a:off x="6577647" y="2538252"/>
            <a:ext cx="148797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:a16="http://schemas.microsoft.com/office/drawing/2014/main" id="{7E089F34-53E9-BE68-004C-EE62C7D94483}"/>
              </a:ext>
            </a:extLst>
          </p:cNvPr>
          <p:cNvSpPr txBox="1"/>
          <p:nvPr/>
        </p:nvSpPr>
        <p:spPr>
          <a:xfrm>
            <a:off x="6437248" y="2862935"/>
            <a:ext cx="4876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HSP90</a:t>
            </a:r>
          </a:p>
        </p:txBody>
      </p:sp>
      <p:cxnSp>
        <p:nvCxnSpPr>
          <p:cNvPr id="150" name="Straight Arrow Connector 149">
            <a:extLst>
              <a:ext uri="{FF2B5EF4-FFF2-40B4-BE49-F238E27FC236}">
                <a16:creationId xmlns:a16="http://schemas.microsoft.com/office/drawing/2014/main" id="{3F91DBD0-8F87-B869-7D22-E3DD7F9C1964}"/>
              </a:ext>
            </a:extLst>
          </p:cNvPr>
          <p:cNvCxnSpPr>
            <a:cxnSpLocks/>
          </p:cNvCxnSpPr>
          <p:nvPr/>
        </p:nvCxnSpPr>
        <p:spPr>
          <a:xfrm flipH="1" flipV="1">
            <a:off x="6536419" y="3129411"/>
            <a:ext cx="148797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id="{877879F0-AA83-56BC-F394-A554D7C65F95}"/>
              </a:ext>
            </a:extLst>
          </p:cNvPr>
          <p:cNvSpPr txBox="1"/>
          <p:nvPr/>
        </p:nvSpPr>
        <p:spPr>
          <a:xfrm>
            <a:off x="6306722" y="2688860"/>
            <a:ext cx="1711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C78DD04B-2120-BEBE-9F5A-5C20C8072F9E}"/>
              </a:ext>
            </a:extLst>
          </p:cNvPr>
          <p:cNvSpPr txBox="1"/>
          <p:nvPr/>
        </p:nvSpPr>
        <p:spPr>
          <a:xfrm>
            <a:off x="5256429" y="1676487"/>
            <a:ext cx="856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3B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3ECEF43E-3671-B86E-69C7-4B1733D5253C}"/>
              </a:ext>
            </a:extLst>
          </p:cNvPr>
          <p:cNvSpPr txBox="1"/>
          <p:nvPr/>
        </p:nvSpPr>
        <p:spPr>
          <a:xfrm>
            <a:off x="4476994" y="2417149"/>
            <a:ext cx="438442" cy="19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8A12541B-9CD9-324B-C52F-8DF408CB8796}"/>
              </a:ext>
            </a:extLst>
          </p:cNvPr>
          <p:cNvSpPr txBox="1"/>
          <p:nvPr/>
        </p:nvSpPr>
        <p:spPr>
          <a:xfrm>
            <a:off x="4430085" y="2287527"/>
            <a:ext cx="488159" cy="19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DC254E0F-4801-98C1-56AD-4F651B10C8E4}"/>
              </a:ext>
            </a:extLst>
          </p:cNvPr>
          <p:cNvSpPr txBox="1"/>
          <p:nvPr/>
        </p:nvSpPr>
        <p:spPr>
          <a:xfrm>
            <a:off x="4429904" y="3146726"/>
            <a:ext cx="438442" cy="19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0371AB2F-78D5-FF50-D4E2-FEAA2A76DC49}"/>
              </a:ext>
            </a:extLst>
          </p:cNvPr>
          <p:cNvSpPr txBox="1"/>
          <p:nvPr/>
        </p:nvSpPr>
        <p:spPr>
          <a:xfrm>
            <a:off x="4382995" y="3017104"/>
            <a:ext cx="488159" cy="1967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pic>
        <p:nvPicPr>
          <p:cNvPr id="160" name="Picture 159">
            <a:extLst>
              <a:ext uri="{FF2B5EF4-FFF2-40B4-BE49-F238E27FC236}">
                <a16:creationId xmlns:a16="http://schemas.microsoft.com/office/drawing/2014/main" id="{6CB2B61F-663B-D471-E587-FFCF887C257C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809782" y="4477480"/>
            <a:ext cx="1718008" cy="81227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61" name="Picture 160">
            <a:extLst>
              <a:ext uri="{FF2B5EF4-FFF2-40B4-BE49-F238E27FC236}">
                <a16:creationId xmlns:a16="http://schemas.microsoft.com/office/drawing/2014/main" id="{F0D42CBA-5399-16AE-1678-D14802CF8D3E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828220" y="5334536"/>
            <a:ext cx="1708031" cy="80425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62" name="Picture 161">
            <a:extLst>
              <a:ext uri="{FF2B5EF4-FFF2-40B4-BE49-F238E27FC236}">
                <a16:creationId xmlns:a16="http://schemas.microsoft.com/office/drawing/2014/main" id="{C53E0CA8-9EFA-A1EC-2181-CF90216A821D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4810717" y="3828017"/>
            <a:ext cx="1716009" cy="61381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63" name="TextBox 162">
            <a:extLst>
              <a:ext uri="{FF2B5EF4-FFF2-40B4-BE49-F238E27FC236}">
                <a16:creationId xmlns:a16="http://schemas.microsoft.com/office/drawing/2014/main" id="{CCF8CB03-2398-D03F-90A2-F2992037B6B1}"/>
              </a:ext>
            </a:extLst>
          </p:cNvPr>
          <p:cNvSpPr txBox="1"/>
          <p:nvPr/>
        </p:nvSpPr>
        <p:spPr>
          <a:xfrm>
            <a:off x="6473767" y="3905634"/>
            <a:ext cx="5004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pS259 </a:t>
            </a:r>
          </a:p>
          <a:p>
            <a:r>
              <a:rPr lang="en-GB" sz="900" b="1" dirty="0"/>
              <a:t>c-RAF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592C5588-A064-4B9D-B30C-2741CA605341}"/>
              </a:ext>
            </a:extLst>
          </p:cNvPr>
          <p:cNvSpPr txBox="1"/>
          <p:nvPr/>
        </p:nvSpPr>
        <p:spPr>
          <a:xfrm>
            <a:off x="6505342" y="4666909"/>
            <a:ext cx="457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Total </a:t>
            </a:r>
          </a:p>
          <a:p>
            <a:r>
              <a:rPr lang="en-GB" sz="900" b="1" dirty="0"/>
              <a:t>ERK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F261C5F1-1531-273E-B54F-151CD0CDF800}"/>
              </a:ext>
            </a:extLst>
          </p:cNvPr>
          <p:cNvSpPr txBox="1"/>
          <p:nvPr/>
        </p:nvSpPr>
        <p:spPr>
          <a:xfrm>
            <a:off x="6458105" y="5496284"/>
            <a:ext cx="478016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pT202</a:t>
            </a:r>
          </a:p>
          <a:p>
            <a:r>
              <a:rPr lang="en-GB" sz="900" b="1" dirty="0"/>
              <a:t>pY204</a:t>
            </a:r>
          </a:p>
          <a:p>
            <a:r>
              <a:rPr lang="en-GB" sz="900" b="1" dirty="0"/>
              <a:t>ERK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6A4A682B-B13F-3B6D-A417-C173E6C17D41}"/>
              </a:ext>
            </a:extLst>
          </p:cNvPr>
          <p:cNvSpPr txBox="1"/>
          <p:nvPr/>
        </p:nvSpPr>
        <p:spPr>
          <a:xfrm>
            <a:off x="6325770" y="3775112"/>
            <a:ext cx="192552" cy="2037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B75DE22E-8333-4098-735B-478927B7F375}"/>
              </a:ext>
            </a:extLst>
          </p:cNvPr>
          <p:cNvSpPr txBox="1"/>
          <p:nvPr/>
        </p:nvSpPr>
        <p:spPr>
          <a:xfrm>
            <a:off x="6299921" y="5888935"/>
            <a:ext cx="192552" cy="2037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7B67D776-BE27-84F5-CECA-D563EDE45369}"/>
              </a:ext>
            </a:extLst>
          </p:cNvPr>
          <p:cNvSpPr txBox="1"/>
          <p:nvPr/>
        </p:nvSpPr>
        <p:spPr>
          <a:xfrm>
            <a:off x="6287460" y="5058521"/>
            <a:ext cx="223417" cy="2037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/>
              <a:t>M</a:t>
            </a:r>
          </a:p>
        </p:txBody>
      </p:sp>
      <p:cxnSp>
        <p:nvCxnSpPr>
          <p:cNvPr id="169" name="Straight Arrow Connector 168">
            <a:extLst>
              <a:ext uri="{FF2B5EF4-FFF2-40B4-BE49-F238E27FC236}">
                <a16:creationId xmlns:a16="http://schemas.microsoft.com/office/drawing/2014/main" id="{B055256F-D14D-D26B-B164-0B845FB52B63}"/>
              </a:ext>
            </a:extLst>
          </p:cNvPr>
          <p:cNvCxnSpPr>
            <a:cxnSpLocks/>
          </p:cNvCxnSpPr>
          <p:nvPr/>
        </p:nvCxnSpPr>
        <p:spPr>
          <a:xfrm flipH="1" flipV="1">
            <a:off x="6578886" y="4271302"/>
            <a:ext cx="129938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Arrow Connector 169">
            <a:extLst>
              <a:ext uri="{FF2B5EF4-FFF2-40B4-BE49-F238E27FC236}">
                <a16:creationId xmlns:a16="http://schemas.microsoft.com/office/drawing/2014/main" id="{12FB7F58-BC48-31C3-A948-1B78543EFCC0}"/>
              </a:ext>
            </a:extLst>
          </p:cNvPr>
          <p:cNvCxnSpPr>
            <a:cxnSpLocks/>
          </p:cNvCxnSpPr>
          <p:nvPr/>
        </p:nvCxnSpPr>
        <p:spPr>
          <a:xfrm flipH="1" flipV="1">
            <a:off x="6570044" y="4680189"/>
            <a:ext cx="129938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Arrow Connector 170">
            <a:extLst>
              <a:ext uri="{FF2B5EF4-FFF2-40B4-BE49-F238E27FC236}">
                <a16:creationId xmlns:a16="http://schemas.microsoft.com/office/drawing/2014/main" id="{958D9A2C-A7FD-AF11-C330-0E825DC75899}"/>
              </a:ext>
            </a:extLst>
          </p:cNvPr>
          <p:cNvCxnSpPr>
            <a:cxnSpLocks/>
          </p:cNvCxnSpPr>
          <p:nvPr/>
        </p:nvCxnSpPr>
        <p:spPr>
          <a:xfrm flipH="1" flipV="1">
            <a:off x="6551382" y="5503414"/>
            <a:ext cx="129938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TextBox 171">
            <a:extLst>
              <a:ext uri="{FF2B5EF4-FFF2-40B4-BE49-F238E27FC236}">
                <a16:creationId xmlns:a16="http://schemas.microsoft.com/office/drawing/2014/main" id="{34403509-8ED0-10E1-2382-11316E9C6688}"/>
              </a:ext>
            </a:extLst>
          </p:cNvPr>
          <p:cNvSpPr txBox="1"/>
          <p:nvPr/>
        </p:nvSpPr>
        <p:spPr>
          <a:xfrm>
            <a:off x="5410211" y="3504056"/>
            <a:ext cx="8547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3C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D0055CBC-965F-841A-DF70-2878FF246A34}"/>
              </a:ext>
            </a:extLst>
          </p:cNvPr>
          <p:cNvSpPr txBox="1"/>
          <p:nvPr/>
        </p:nvSpPr>
        <p:spPr>
          <a:xfrm>
            <a:off x="4435994" y="4127919"/>
            <a:ext cx="382873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12BB31F6-3998-6C07-A038-CA9D9450B3AA}"/>
              </a:ext>
            </a:extLst>
          </p:cNvPr>
          <p:cNvSpPr txBox="1"/>
          <p:nvPr/>
        </p:nvSpPr>
        <p:spPr>
          <a:xfrm>
            <a:off x="4395030" y="4000259"/>
            <a:ext cx="426289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C117AC8D-00EF-C953-5355-F47564F98BE1}"/>
              </a:ext>
            </a:extLst>
          </p:cNvPr>
          <p:cNvSpPr txBox="1"/>
          <p:nvPr/>
        </p:nvSpPr>
        <p:spPr>
          <a:xfrm>
            <a:off x="4416148" y="4595394"/>
            <a:ext cx="382873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37kDa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4D59AC88-1253-C17D-F708-6292472DF242}"/>
              </a:ext>
            </a:extLst>
          </p:cNvPr>
          <p:cNvSpPr txBox="1"/>
          <p:nvPr/>
        </p:nvSpPr>
        <p:spPr>
          <a:xfrm>
            <a:off x="4417064" y="4875992"/>
            <a:ext cx="382873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5kDa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C2BB3111-F4B6-377B-7CD7-0E5E099A1006}"/>
              </a:ext>
            </a:extLst>
          </p:cNvPr>
          <p:cNvSpPr txBox="1"/>
          <p:nvPr/>
        </p:nvSpPr>
        <p:spPr>
          <a:xfrm>
            <a:off x="4416148" y="4987268"/>
            <a:ext cx="382873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0kDa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D5C6F07A-DD39-603D-7A09-CEA0E81B62FD}"/>
              </a:ext>
            </a:extLst>
          </p:cNvPr>
          <p:cNvSpPr txBox="1"/>
          <p:nvPr/>
        </p:nvSpPr>
        <p:spPr>
          <a:xfrm>
            <a:off x="4415013" y="4414807"/>
            <a:ext cx="382873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50kDa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3C936277-0F88-97AD-724A-9CA91C5E7130}"/>
              </a:ext>
            </a:extLst>
          </p:cNvPr>
          <p:cNvSpPr txBox="1"/>
          <p:nvPr/>
        </p:nvSpPr>
        <p:spPr>
          <a:xfrm>
            <a:off x="4421370" y="5497065"/>
            <a:ext cx="382873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37kDa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859EAD91-2A07-A3C8-B246-E47237A4D2CA}"/>
              </a:ext>
            </a:extLst>
          </p:cNvPr>
          <p:cNvSpPr txBox="1"/>
          <p:nvPr/>
        </p:nvSpPr>
        <p:spPr>
          <a:xfrm>
            <a:off x="4422286" y="5777658"/>
            <a:ext cx="382873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5kDa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86D4F711-480E-479B-CC17-9DCB8541374B}"/>
              </a:ext>
            </a:extLst>
          </p:cNvPr>
          <p:cNvSpPr txBox="1"/>
          <p:nvPr/>
        </p:nvSpPr>
        <p:spPr>
          <a:xfrm>
            <a:off x="4421370" y="5888935"/>
            <a:ext cx="382873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0kDa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DAAFE155-AE47-6F26-5017-447036749BF8}"/>
              </a:ext>
            </a:extLst>
          </p:cNvPr>
          <p:cNvSpPr txBox="1"/>
          <p:nvPr/>
        </p:nvSpPr>
        <p:spPr>
          <a:xfrm>
            <a:off x="4420235" y="5260491"/>
            <a:ext cx="382873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50kD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CA36E39-E06E-F87D-A1D6-2423F6FED5C9}"/>
              </a:ext>
            </a:extLst>
          </p:cNvPr>
          <p:cNvSpPr txBox="1"/>
          <p:nvPr/>
        </p:nvSpPr>
        <p:spPr>
          <a:xfrm>
            <a:off x="67995" y="8887017"/>
            <a:ext cx="6841495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ppendix </a:t>
            </a:r>
            <a:r>
              <a:rPr kumimoji="0" lang="en-GB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.1 All Immunoblots</a:t>
            </a: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 </a:t>
            </a:r>
            <a:r>
              <a:rPr kumimoji="0" lang="en-GB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[IMMUNOBLOTS 1-3A-D] Lane: (1) – Ladder, (2) – Vehicle (1% DMSO), (3) – DRx-170 4 Hrs (0.3 µM), (4) DRx-170 24 Hrs (0.3 µM), (5) DRx-170 72 Hrs (0.3 µM), (6) DRx-170 4 Hrs (3 µM), (7) DRx-170 24 Hrs (3 µM), (8) DRx-170 72 Hrs (3 µM), (9) DRx-150 4 Hrs (3 µM). </a:t>
            </a:r>
            <a:r>
              <a:rPr lang="en-GB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blots 1A-C (N=1), 2A,C-D (N=2), 3A-C (N=3). ). [IMMUNOBLOTS 4A-B] Lane: (1) – Ladder, (2) – (5) PANC1, (6) Blank, (7) – (10) Panc08.13. N=4 independent replicates for each cell line (PANC1 and Panc08.13) on the same immunoblot. R = Rabbit Primary Antibody. M = Mouse Primary Antibody.</a:t>
            </a:r>
            <a:endParaRPr lang="en-GB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F3B050C-6CDD-9EA3-060D-5020CABDA01C}"/>
              </a:ext>
            </a:extLst>
          </p:cNvPr>
          <p:cNvSpPr txBox="1"/>
          <p:nvPr/>
        </p:nvSpPr>
        <p:spPr>
          <a:xfrm>
            <a:off x="6451604" y="6508780"/>
            <a:ext cx="4876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HSP90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6DCC090E-B25B-FDC5-1146-24B25BA417DD}"/>
              </a:ext>
            </a:extLst>
          </p:cNvPr>
          <p:cNvCxnSpPr>
            <a:cxnSpLocks/>
          </p:cNvCxnSpPr>
          <p:nvPr/>
        </p:nvCxnSpPr>
        <p:spPr>
          <a:xfrm flipH="1" flipV="1">
            <a:off x="6586261" y="6754537"/>
            <a:ext cx="129938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402B75D1-DBD4-82CF-7BFC-16632833E66D}"/>
              </a:ext>
            </a:extLst>
          </p:cNvPr>
          <p:cNvSpPr txBox="1"/>
          <p:nvPr/>
        </p:nvSpPr>
        <p:spPr>
          <a:xfrm>
            <a:off x="4412400" y="6652533"/>
            <a:ext cx="382873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AE241C2-F8F4-5851-DF7A-B7F526C6A6BD}"/>
              </a:ext>
            </a:extLst>
          </p:cNvPr>
          <p:cNvSpPr txBox="1"/>
          <p:nvPr/>
        </p:nvSpPr>
        <p:spPr>
          <a:xfrm>
            <a:off x="4371429" y="6524872"/>
            <a:ext cx="426289" cy="1937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CF362FD-5F22-3B10-F609-D4F84ABC0A0F}"/>
              </a:ext>
            </a:extLst>
          </p:cNvPr>
          <p:cNvSpPr txBox="1"/>
          <p:nvPr/>
        </p:nvSpPr>
        <p:spPr>
          <a:xfrm>
            <a:off x="6311185" y="6183538"/>
            <a:ext cx="192552" cy="2037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/>
              <a:t>R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EC1CE03-3789-F400-E1C3-B6773A925E7D}"/>
              </a:ext>
            </a:extLst>
          </p:cNvPr>
          <p:cNvSpPr txBox="1"/>
          <p:nvPr/>
        </p:nvSpPr>
        <p:spPr>
          <a:xfrm>
            <a:off x="824643" y="696207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4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3398022-46CE-A695-A3CE-8D2D00CBF03B}"/>
              </a:ext>
            </a:extLst>
          </p:cNvPr>
          <p:cNvSpPr txBox="1"/>
          <p:nvPr/>
        </p:nvSpPr>
        <p:spPr>
          <a:xfrm>
            <a:off x="300401" y="8715249"/>
            <a:ext cx="15888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Total Protein: IRDye – 700nm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F7DC8FE-AE8C-E9BF-DF93-F51C4E642BAB}"/>
              </a:ext>
            </a:extLst>
          </p:cNvPr>
          <p:cNvSpPr txBox="1"/>
          <p:nvPr/>
        </p:nvSpPr>
        <p:spPr>
          <a:xfrm>
            <a:off x="-20143" y="7673282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5641035-6FAD-7E95-3E70-BAEC8B2471DB}"/>
              </a:ext>
            </a:extLst>
          </p:cNvPr>
          <p:cNvSpPr txBox="1"/>
          <p:nvPr/>
        </p:nvSpPr>
        <p:spPr>
          <a:xfrm>
            <a:off x="-60796" y="7535508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D2BBDB1F-3A25-6AE8-C6BE-AEC168616E34}"/>
              </a:ext>
            </a:extLst>
          </p:cNvPr>
          <p:cNvSpPr txBox="1"/>
          <p:nvPr/>
        </p:nvSpPr>
        <p:spPr>
          <a:xfrm>
            <a:off x="-68188" y="7354353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50kDa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CC822FF1-25B9-BBA3-6B95-E5FA8766C45E}"/>
              </a:ext>
            </a:extLst>
          </p:cNvPr>
          <p:cNvSpPr txBox="1"/>
          <p:nvPr/>
        </p:nvSpPr>
        <p:spPr>
          <a:xfrm>
            <a:off x="-71263" y="7229105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50kDa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75551E8E-9042-C606-65BC-EE6F896DE12B}"/>
              </a:ext>
            </a:extLst>
          </p:cNvPr>
          <p:cNvSpPr txBox="1"/>
          <p:nvPr/>
        </p:nvSpPr>
        <p:spPr>
          <a:xfrm>
            <a:off x="-18106" y="8165776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37kDa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6D7D91AD-8EC9-BF13-6353-B2B92383C6B0}"/>
              </a:ext>
            </a:extLst>
          </p:cNvPr>
          <p:cNvSpPr txBox="1"/>
          <p:nvPr/>
        </p:nvSpPr>
        <p:spPr>
          <a:xfrm>
            <a:off x="-21181" y="7940320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50kDa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C4A19647-E775-DD43-06AD-F839F5EFAC9C}"/>
              </a:ext>
            </a:extLst>
          </p:cNvPr>
          <p:cNvSpPr txBox="1"/>
          <p:nvPr/>
        </p:nvSpPr>
        <p:spPr>
          <a:xfrm>
            <a:off x="-9500" y="8461931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5kDa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89621347-4C85-3DF2-8B85-B68648F30B96}"/>
              </a:ext>
            </a:extLst>
          </p:cNvPr>
          <p:cNvSpPr txBox="1"/>
          <p:nvPr/>
        </p:nvSpPr>
        <p:spPr>
          <a:xfrm>
            <a:off x="-4141" y="8552517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0kDa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5276A2F4-6675-37F5-5F66-08A5E9E6745E}"/>
              </a:ext>
            </a:extLst>
          </p:cNvPr>
          <p:cNvSpPr txBox="1"/>
          <p:nvPr/>
        </p:nvSpPr>
        <p:spPr>
          <a:xfrm>
            <a:off x="2913601" y="692611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4A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81FCE68F-5FC6-F1A4-21C2-8BF26C8734FE}"/>
              </a:ext>
            </a:extLst>
          </p:cNvPr>
          <p:cNvSpPr txBox="1"/>
          <p:nvPr/>
        </p:nvSpPr>
        <p:spPr>
          <a:xfrm>
            <a:off x="5185981" y="698175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4A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9DD01E1C-580F-17E1-2383-436774C74AE7}"/>
              </a:ext>
            </a:extLst>
          </p:cNvPr>
          <p:cNvSpPr txBox="1"/>
          <p:nvPr/>
        </p:nvSpPr>
        <p:spPr>
          <a:xfrm>
            <a:off x="2141653" y="7638697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5kDa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6E4FC985-79DF-0F09-7FD2-4433B07C4D33}"/>
              </a:ext>
            </a:extLst>
          </p:cNvPr>
          <p:cNvSpPr txBox="1"/>
          <p:nvPr/>
        </p:nvSpPr>
        <p:spPr>
          <a:xfrm>
            <a:off x="2101000" y="7500923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kDa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CBCC465B-E1B2-F431-B0D9-7B8E2CE3546D}"/>
              </a:ext>
            </a:extLst>
          </p:cNvPr>
          <p:cNvSpPr txBox="1"/>
          <p:nvPr/>
        </p:nvSpPr>
        <p:spPr>
          <a:xfrm>
            <a:off x="2093608" y="7319768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50kDa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82594C08-0025-36FC-3E25-DF82BBAF64C1}"/>
              </a:ext>
            </a:extLst>
          </p:cNvPr>
          <p:cNvSpPr txBox="1"/>
          <p:nvPr/>
        </p:nvSpPr>
        <p:spPr>
          <a:xfrm>
            <a:off x="2090533" y="7194520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50kDa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92A7700E-9EC0-74DC-42DF-DEA511344611}"/>
              </a:ext>
            </a:extLst>
          </p:cNvPr>
          <p:cNvSpPr txBox="1"/>
          <p:nvPr/>
        </p:nvSpPr>
        <p:spPr>
          <a:xfrm>
            <a:off x="2140615" y="7905735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50kDa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CD5E290F-449B-CF15-4EA4-ED960F70EE48}"/>
              </a:ext>
            </a:extLst>
          </p:cNvPr>
          <p:cNvSpPr txBox="1"/>
          <p:nvPr/>
        </p:nvSpPr>
        <p:spPr>
          <a:xfrm>
            <a:off x="2147673" y="8067284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37kDa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2182A216-6FC4-7769-0403-8D0BC361EC96}"/>
              </a:ext>
            </a:extLst>
          </p:cNvPr>
          <p:cNvSpPr txBox="1"/>
          <p:nvPr/>
        </p:nvSpPr>
        <p:spPr>
          <a:xfrm>
            <a:off x="2156279" y="8363439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5kDa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BF38EF23-B101-BC76-9FBF-3CDB9766C6A2}"/>
              </a:ext>
            </a:extLst>
          </p:cNvPr>
          <p:cNvSpPr txBox="1"/>
          <p:nvPr/>
        </p:nvSpPr>
        <p:spPr>
          <a:xfrm>
            <a:off x="2161638" y="8454025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0kDa</a:t>
            </a:r>
          </a:p>
        </p:txBody>
      </p:sp>
      <p:pic>
        <p:nvPicPr>
          <p:cNvPr id="193" name="Picture 192">
            <a:extLst>
              <a:ext uri="{FF2B5EF4-FFF2-40B4-BE49-F238E27FC236}">
                <a16:creationId xmlns:a16="http://schemas.microsoft.com/office/drawing/2014/main" id="{7CE181C1-6097-660F-35BD-B99EB8163DCB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381197" y="7266451"/>
            <a:ext cx="1700098" cy="146231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97" name="Picture 196">
            <a:extLst>
              <a:ext uri="{FF2B5EF4-FFF2-40B4-BE49-F238E27FC236}">
                <a16:creationId xmlns:a16="http://schemas.microsoft.com/office/drawing/2014/main" id="{64286815-CFA2-1942-6F0E-61572CB98B34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2537233" y="8150903"/>
            <a:ext cx="1700099" cy="47582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98" name="TextBox 197">
            <a:extLst>
              <a:ext uri="{FF2B5EF4-FFF2-40B4-BE49-F238E27FC236}">
                <a16:creationId xmlns:a16="http://schemas.microsoft.com/office/drawing/2014/main" id="{E04D5E35-AA3D-A76B-5BBD-3679F62D8980}"/>
              </a:ext>
            </a:extLst>
          </p:cNvPr>
          <p:cNvSpPr txBox="1"/>
          <p:nvPr/>
        </p:nvSpPr>
        <p:spPr>
          <a:xfrm>
            <a:off x="4162176" y="8276962"/>
            <a:ext cx="4379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KRAS</a:t>
            </a:r>
          </a:p>
        </p:txBody>
      </p:sp>
      <p:cxnSp>
        <p:nvCxnSpPr>
          <p:cNvPr id="199" name="Straight Arrow Connector 198">
            <a:extLst>
              <a:ext uri="{FF2B5EF4-FFF2-40B4-BE49-F238E27FC236}">
                <a16:creationId xmlns:a16="http://schemas.microsoft.com/office/drawing/2014/main" id="{35B10935-6E17-E4EB-A853-E05A7B031C9E}"/>
              </a:ext>
            </a:extLst>
          </p:cNvPr>
          <p:cNvCxnSpPr>
            <a:cxnSpLocks/>
          </p:cNvCxnSpPr>
          <p:nvPr/>
        </p:nvCxnSpPr>
        <p:spPr>
          <a:xfrm flipH="1" flipV="1">
            <a:off x="4284307" y="8510193"/>
            <a:ext cx="129938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1" name="Picture 200">
            <a:extLst>
              <a:ext uri="{FF2B5EF4-FFF2-40B4-BE49-F238E27FC236}">
                <a16:creationId xmlns:a16="http://schemas.microsoft.com/office/drawing/2014/main" id="{47F72ED3-8FBC-AB54-CDE5-975B3498930A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2533804" y="7261378"/>
            <a:ext cx="1700099" cy="79350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A82EFF6-46AA-7719-792E-988B36CE1C5F}"/>
              </a:ext>
            </a:extLst>
          </p:cNvPr>
          <p:cNvSpPr txBox="1"/>
          <p:nvPr/>
        </p:nvSpPr>
        <p:spPr>
          <a:xfrm>
            <a:off x="4159078" y="7628221"/>
            <a:ext cx="4571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c-RAF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A17732C6-AE99-2E89-B456-D57C2C79739F}"/>
              </a:ext>
            </a:extLst>
          </p:cNvPr>
          <p:cNvCxnSpPr>
            <a:cxnSpLocks/>
          </p:cNvCxnSpPr>
          <p:nvPr/>
        </p:nvCxnSpPr>
        <p:spPr>
          <a:xfrm flipH="1" flipV="1">
            <a:off x="4281209" y="7823352"/>
            <a:ext cx="129938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28270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92876437B99B04CA0A0259AFDABB09E" ma:contentTypeVersion="11" ma:contentTypeDescription="Create a new document." ma:contentTypeScope="" ma:versionID="5f92f623b194baab12083c9e87ae1dd4">
  <xsd:schema xmlns:xsd="http://www.w3.org/2001/XMLSchema" xmlns:xs="http://www.w3.org/2001/XMLSchema" xmlns:p="http://schemas.microsoft.com/office/2006/metadata/properties" xmlns:ns3="7ed581de-19d2-466c-8863-622701b259f0" targetNamespace="http://schemas.microsoft.com/office/2006/metadata/properties" ma:root="true" ma:fieldsID="3b9aff6c227436546e1c51eaca58eed3" ns3:_="">
    <xsd:import namespace="7ed581de-19d2-466c-8863-622701b259f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ed581de-19d2-466c-8863-622701b259f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18" nillable="true" ma:displayName="_activity" ma:hidden="true" ma:internalName="_activity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7ed581de-19d2-466c-8863-622701b259f0" xsi:nil="true"/>
  </documentManagement>
</p:properties>
</file>

<file path=customXml/itemProps1.xml><?xml version="1.0" encoding="utf-8"?>
<ds:datastoreItem xmlns:ds="http://schemas.openxmlformats.org/officeDocument/2006/customXml" ds:itemID="{FDAF203C-8A99-47B2-9199-967E1A97F36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ed581de-19d2-466c-8863-622701b259f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0EAC490-FE8F-4FEA-B915-629F922CE25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596599E-5933-4433-9E6C-7B72544BD27B}">
  <ds:schemaRefs>
    <ds:schemaRef ds:uri="7ed581de-19d2-466c-8863-622701b259f0"/>
    <ds:schemaRef ds:uri="http://purl.org/dc/elements/1.1/"/>
    <ds:schemaRef ds:uri="http://schemas.microsoft.com/office/2006/metadata/properties"/>
    <ds:schemaRef ds:uri="http://schemas.microsoft.com/office/2006/documentManagement/types"/>
    <ds:schemaRef ds:uri="http://purl.org/dc/dcmitype/"/>
    <ds:schemaRef ds:uri="http://purl.org/dc/terms/"/>
    <ds:schemaRef ds:uri="http://www.w3.org/XML/1998/namespace"/>
    <ds:schemaRef ds:uri="http://schemas.microsoft.com/office/infopath/2007/PartnerControls"/>
    <ds:schemaRef ds:uri="http://schemas.openxmlformats.org/package/2006/metadata/core-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9530</TotalTime>
  <Words>361</Words>
  <Application>Microsoft Office PowerPoint</Application>
  <PresentationFormat>A4 Paper (210x297 mm)</PresentationFormat>
  <Paragraphs>15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or Blair</dc:creator>
  <cp:lastModifiedBy>Connor Blair</cp:lastModifiedBy>
  <cp:revision>24</cp:revision>
  <dcterms:created xsi:type="dcterms:W3CDTF">2023-03-15T09:52:16Z</dcterms:created>
  <dcterms:modified xsi:type="dcterms:W3CDTF">2024-03-19T09:22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92876437B99B04CA0A0259AFDABB09E</vt:lpwstr>
  </property>
</Properties>
</file>